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A1D524-B718-4155-9E8A-21AAB3862AB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9EA42D-6DF5-49D7-AE0A-561E629246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2EEC39-F422-4FA4-869E-F8C0881155A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7C7BCC-8BF5-4F4D-AD88-84293E2FA58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BA5DF2-AB98-4FEE-A486-82FF0C638E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A93141-9440-4E10-8EFA-A4F758E844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8A593F-E3AB-4D08-99FF-D52D901E9F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E46449-E80F-4A19-AC5A-191BACF359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1C1C06-24A4-4090-9DDB-48FDAE47CB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F6C6A7-AD85-4F80-BAA7-EDC5675E47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5B053D-9E53-4256-9E36-FB88FB65E1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9BBB98-7627-4C9F-9EB4-CBACAD12BC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9CA1C3-E435-44C3-ABEF-DB11367D3E20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13"/>
          <p:cNvSpPr/>
          <p:nvPr/>
        </p:nvSpPr>
        <p:spPr>
          <a:xfrm>
            <a:off x="3262320" y="2060640"/>
            <a:ext cx="503280" cy="217440"/>
          </a:xfrm>
          <a:prstGeom prst="rightArrow">
            <a:avLst>
              <a:gd name="adj1" fmla="val 50000"/>
              <a:gd name="adj2" fmla="val 57864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14"/>
          <p:cNvSpPr/>
          <p:nvPr/>
        </p:nvSpPr>
        <p:spPr>
          <a:xfrm>
            <a:off x="3105720" y="1700280"/>
            <a:ext cx="81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Arial"/>
              </a:rPr>
              <a:t>Gatewa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Arial"/>
              </a:rPr>
              <a:t>BP react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6"/>
          <p:cNvSpPr/>
          <p:nvPr/>
        </p:nvSpPr>
        <p:spPr>
          <a:xfrm>
            <a:off x="6064560" y="2852640"/>
            <a:ext cx="81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Arial"/>
              </a:rPr>
              <a:t>Gatewa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Arial"/>
              </a:rPr>
              <a:t>LR react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AutoShape 19"/>
          <p:cNvSpPr/>
          <p:nvPr/>
        </p:nvSpPr>
        <p:spPr>
          <a:xfrm>
            <a:off x="6165720" y="3284640"/>
            <a:ext cx="503280" cy="217440"/>
          </a:xfrm>
          <a:prstGeom prst="rightArrow">
            <a:avLst>
              <a:gd name="adj1" fmla="val 50000"/>
              <a:gd name="adj2" fmla="val 57864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AutoShape 21"/>
          <p:cNvSpPr/>
          <p:nvPr/>
        </p:nvSpPr>
        <p:spPr>
          <a:xfrm>
            <a:off x="3059280" y="1413000"/>
            <a:ext cx="72720" cy="2158920"/>
          </a:xfrm>
          <a:custGeom>
            <a:avLst/>
            <a:gdLst>
              <a:gd name="textAreaLeft" fmla="*/ 0 w 72720"/>
              <a:gd name="textAreaRight" fmla="*/ 51120 w 72720"/>
              <a:gd name="textAreaTop" fmla="*/ 89640 h 2158920"/>
              <a:gd name="textAreaBottom" fmla="*/ 2069280 h 2158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AutoShape 22"/>
          <p:cNvSpPr/>
          <p:nvPr/>
        </p:nvSpPr>
        <p:spPr>
          <a:xfrm>
            <a:off x="5940360" y="2276640"/>
            <a:ext cx="144360" cy="2376360"/>
          </a:xfrm>
          <a:custGeom>
            <a:avLst/>
            <a:gdLst>
              <a:gd name="textAreaLeft" fmla="*/ 0 w 144360"/>
              <a:gd name="textAreaRight" fmla="*/ 101160 w 144360"/>
              <a:gd name="textAreaTop" fmla="*/ 99000 h 2376360"/>
              <a:gd name="textAreaBottom" fmla="*/ 2277360 h 2376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AutoShape 57"/>
          <p:cNvSpPr/>
          <p:nvPr/>
        </p:nvSpPr>
        <p:spPr>
          <a:xfrm>
            <a:off x="179280" y="836640"/>
            <a:ext cx="2901960" cy="687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" name="Group 73"/>
          <p:cNvGrpSpPr/>
          <p:nvPr/>
        </p:nvGrpSpPr>
        <p:grpSpPr>
          <a:xfrm>
            <a:off x="322920" y="1197000"/>
            <a:ext cx="2649600" cy="294840"/>
            <a:chOff x="322920" y="1197000"/>
            <a:chExt cx="2649600" cy="294840"/>
          </a:xfrm>
        </p:grpSpPr>
        <p:sp>
          <p:nvSpPr>
            <p:cNvPr id="49" name="Rectangle 59"/>
            <p:cNvSpPr/>
            <p:nvPr/>
          </p:nvSpPr>
          <p:spPr>
            <a:xfrm>
              <a:off x="413280" y="1413360"/>
              <a:ext cx="2380320" cy="18720"/>
            </a:xfrm>
            <a:prstGeom prst="rect">
              <a:avLst/>
            </a:prstGeom>
            <a:solidFill>
              <a:srgbClr val="ffffcc"/>
            </a:solidFill>
            <a:ln w="0">
              <a:solidFill>
                <a:srgbClr val="cccc99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60"/>
            <p:cNvSpPr/>
            <p:nvPr/>
          </p:nvSpPr>
          <p:spPr>
            <a:xfrm>
              <a:off x="414720" y="1413360"/>
              <a:ext cx="2379240" cy="18720"/>
            </a:xfrm>
            <a:prstGeom prst="rect">
              <a:avLst/>
            </a:prstGeom>
            <a:solidFill>
              <a:srgbClr val="ffffcc"/>
            </a:solidFill>
            <a:ln w="0">
              <a:solidFill>
                <a:srgbClr val="cccc99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Freeform 63"/>
            <p:cNvSpPr/>
            <p:nvPr/>
          </p:nvSpPr>
          <p:spPr>
            <a:xfrm>
              <a:off x="498600" y="1354680"/>
              <a:ext cx="2214720" cy="137160"/>
            </a:xfrm>
            <a:custGeom>
              <a:avLst/>
              <a:gdLst>
                <a:gd name="textAreaLeft" fmla="*/ 0 w 2214720"/>
                <a:gd name="textAreaRight" fmla="*/ 2215080 w 2214720"/>
                <a:gd name="textAreaTop" fmla="*/ 0 h 137160"/>
                <a:gd name="textAreaBottom" fmla="*/ 137520 h 137160"/>
              </a:gdLst>
              <a:ahLst/>
              <a:rect l="textAreaLeft" t="textAreaTop" r="textAreaRight" b="textAreaBottom"/>
              <a:pathLst>
                <a:path w="1536" h="87">
                  <a:moveTo>
                    <a:pt x="1496" y="87"/>
                  </a:moveTo>
                  <a:lnTo>
                    <a:pt x="1536" y="43"/>
                  </a:lnTo>
                  <a:lnTo>
                    <a:pt x="1496" y="0"/>
                  </a:lnTo>
                  <a:lnTo>
                    <a:pt x="1496" y="19"/>
                  </a:lnTo>
                  <a:lnTo>
                    <a:pt x="0" y="19"/>
                  </a:lnTo>
                  <a:lnTo>
                    <a:pt x="0" y="68"/>
                  </a:lnTo>
                  <a:lnTo>
                    <a:pt x="1496" y="68"/>
                  </a:lnTo>
                  <a:lnTo>
                    <a:pt x="1496" y="87"/>
                  </a:lnTo>
                  <a:close/>
                </a:path>
              </a:pathLst>
            </a:custGeom>
            <a:solidFill>
              <a:srgbClr val="00b0f0"/>
            </a:solidFill>
            <a:ln w="0">
              <a:solidFill>
                <a:srgbClr val="00b0f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64"/>
            <p:cNvSpPr/>
            <p:nvPr/>
          </p:nvSpPr>
          <p:spPr>
            <a:xfrm flipH="1">
              <a:off x="1605600" y="1272240"/>
              <a:ext cx="3960" cy="11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65"/>
            <p:cNvSpPr/>
            <p:nvPr/>
          </p:nvSpPr>
          <p:spPr>
            <a:xfrm>
              <a:off x="1477440" y="1197000"/>
              <a:ext cx="236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s-ES" sz="600" spc="-1" strike="noStrike">
                  <a:solidFill>
                    <a:srgbClr val="000000"/>
                  </a:solidFill>
                  <a:latin typeface="Arial"/>
                </a:rPr>
                <a:t>GBSS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66"/>
            <p:cNvSpPr/>
            <p:nvPr/>
          </p:nvSpPr>
          <p:spPr>
            <a:xfrm>
              <a:off x="417600" y="1354680"/>
              <a:ext cx="80640" cy="137160"/>
            </a:xfrm>
            <a:custGeom>
              <a:avLst/>
              <a:gdLst>
                <a:gd name="textAreaLeft" fmla="*/ 0 w 80640"/>
                <a:gd name="textAreaRight" fmla="*/ 81000 w 80640"/>
                <a:gd name="textAreaTop" fmla="*/ 0 h 137160"/>
                <a:gd name="textAreaBottom" fmla="*/ 137520 h 137160"/>
              </a:gdLst>
              <a:ahLst/>
              <a:rect l="textAreaLeft" t="textAreaTop" r="textAreaRight" b="textAreaBottom"/>
              <a:pathLst>
                <a:path w="56" h="87">
                  <a:moveTo>
                    <a:pt x="16" y="87"/>
                  </a:moveTo>
                  <a:lnTo>
                    <a:pt x="56" y="43"/>
                  </a:lnTo>
                  <a:lnTo>
                    <a:pt x="16" y="0"/>
                  </a:lnTo>
                  <a:lnTo>
                    <a:pt x="16" y="19"/>
                  </a:lnTo>
                  <a:lnTo>
                    <a:pt x="0" y="19"/>
                  </a:lnTo>
                  <a:lnTo>
                    <a:pt x="0" y="68"/>
                  </a:lnTo>
                  <a:lnTo>
                    <a:pt x="16" y="68"/>
                  </a:lnTo>
                  <a:lnTo>
                    <a:pt x="16" y="87"/>
                  </a:lnTo>
                  <a:close/>
                </a:path>
              </a:pathLst>
            </a:custGeom>
            <a:solidFill>
              <a:srgbClr val="66cc99"/>
            </a:solidFill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67"/>
            <p:cNvSpPr/>
            <p:nvPr/>
          </p:nvSpPr>
          <p:spPr>
            <a:xfrm>
              <a:off x="456480" y="1305720"/>
              <a:ext cx="1080" cy="78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680" bIns="31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68"/>
            <p:cNvSpPr/>
            <p:nvPr/>
          </p:nvSpPr>
          <p:spPr>
            <a:xfrm>
              <a:off x="322920" y="1228320"/>
              <a:ext cx="192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600" spc="-1" strike="noStrike">
                  <a:solidFill>
                    <a:srgbClr val="000000"/>
                  </a:solidFill>
                  <a:latin typeface="Arial"/>
                </a:rPr>
                <a:t>attB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69"/>
            <p:cNvSpPr/>
            <p:nvPr/>
          </p:nvSpPr>
          <p:spPr>
            <a:xfrm>
              <a:off x="2713320" y="1354680"/>
              <a:ext cx="80640" cy="137160"/>
            </a:xfrm>
            <a:custGeom>
              <a:avLst/>
              <a:gdLst>
                <a:gd name="textAreaLeft" fmla="*/ 0 w 80640"/>
                <a:gd name="textAreaRight" fmla="*/ 81000 w 80640"/>
                <a:gd name="textAreaTop" fmla="*/ 0 h 137160"/>
                <a:gd name="textAreaBottom" fmla="*/ 137520 h 137160"/>
              </a:gdLst>
              <a:ahLst/>
              <a:rect l="textAreaLeft" t="textAreaTop" r="textAreaRight" b="textAreaBottom"/>
              <a:pathLst>
                <a:path w="56" h="87">
                  <a:moveTo>
                    <a:pt x="56" y="19"/>
                  </a:moveTo>
                  <a:lnTo>
                    <a:pt x="39" y="19"/>
                  </a:lnTo>
                  <a:lnTo>
                    <a:pt x="39" y="0"/>
                  </a:lnTo>
                  <a:lnTo>
                    <a:pt x="0" y="43"/>
                  </a:lnTo>
                  <a:lnTo>
                    <a:pt x="39" y="87"/>
                  </a:lnTo>
                  <a:lnTo>
                    <a:pt x="39" y="68"/>
                  </a:lnTo>
                  <a:lnTo>
                    <a:pt x="56" y="68"/>
                  </a:lnTo>
                  <a:lnTo>
                    <a:pt x="56" y="19"/>
                  </a:lnTo>
                  <a:close/>
                </a:path>
              </a:pathLst>
            </a:custGeom>
            <a:solidFill>
              <a:srgbClr val="66cc99"/>
            </a:solidFill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70"/>
            <p:cNvSpPr/>
            <p:nvPr/>
          </p:nvSpPr>
          <p:spPr>
            <a:xfrm>
              <a:off x="413280" y="1384560"/>
              <a:ext cx="3960" cy="77040"/>
            </a:xfrm>
            <a:prstGeom prst="rect">
              <a:avLst/>
            </a:prstGeom>
            <a:solidFill>
              <a:srgbClr val="66cc99"/>
            </a:solidFill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240" bIns="30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71"/>
            <p:cNvSpPr/>
            <p:nvPr/>
          </p:nvSpPr>
          <p:spPr>
            <a:xfrm flipH="1">
              <a:off x="2755080" y="1310400"/>
              <a:ext cx="23040" cy="73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72"/>
            <p:cNvSpPr/>
            <p:nvPr/>
          </p:nvSpPr>
          <p:spPr>
            <a:xfrm>
              <a:off x="2779920" y="1233000"/>
              <a:ext cx="192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600" spc="-1" strike="noStrike">
                  <a:solidFill>
                    <a:srgbClr val="000000"/>
                  </a:solidFill>
                  <a:latin typeface="Arial"/>
                </a:rPr>
                <a:t>attB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1" name="Text Box 74"/>
          <p:cNvSpPr/>
          <p:nvPr/>
        </p:nvSpPr>
        <p:spPr>
          <a:xfrm>
            <a:off x="3633840" y="6019920"/>
            <a:ext cx="352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Arial"/>
              </a:rPr>
              <a:t>Supplemental Figure 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75"/>
          <p:cNvSpPr/>
          <p:nvPr/>
        </p:nvSpPr>
        <p:spPr>
          <a:xfrm>
            <a:off x="1187280" y="1484280"/>
            <a:ext cx="1224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800" spc="-1" strike="noStrike">
                <a:solidFill>
                  <a:srgbClr val="000000"/>
                </a:solidFill>
                <a:latin typeface="Arial"/>
              </a:rPr>
              <a:t>(PCR product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AutoShape 76"/>
          <p:cNvSpPr/>
          <p:nvPr/>
        </p:nvSpPr>
        <p:spPr>
          <a:xfrm>
            <a:off x="468360" y="2452680"/>
            <a:ext cx="2244600" cy="183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Freeform 78"/>
          <p:cNvSpPr/>
          <p:nvPr/>
        </p:nvSpPr>
        <p:spPr>
          <a:xfrm>
            <a:off x="949320" y="2500200"/>
            <a:ext cx="1592280" cy="1594080"/>
          </a:xfrm>
          <a:custGeom>
            <a:avLst/>
            <a:gdLst>
              <a:gd name="textAreaLeft" fmla="*/ 0 w 1592280"/>
              <a:gd name="textAreaRight" fmla="*/ 1592640 w 1592280"/>
              <a:gd name="textAreaTop" fmla="*/ 0 h 1594080"/>
              <a:gd name="textAreaBottom" fmla="*/ 1594440 h 1594080"/>
            </a:gdLst>
            <a:ahLst/>
            <a:rect l="textAreaLeft" t="textAreaTop" r="textAreaRight" b="textAreaBottom"/>
            <a:pathLst>
              <a:path w="1003" h="1004">
                <a:moveTo>
                  <a:pt x="506" y="0"/>
                </a:moveTo>
                <a:lnTo>
                  <a:pt x="461" y="2"/>
                </a:lnTo>
                <a:lnTo>
                  <a:pt x="416" y="7"/>
                </a:lnTo>
                <a:lnTo>
                  <a:pt x="373" y="17"/>
                </a:lnTo>
                <a:lnTo>
                  <a:pt x="330" y="31"/>
                </a:lnTo>
                <a:lnTo>
                  <a:pt x="289" y="48"/>
                </a:lnTo>
                <a:lnTo>
                  <a:pt x="249" y="69"/>
                </a:lnTo>
                <a:lnTo>
                  <a:pt x="211" y="93"/>
                </a:lnTo>
                <a:lnTo>
                  <a:pt x="176" y="121"/>
                </a:lnTo>
                <a:lnTo>
                  <a:pt x="143" y="151"/>
                </a:lnTo>
                <a:lnTo>
                  <a:pt x="113" y="184"/>
                </a:lnTo>
                <a:lnTo>
                  <a:pt x="87" y="220"/>
                </a:lnTo>
                <a:lnTo>
                  <a:pt x="64" y="259"/>
                </a:lnTo>
                <a:lnTo>
                  <a:pt x="44" y="300"/>
                </a:lnTo>
                <a:lnTo>
                  <a:pt x="26" y="341"/>
                </a:lnTo>
                <a:lnTo>
                  <a:pt x="14" y="384"/>
                </a:lnTo>
                <a:lnTo>
                  <a:pt x="5" y="429"/>
                </a:lnTo>
                <a:lnTo>
                  <a:pt x="2" y="473"/>
                </a:lnTo>
                <a:lnTo>
                  <a:pt x="0" y="518"/>
                </a:lnTo>
                <a:lnTo>
                  <a:pt x="4" y="563"/>
                </a:lnTo>
                <a:lnTo>
                  <a:pt x="11" y="607"/>
                </a:lnTo>
                <a:lnTo>
                  <a:pt x="23" y="651"/>
                </a:lnTo>
                <a:lnTo>
                  <a:pt x="37" y="693"/>
                </a:lnTo>
                <a:lnTo>
                  <a:pt x="57" y="734"/>
                </a:lnTo>
                <a:lnTo>
                  <a:pt x="80" y="772"/>
                </a:lnTo>
                <a:lnTo>
                  <a:pt x="106" y="809"/>
                </a:lnTo>
                <a:lnTo>
                  <a:pt x="134" y="843"/>
                </a:lnTo>
                <a:lnTo>
                  <a:pt x="166" y="875"/>
                </a:lnTo>
                <a:lnTo>
                  <a:pt x="201" y="903"/>
                </a:lnTo>
                <a:lnTo>
                  <a:pt x="237" y="928"/>
                </a:lnTo>
                <a:lnTo>
                  <a:pt x="276" y="951"/>
                </a:lnTo>
                <a:lnTo>
                  <a:pt x="317" y="969"/>
                </a:lnTo>
                <a:lnTo>
                  <a:pt x="359" y="983"/>
                </a:lnTo>
                <a:lnTo>
                  <a:pt x="403" y="994"/>
                </a:lnTo>
                <a:lnTo>
                  <a:pt x="447" y="1001"/>
                </a:lnTo>
                <a:lnTo>
                  <a:pt x="492" y="1004"/>
                </a:lnTo>
                <a:lnTo>
                  <a:pt x="538" y="1003"/>
                </a:lnTo>
                <a:lnTo>
                  <a:pt x="582" y="998"/>
                </a:lnTo>
                <a:lnTo>
                  <a:pt x="626" y="988"/>
                </a:lnTo>
                <a:lnTo>
                  <a:pt x="669" y="975"/>
                </a:lnTo>
                <a:lnTo>
                  <a:pt x="710" y="958"/>
                </a:lnTo>
                <a:lnTo>
                  <a:pt x="749" y="938"/>
                </a:lnTo>
                <a:lnTo>
                  <a:pt x="788" y="915"/>
                </a:lnTo>
                <a:lnTo>
                  <a:pt x="824" y="887"/>
                </a:lnTo>
                <a:lnTo>
                  <a:pt x="856" y="856"/>
                </a:lnTo>
                <a:lnTo>
                  <a:pt x="887" y="823"/>
                </a:lnTo>
                <a:lnTo>
                  <a:pt x="914" y="788"/>
                </a:lnTo>
                <a:lnTo>
                  <a:pt x="938" y="750"/>
                </a:lnTo>
                <a:lnTo>
                  <a:pt x="957" y="710"/>
                </a:lnTo>
                <a:lnTo>
                  <a:pt x="975" y="668"/>
                </a:lnTo>
                <a:lnTo>
                  <a:pt x="987" y="624"/>
                </a:lnTo>
                <a:lnTo>
                  <a:pt x="997" y="581"/>
                </a:lnTo>
                <a:lnTo>
                  <a:pt x="1002" y="536"/>
                </a:lnTo>
                <a:lnTo>
                  <a:pt x="1003" y="492"/>
                </a:lnTo>
                <a:lnTo>
                  <a:pt x="1000" y="447"/>
                </a:lnTo>
                <a:lnTo>
                  <a:pt x="993" y="403"/>
                </a:lnTo>
                <a:lnTo>
                  <a:pt x="982" y="359"/>
                </a:lnTo>
                <a:lnTo>
                  <a:pt x="967" y="317"/>
                </a:lnTo>
                <a:lnTo>
                  <a:pt x="949" y="276"/>
                </a:lnTo>
                <a:lnTo>
                  <a:pt x="928" y="237"/>
                </a:lnTo>
                <a:lnTo>
                  <a:pt x="902" y="199"/>
                </a:lnTo>
                <a:lnTo>
                  <a:pt x="873" y="165"/>
                </a:lnTo>
                <a:lnTo>
                  <a:pt x="841" y="134"/>
                </a:lnTo>
                <a:lnTo>
                  <a:pt x="808" y="104"/>
                </a:lnTo>
                <a:lnTo>
                  <a:pt x="771" y="78"/>
                </a:lnTo>
                <a:lnTo>
                  <a:pt x="732" y="56"/>
                </a:lnTo>
                <a:lnTo>
                  <a:pt x="691" y="37"/>
                </a:lnTo>
                <a:lnTo>
                  <a:pt x="649" y="22"/>
                </a:lnTo>
                <a:lnTo>
                  <a:pt x="606" y="11"/>
                </a:lnTo>
                <a:lnTo>
                  <a:pt x="561" y="3"/>
                </a:lnTo>
                <a:lnTo>
                  <a:pt x="517" y="0"/>
                </a:lnTo>
                <a:lnTo>
                  <a:pt x="507" y="0"/>
                </a:lnTo>
                <a:lnTo>
                  <a:pt x="507" y="11"/>
                </a:lnTo>
                <a:lnTo>
                  <a:pt x="550" y="13"/>
                </a:lnTo>
                <a:lnTo>
                  <a:pt x="593" y="20"/>
                </a:lnTo>
                <a:lnTo>
                  <a:pt x="637" y="29"/>
                </a:lnTo>
                <a:lnTo>
                  <a:pt x="678" y="43"/>
                </a:lnTo>
                <a:lnTo>
                  <a:pt x="718" y="60"/>
                </a:lnTo>
                <a:lnTo>
                  <a:pt x="757" y="82"/>
                </a:lnTo>
                <a:lnTo>
                  <a:pt x="793" y="106"/>
                </a:lnTo>
                <a:lnTo>
                  <a:pt x="827" y="135"/>
                </a:lnTo>
                <a:lnTo>
                  <a:pt x="858" y="165"/>
                </a:lnTo>
                <a:lnTo>
                  <a:pt x="887" y="198"/>
                </a:lnTo>
                <a:lnTo>
                  <a:pt x="913" y="234"/>
                </a:lnTo>
                <a:lnTo>
                  <a:pt x="935" y="271"/>
                </a:lnTo>
                <a:lnTo>
                  <a:pt x="954" y="311"/>
                </a:lnTo>
                <a:lnTo>
                  <a:pt x="969" y="353"/>
                </a:lnTo>
                <a:lnTo>
                  <a:pt x="981" y="395"/>
                </a:lnTo>
                <a:lnTo>
                  <a:pt x="988" y="439"/>
                </a:lnTo>
                <a:lnTo>
                  <a:pt x="992" y="482"/>
                </a:lnTo>
                <a:lnTo>
                  <a:pt x="992" y="525"/>
                </a:lnTo>
                <a:lnTo>
                  <a:pt x="987" y="570"/>
                </a:lnTo>
                <a:lnTo>
                  <a:pt x="980" y="613"/>
                </a:lnTo>
                <a:lnTo>
                  <a:pt x="967" y="655"/>
                </a:lnTo>
                <a:lnTo>
                  <a:pt x="953" y="696"/>
                </a:lnTo>
                <a:lnTo>
                  <a:pt x="933" y="736"/>
                </a:lnTo>
                <a:lnTo>
                  <a:pt x="910" y="773"/>
                </a:lnTo>
                <a:lnTo>
                  <a:pt x="884" y="809"/>
                </a:lnTo>
                <a:lnTo>
                  <a:pt x="856" y="841"/>
                </a:lnTo>
                <a:lnTo>
                  <a:pt x="824" y="872"/>
                </a:lnTo>
                <a:lnTo>
                  <a:pt x="790" y="900"/>
                </a:lnTo>
                <a:lnTo>
                  <a:pt x="753" y="923"/>
                </a:lnTo>
                <a:lnTo>
                  <a:pt x="715" y="944"/>
                </a:lnTo>
                <a:lnTo>
                  <a:pt x="674" y="962"/>
                </a:lnTo>
                <a:lnTo>
                  <a:pt x="633" y="975"/>
                </a:lnTo>
                <a:lnTo>
                  <a:pt x="590" y="985"/>
                </a:lnTo>
                <a:lnTo>
                  <a:pt x="546" y="991"/>
                </a:lnTo>
                <a:lnTo>
                  <a:pt x="503" y="993"/>
                </a:lnTo>
                <a:lnTo>
                  <a:pt x="458" y="991"/>
                </a:lnTo>
                <a:lnTo>
                  <a:pt x="415" y="985"/>
                </a:lnTo>
                <a:lnTo>
                  <a:pt x="372" y="975"/>
                </a:lnTo>
                <a:lnTo>
                  <a:pt x="331" y="963"/>
                </a:lnTo>
                <a:lnTo>
                  <a:pt x="290" y="946"/>
                </a:lnTo>
                <a:lnTo>
                  <a:pt x="252" y="924"/>
                </a:lnTo>
                <a:lnTo>
                  <a:pt x="215" y="901"/>
                </a:lnTo>
                <a:lnTo>
                  <a:pt x="180" y="874"/>
                </a:lnTo>
                <a:lnTo>
                  <a:pt x="149" y="843"/>
                </a:lnTo>
                <a:lnTo>
                  <a:pt x="119" y="810"/>
                </a:lnTo>
                <a:lnTo>
                  <a:pt x="93" y="774"/>
                </a:lnTo>
                <a:lnTo>
                  <a:pt x="71" y="737"/>
                </a:lnTo>
                <a:lnTo>
                  <a:pt x="51" y="698"/>
                </a:lnTo>
                <a:lnTo>
                  <a:pt x="36" y="657"/>
                </a:lnTo>
                <a:lnTo>
                  <a:pt x="24" y="615"/>
                </a:lnTo>
                <a:lnTo>
                  <a:pt x="16" y="571"/>
                </a:lnTo>
                <a:lnTo>
                  <a:pt x="11" y="528"/>
                </a:lnTo>
                <a:lnTo>
                  <a:pt x="11" y="483"/>
                </a:lnTo>
                <a:lnTo>
                  <a:pt x="15" y="440"/>
                </a:lnTo>
                <a:lnTo>
                  <a:pt x="23" y="396"/>
                </a:lnTo>
                <a:lnTo>
                  <a:pt x="34" y="354"/>
                </a:lnTo>
                <a:lnTo>
                  <a:pt x="49" y="312"/>
                </a:lnTo>
                <a:lnTo>
                  <a:pt x="67" y="272"/>
                </a:lnTo>
                <a:lnTo>
                  <a:pt x="90" y="235"/>
                </a:lnTo>
                <a:lnTo>
                  <a:pt x="116" y="199"/>
                </a:lnTo>
                <a:lnTo>
                  <a:pt x="144" y="166"/>
                </a:lnTo>
                <a:lnTo>
                  <a:pt x="175" y="135"/>
                </a:lnTo>
                <a:lnTo>
                  <a:pt x="210" y="108"/>
                </a:lnTo>
                <a:lnTo>
                  <a:pt x="246" y="83"/>
                </a:lnTo>
                <a:lnTo>
                  <a:pt x="284" y="62"/>
                </a:lnTo>
                <a:lnTo>
                  <a:pt x="324" y="44"/>
                </a:lnTo>
                <a:lnTo>
                  <a:pt x="366" y="29"/>
                </a:lnTo>
                <a:lnTo>
                  <a:pt x="408" y="20"/>
                </a:lnTo>
                <a:lnTo>
                  <a:pt x="452" y="13"/>
                </a:lnTo>
                <a:lnTo>
                  <a:pt x="496" y="11"/>
                </a:lnTo>
                <a:lnTo>
                  <a:pt x="506" y="11"/>
                </a:lnTo>
                <a:lnTo>
                  <a:pt x="506" y="0"/>
                </a:lnTo>
                <a:close/>
              </a:path>
            </a:pathLst>
          </a:custGeom>
          <a:solidFill>
            <a:srgbClr val="ff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Oval 79"/>
          <p:cNvSpPr/>
          <p:nvPr/>
        </p:nvSpPr>
        <p:spPr>
          <a:xfrm>
            <a:off x="949320" y="2500200"/>
            <a:ext cx="1592280" cy="1594080"/>
          </a:xfrm>
          <a:prstGeom prst="ellipse">
            <a:avLst/>
          </a:prstGeom>
          <a:noFill/>
          <a:ln w="0">
            <a:solidFill>
              <a:srgbClr val="cccc99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Oval 80"/>
          <p:cNvSpPr/>
          <p:nvPr/>
        </p:nvSpPr>
        <p:spPr>
          <a:xfrm>
            <a:off x="966960" y="2517840"/>
            <a:ext cx="1557000" cy="1558800"/>
          </a:xfrm>
          <a:prstGeom prst="ellipse">
            <a:avLst/>
          </a:prstGeom>
          <a:noFill/>
          <a:ln w="0">
            <a:solidFill>
              <a:srgbClr val="cccc99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81"/>
          <p:cNvSpPr/>
          <p:nvPr/>
        </p:nvSpPr>
        <p:spPr>
          <a:xfrm flipV="1">
            <a:off x="1752480" y="2499840"/>
            <a:ext cx="1800" cy="17640"/>
          </a:xfrm>
          <a:prstGeom prst="line">
            <a:avLst/>
          </a:prstGeom>
          <a:ln w="0">
            <a:solidFill>
              <a:srgbClr val="cccc99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82"/>
          <p:cNvSpPr/>
          <p:nvPr/>
        </p:nvSpPr>
        <p:spPr>
          <a:xfrm>
            <a:off x="1487880" y="3173400"/>
            <a:ext cx="572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800" spc="-1" strike="noStrike">
                <a:solidFill>
                  <a:srgbClr val="000000"/>
                </a:solidFill>
                <a:latin typeface="Arial"/>
              </a:rPr>
              <a:t>pDONR/Ze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83"/>
          <p:cNvSpPr/>
          <p:nvPr/>
        </p:nvSpPr>
        <p:spPr>
          <a:xfrm>
            <a:off x="1642680" y="3328920"/>
            <a:ext cx="3178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700" spc="-1" strike="noStrike">
                <a:solidFill>
                  <a:srgbClr val="000000"/>
                </a:solidFill>
                <a:latin typeface="Arial"/>
              </a:rPr>
              <a:t>4291 b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Freeform 84"/>
          <p:cNvSpPr/>
          <p:nvPr/>
        </p:nvSpPr>
        <p:spPr>
          <a:xfrm>
            <a:off x="2352600" y="3444840"/>
            <a:ext cx="211320" cy="338040"/>
          </a:xfrm>
          <a:custGeom>
            <a:avLst/>
            <a:gdLst>
              <a:gd name="textAreaLeft" fmla="*/ 0 w 211320"/>
              <a:gd name="textAreaRight" fmla="*/ 211680 w 211320"/>
              <a:gd name="textAreaTop" fmla="*/ 0 h 338040"/>
              <a:gd name="textAreaBottom" fmla="*/ 338400 h 338040"/>
            </a:gdLst>
            <a:ahLst/>
            <a:rect l="textAreaLeft" t="textAreaTop" r="textAreaRight" b="textAreaBottom"/>
            <a:pathLst>
              <a:path w="133" h="213">
                <a:moveTo>
                  <a:pt x="34" y="213"/>
                </a:moveTo>
                <a:lnTo>
                  <a:pt x="59" y="176"/>
                </a:lnTo>
                <a:lnTo>
                  <a:pt x="81" y="135"/>
                </a:lnTo>
                <a:lnTo>
                  <a:pt x="99" y="93"/>
                </a:lnTo>
                <a:lnTo>
                  <a:pt x="114" y="48"/>
                </a:lnTo>
                <a:lnTo>
                  <a:pt x="117" y="37"/>
                </a:lnTo>
                <a:lnTo>
                  <a:pt x="133" y="41"/>
                </a:lnTo>
                <a:lnTo>
                  <a:pt x="104" y="0"/>
                </a:lnTo>
                <a:lnTo>
                  <a:pt x="62" y="22"/>
                </a:lnTo>
                <a:lnTo>
                  <a:pt x="78" y="26"/>
                </a:lnTo>
                <a:lnTo>
                  <a:pt x="66" y="67"/>
                </a:lnTo>
                <a:lnTo>
                  <a:pt x="50" y="106"/>
                </a:lnTo>
                <a:lnTo>
                  <a:pt x="30" y="145"/>
                </a:lnTo>
                <a:lnTo>
                  <a:pt x="7" y="181"/>
                </a:lnTo>
                <a:lnTo>
                  <a:pt x="0" y="189"/>
                </a:lnTo>
                <a:lnTo>
                  <a:pt x="34" y="213"/>
                </a:lnTo>
                <a:close/>
              </a:path>
            </a:pathLst>
          </a:custGeom>
          <a:solidFill>
            <a:srgbClr val="ff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Arc 85"/>
          <p:cNvSpPr/>
          <p:nvPr/>
        </p:nvSpPr>
        <p:spPr>
          <a:xfrm>
            <a:off x="1746360" y="3297240"/>
            <a:ext cx="793800" cy="485640"/>
          </a:xfrm>
          <a:custGeom>
            <a:avLst/>
            <a:gdLst>
              <a:gd name="textAreaLeft" fmla="*/ 0 w 793800"/>
              <a:gd name="textAreaRight" fmla="*/ 794160 w 793800"/>
              <a:gd name="textAreaTop" fmla="*/ 0 h 485640"/>
              <a:gd name="textAreaBottom" fmla="*/ 486000 h 485640"/>
            </a:gdLst>
            <a:ahLst/>
            <a:rect l="textAreaLeft" t="textAreaTop" r="textAreaRight" b="textAreaBottom"/>
            <a:pathLst>
              <a:path fill="none" w="20904" h="12791">
                <a:moveTo>
                  <a:pt x="20903" y="5440"/>
                </a:moveTo>
                <a:cubicBezTo>
                  <a:pt x="20213" y="8090"/>
                  <a:pt x="19026" y="10584"/>
                  <a:pt x="17405" y="12790"/>
                </a:cubicBezTo>
              </a:path>
              <a:path stroke="0" w="20904" h="12791">
                <a:moveTo>
                  <a:pt x="20903" y="5440"/>
                </a:moveTo>
                <a:cubicBezTo>
                  <a:pt x="20213" y="8090"/>
                  <a:pt x="19026" y="10584"/>
                  <a:pt x="17405" y="12790"/>
                </a:cubicBezTo>
                <a:lnTo>
                  <a:pt x="0" y="0"/>
                </a:lnTo>
                <a:lnTo>
                  <a:pt x="20903" y="5440"/>
                </a:lnTo>
                <a:close/>
              </a:path>
            </a:pathLst>
          </a:custGeom>
          <a:noFill/>
          <a:ln w="0">
            <a:solidFill>
              <a:srgbClr val="993333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Arc 86"/>
          <p:cNvSpPr/>
          <p:nvPr/>
        </p:nvSpPr>
        <p:spPr>
          <a:xfrm>
            <a:off x="1746360" y="3297240"/>
            <a:ext cx="730080" cy="449280"/>
          </a:xfrm>
          <a:custGeom>
            <a:avLst/>
            <a:gdLst>
              <a:gd name="textAreaLeft" fmla="*/ 0 w 730080"/>
              <a:gd name="textAreaRight" fmla="*/ 730080 w 730080"/>
              <a:gd name="textAreaTop" fmla="*/ 0 h 449280"/>
              <a:gd name="textAreaBottom" fmla="*/ 449640 h 449280"/>
            </a:gdLst>
            <a:ahLst/>
            <a:rect l="textAreaLeft" t="textAreaTop" r="textAreaRight" b="textAreaBottom"/>
            <a:pathLst>
              <a:path fill="none" w="20913" h="12820">
                <a:moveTo>
                  <a:pt x="20913" y="5404"/>
                </a:moveTo>
                <a:cubicBezTo>
                  <a:pt x="20221" y="8078"/>
                  <a:pt x="19023" y="10596"/>
                  <a:pt x="17384" y="12820"/>
                </a:cubicBezTo>
              </a:path>
              <a:path stroke="0" w="20913" h="12820">
                <a:moveTo>
                  <a:pt x="20913" y="5404"/>
                </a:moveTo>
                <a:cubicBezTo>
                  <a:pt x="20221" y="8078"/>
                  <a:pt x="19023" y="10596"/>
                  <a:pt x="17384" y="12820"/>
                </a:cubicBezTo>
                <a:lnTo>
                  <a:pt x="0" y="0"/>
                </a:lnTo>
                <a:lnTo>
                  <a:pt x="20913" y="5404"/>
                </a:lnTo>
                <a:close/>
              </a:path>
            </a:pathLst>
          </a:custGeom>
          <a:noFill/>
          <a:ln w="0">
            <a:solidFill>
              <a:srgbClr val="993333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87"/>
          <p:cNvSpPr/>
          <p:nvPr/>
        </p:nvSpPr>
        <p:spPr>
          <a:xfrm>
            <a:off x="2352600" y="3745080"/>
            <a:ext cx="54000" cy="37800"/>
          </a:xfrm>
          <a:prstGeom prst="line">
            <a:avLst/>
          </a:prstGeom>
          <a:ln w="0">
            <a:solidFill>
              <a:srgbClr val="993333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Freeform 88"/>
          <p:cNvSpPr/>
          <p:nvPr/>
        </p:nvSpPr>
        <p:spPr>
          <a:xfrm>
            <a:off x="2451240" y="3444840"/>
            <a:ext cx="112680" cy="65160"/>
          </a:xfrm>
          <a:custGeom>
            <a:avLst/>
            <a:gdLst>
              <a:gd name="textAreaLeft" fmla="*/ 0 w 112680"/>
              <a:gd name="textAreaRight" fmla="*/ 113040 w 112680"/>
              <a:gd name="textAreaTop" fmla="*/ 0 h 65160"/>
              <a:gd name="textAreaBottom" fmla="*/ 65520 h 65160"/>
            </a:gdLst>
            <a:ahLst/>
            <a:rect l="textAreaLeft" t="textAreaTop" r="textAreaRight" b="textAreaBottom"/>
            <a:pathLst>
              <a:path w="57" h="33">
                <a:moveTo>
                  <a:pt x="13" y="21"/>
                </a:moveTo>
                <a:lnTo>
                  <a:pt x="0" y="18"/>
                </a:lnTo>
                <a:lnTo>
                  <a:pt x="34" y="0"/>
                </a:lnTo>
                <a:lnTo>
                  <a:pt x="57" y="33"/>
                </a:lnTo>
                <a:lnTo>
                  <a:pt x="44" y="30"/>
                </a:lnTo>
              </a:path>
            </a:pathLst>
          </a:custGeom>
          <a:noFill/>
          <a:ln w="0">
            <a:solidFill>
              <a:srgbClr val="993333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89"/>
          <p:cNvSpPr/>
          <p:nvPr/>
        </p:nvSpPr>
        <p:spPr>
          <a:xfrm flipH="1" flipV="1">
            <a:off x="2496600" y="3625920"/>
            <a:ext cx="2412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90"/>
          <p:cNvSpPr/>
          <p:nvPr/>
        </p:nvSpPr>
        <p:spPr>
          <a:xfrm>
            <a:off x="2525040" y="3657600"/>
            <a:ext cx="215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700" spc="-1" strike="noStrike">
                <a:solidFill>
                  <a:srgbClr val="000000"/>
                </a:solidFill>
                <a:latin typeface="Arial"/>
              </a:rPr>
              <a:t>ccd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Freeform 91"/>
          <p:cNvSpPr/>
          <p:nvPr/>
        </p:nvSpPr>
        <p:spPr>
          <a:xfrm>
            <a:off x="1328760" y="3948120"/>
            <a:ext cx="747720" cy="169920"/>
          </a:xfrm>
          <a:custGeom>
            <a:avLst/>
            <a:gdLst>
              <a:gd name="textAreaLeft" fmla="*/ 0 w 747720"/>
              <a:gd name="textAreaRight" fmla="*/ 748080 w 747720"/>
              <a:gd name="textAreaTop" fmla="*/ 0 h 169920"/>
              <a:gd name="textAreaBottom" fmla="*/ 170280 h 169920"/>
            </a:gdLst>
            <a:ahLst/>
            <a:rect l="textAreaLeft" t="textAreaTop" r="textAreaRight" b="textAreaBottom"/>
            <a:pathLst>
              <a:path w="471" h="107">
                <a:moveTo>
                  <a:pt x="0" y="35"/>
                </a:moveTo>
                <a:lnTo>
                  <a:pt x="41" y="57"/>
                </a:lnTo>
                <a:lnTo>
                  <a:pt x="85" y="74"/>
                </a:lnTo>
                <a:lnTo>
                  <a:pt x="128" y="89"/>
                </a:lnTo>
                <a:lnTo>
                  <a:pt x="174" y="99"/>
                </a:lnTo>
                <a:lnTo>
                  <a:pt x="219" y="105"/>
                </a:lnTo>
                <a:lnTo>
                  <a:pt x="265" y="107"/>
                </a:lnTo>
                <a:lnTo>
                  <a:pt x="311" y="104"/>
                </a:lnTo>
                <a:lnTo>
                  <a:pt x="357" y="98"/>
                </a:lnTo>
                <a:lnTo>
                  <a:pt x="401" y="88"/>
                </a:lnTo>
                <a:lnTo>
                  <a:pt x="446" y="73"/>
                </a:lnTo>
                <a:lnTo>
                  <a:pt x="447" y="72"/>
                </a:lnTo>
                <a:lnTo>
                  <a:pt x="453" y="88"/>
                </a:lnTo>
                <a:lnTo>
                  <a:pt x="471" y="41"/>
                </a:lnTo>
                <a:lnTo>
                  <a:pt x="427" y="19"/>
                </a:lnTo>
                <a:lnTo>
                  <a:pt x="434" y="34"/>
                </a:lnTo>
                <a:lnTo>
                  <a:pt x="393" y="48"/>
                </a:lnTo>
                <a:lnTo>
                  <a:pt x="352" y="57"/>
                </a:lnTo>
                <a:lnTo>
                  <a:pt x="310" y="63"/>
                </a:lnTo>
                <a:lnTo>
                  <a:pt x="267" y="66"/>
                </a:lnTo>
                <a:lnTo>
                  <a:pt x="224" y="65"/>
                </a:lnTo>
                <a:lnTo>
                  <a:pt x="182" y="60"/>
                </a:lnTo>
                <a:lnTo>
                  <a:pt x="141" y="50"/>
                </a:lnTo>
                <a:lnTo>
                  <a:pt x="101" y="37"/>
                </a:lnTo>
                <a:lnTo>
                  <a:pt x="61" y="21"/>
                </a:lnTo>
                <a:lnTo>
                  <a:pt x="24" y="1"/>
                </a:lnTo>
                <a:lnTo>
                  <a:pt x="21" y="0"/>
                </a:lnTo>
                <a:lnTo>
                  <a:pt x="0" y="35"/>
                </a:lnTo>
                <a:close/>
              </a:path>
            </a:pathLst>
          </a:custGeom>
          <a:solidFill>
            <a:srgbClr val="ff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Arc 92"/>
          <p:cNvSpPr/>
          <p:nvPr/>
        </p:nvSpPr>
        <p:spPr>
          <a:xfrm>
            <a:off x="1328760" y="3297240"/>
            <a:ext cx="709560" cy="820800"/>
          </a:xfrm>
          <a:custGeom>
            <a:avLst/>
            <a:gdLst>
              <a:gd name="textAreaLeft" fmla="*/ 0 w 709560"/>
              <a:gd name="textAreaRight" fmla="*/ 709920 w 709560"/>
              <a:gd name="textAreaTop" fmla="*/ 0 h 820800"/>
              <a:gd name="textAreaBottom" fmla="*/ 821160 h 820800"/>
            </a:gdLst>
            <a:ahLst/>
            <a:rect l="textAreaLeft" t="textAreaTop" r="textAreaRight" b="textAreaBottom"/>
            <a:pathLst>
              <a:path fill="none" w="18708" h="21600">
                <a:moveTo>
                  <a:pt x="18708" y="20177"/>
                </a:moveTo>
                <a:cubicBezTo>
                  <a:pt x="16246" y="21117"/>
                  <a:pt x="13633" y="21599"/>
                  <a:pt x="10998" y="21600"/>
                </a:cubicBezTo>
                <a:cubicBezTo>
                  <a:pt x="7128" y="21600"/>
                  <a:pt x="3330" y="20560"/>
                  <a:pt x="0" y="18590"/>
                </a:cubicBezTo>
              </a:path>
              <a:path stroke="0" w="18708" h="21600">
                <a:moveTo>
                  <a:pt x="18708" y="20177"/>
                </a:moveTo>
                <a:cubicBezTo>
                  <a:pt x="16246" y="21117"/>
                  <a:pt x="13633" y="21599"/>
                  <a:pt x="10998" y="21600"/>
                </a:cubicBezTo>
                <a:cubicBezTo>
                  <a:pt x="7128" y="21600"/>
                  <a:pt x="3330" y="20560"/>
                  <a:pt x="0" y="18590"/>
                </a:cubicBezTo>
                <a:lnTo>
                  <a:pt x="10998" y="0"/>
                </a:lnTo>
                <a:lnTo>
                  <a:pt x="18708" y="20177"/>
                </a:lnTo>
                <a:close/>
              </a:path>
            </a:pathLst>
          </a:custGeom>
          <a:noFill/>
          <a:ln w="0">
            <a:solidFill>
              <a:srgbClr val="993333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Arc 93"/>
          <p:cNvSpPr/>
          <p:nvPr/>
        </p:nvSpPr>
        <p:spPr>
          <a:xfrm>
            <a:off x="1362240" y="3297240"/>
            <a:ext cx="655560" cy="755640"/>
          </a:xfrm>
          <a:custGeom>
            <a:avLst/>
            <a:gdLst>
              <a:gd name="textAreaLeft" fmla="*/ 0 w 655560"/>
              <a:gd name="textAreaRight" fmla="*/ 655920 w 655560"/>
              <a:gd name="textAreaTop" fmla="*/ 0 h 755640"/>
              <a:gd name="textAreaBottom" fmla="*/ 756000 h 755640"/>
            </a:gdLst>
            <a:ahLst/>
            <a:rect l="textAreaLeft" t="textAreaTop" r="textAreaRight" b="textAreaBottom"/>
            <a:pathLst>
              <a:path fill="none" w="18758" h="21600">
                <a:moveTo>
                  <a:pt x="18758" y="20154"/>
                </a:moveTo>
                <a:cubicBezTo>
                  <a:pt x="16278" y="21109"/>
                  <a:pt x="13644" y="21599"/>
                  <a:pt x="10988" y="21600"/>
                </a:cubicBezTo>
                <a:cubicBezTo>
                  <a:pt x="7122" y="21600"/>
                  <a:pt x="3327" y="20562"/>
                  <a:pt x="-1" y="18596"/>
                </a:cubicBezTo>
              </a:path>
              <a:path stroke="0" w="18758" h="21600">
                <a:moveTo>
                  <a:pt x="18758" y="20154"/>
                </a:moveTo>
                <a:cubicBezTo>
                  <a:pt x="16278" y="21109"/>
                  <a:pt x="13644" y="21599"/>
                  <a:pt x="10988" y="21600"/>
                </a:cubicBezTo>
                <a:cubicBezTo>
                  <a:pt x="7122" y="21600"/>
                  <a:pt x="3327" y="20562"/>
                  <a:pt x="-1" y="18596"/>
                </a:cubicBezTo>
                <a:lnTo>
                  <a:pt x="10988" y="0"/>
                </a:lnTo>
                <a:lnTo>
                  <a:pt x="18758" y="20154"/>
                </a:lnTo>
                <a:close/>
              </a:path>
            </a:pathLst>
          </a:custGeom>
          <a:noFill/>
          <a:ln w="0">
            <a:solidFill>
              <a:srgbClr val="993333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94"/>
          <p:cNvSpPr/>
          <p:nvPr/>
        </p:nvSpPr>
        <p:spPr>
          <a:xfrm flipH="1">
            <a:off x="1328400" y="3948120"/>
            <a:ext cx="33480" cy="55440"/>
          </a:xfrm>
          <a:prstGeom prst="line">
            <a:avLst/>
          </a:prstGeom>
          <a:ln w="0">
            <a:solidFill>
              <a:srgbClr val="993333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Freeform 95"/>
          <p:cNvSpPr/>
          <p:nvPr/>
        </p:nvSpPr>
        <p:spPr>
          <a:xfrm>
            <a:off x="2006640" y="3978360"/>
            <a:ext cx="69840" cy="109440"/>
          </a:xfrm>
          <a:custGeom>
            <a:avLst/>
            <a:gdLst>
              <a:gd name="textAreaLeft" fmla="*/ 0 w 69840"/>
              <a:gd name="textAreaRight" fmla="*/ 70200 w 69840"/>
              <a:gd name="textAreaTop" fmla="*/ 0 h 109440"/>
              <a:gd name="textAreaBottom" fmla="*/ 109800 h 109440"/>
            </a:gdLst>
            <a:ahLst/>
            <a:rect l="textAreaLeft" t="textAreaTop" r="textAreaRight" b="textAreaBottom"/>
            <a:pathLst>
              <a:path w="35" h="56">
                <a:moveTo>
                  <a:pt x="5" y="12"/>
                </a:moveTo>
                <a:lnTo>
                  <a:pt x="0" y="0"/>
                </a:lnTo>
                <a:lnTo>
                  <a:pt x="35" y="18"/>
                </a:lnTo>
                <a:lnTo>
                  <a:pt x="21" y="56"/>
                </a:lnTo>
                <a:lnTo>
                  <a:pt x="16" y="43"/>
                </a:lnTo>
              </a:path>
            </a:pathLst>
          </a:custGeom>
          <a:noFill/>
          <a:ln w="0">
            <a:solidFill>
              <a:srgbClr val="993333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96"/>
          <p:cNvSpPr/>
          <p:nvPr/>
        </p:nvSpPr>
        <p:spPr>
          <a:xfrm flipH="1" flipV="1">
            <a:off x="1704600" y="4114800"/>
            <a:ext cx="28440" cy="68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97"/>
          <p:cNvSpPr/>
          <p:nvPr/>
        </p:nvSpPr>
        <p:spPr>
          <a:xfrm>
            <a:off x="1530720" y="4183200"/>
            <a:ext cx="266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700" spc="-1" strike="noStrike">
                <a:solidFill>
                  <a:srgbClr val="000000"/>
                </a:solidFill>
                <a:latin typeface="Arial"/>
              </a:rPr>
              <a:t>Cm(R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Freeform 98"/>
          <p:cNvSpPr/>
          <p:nvPr/>
        </p:nvSpPr>
        <p:spPr>
          <a:xfrm>
            <a:off x="905040" y="2984400"/>
            <a:ext cx="142560" cy="435240"/>
          </a:xfrm>
          <a:custGeom>
            <a:avLst/>
            <a:gdLst>
              <a:gd name="textAreaLeft" fmla="*/ 0 w 142560"/>
              <a:gd name="textAreaRight" fmla="*/ 142920 w 142560"/>
              <a:gd name="textAreaTop" fmla="*/ 0 h 435240"/>
              <a:gd name="textAreaBottom" fmla="*/ 435600 h 435240"/>
            </a:gdLst>
            <a:ahLst/>
            <a:rect l="textAreaLeft" t="textAreaTop" r="textAreaRight" b="textAreaBottom"/>
            <a:pathLst>
              <a:path w="90" h="274">
                <a:moveTo>
                  <a:pt x="53" y="0"/>
                </a:moveTo>
                <a:lnTo>
                  <a:pt x="37" y="43"/>
                </a:lnTo>
                <a:lnTo>
                  <a:pt x="25" y="88"/>
                </a:lnTo>
                <a:lnTo>
                  <a:pt x="17" y="132"/>
                </a:lnTo>
                <a:lnTo>
                  <a:pt x="13" y="179"/>
                </a:lnTo>
                <a:lnTo>
                  <a:pt x="13" y="225"/>
                </a:lnTo>
                <a:lnTo>
                  <a:pt x="16" y="244"/>
                </a:lnTo>
                <a:lnTo>
                  <a:pt x="0" y="245"/>
                </a:lnTo>
                <a:lnTo>
                  <a:pt x="39" y="274"/>
                </a:lnTo>
                <a:lnTo>
                  <a:pt x="73" y="238"/>
                </a:lnTo>
                <a:lnTo>
                  <a:pt x="57" y="240"/>
                </a:lnTo>
                <a:lnTo>
                  <a:pt x="54" y="197"/>
                </a:lnTo>
                <a:lnTo>
                  <a:pt x="56" y="155"/>
                </a:lnTo>
                <a:lnTo>
                  <a:pt x="62" y="112"/>
                </a:lnTo>
                <a:lnTo>
                  <a:pt x="72" y="70"/>
                </a:lnTo>
                <a:lnTo>
                  <a:pt x="84" y="31"/>
                </a:lnTo>
                <a:lnTo>
                  <a:pt x="90" y="15"/>
                </a:lnTo>
                <a:lnTo>
                  <a:pt x="53" y="0"/>
                </a:lnTo>
                <a:close/>
              </a:path>
            </a:pathLst>
          </a:custGeom>
          <a:solidFill>
            <a:srgbClr val="ff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Arc 99"/>
          <p:cNvSpPr/>
          <p:nvPr/>
        </p:nvSpPr>
        <p:spPr>
          <a:xfrm>
            <a:off x="925560" y="2984400"/>
            <a:ext cx="820800" cy="387360"/>
          </a:xfrm>
          <a:custGeom>
            <a:avLst/>
            <a:gdLst>
              <a:gd name="textAreaLeft" fmla="*/ 0 w 820800"/>
              <a:gd name="textAreaRight" fmla="*/ 821160 w 820800"/>
              <a:gd name="textAreaTop" fmla="*/ 0 h 387360"/>
              <a:gd name="textAreaBottom" fmla="*/ 387720 h 387360"/>
            </a:gdLst>
            <a:ahLst/>
            <a:rect l="textAreaLeft" t="textAreaTop" r="textAreaRight" b="textAreaBottom"/>
            <a:pathLst>
              <a:path fill="none" w="21600" h="10203">
                <a:moveTo>
                  <a:pt x="89" y="10203"/>
                </a:moveTo>
                <a:cubicBezTo>
                  <a:pt x="29" y="9549"/>
                  <a:pt x="0" y="8894"/>
                  <a:pt x="0" y="8238"/>
                </a:cubicBezTo>
                <a:cubicBezTo>
                  <a:pt x="-1" y="5411"/>
                  <a:pt x="554" y="2612"/>
                  <a:pt x="1632" y="-1"/>
                </a:cubicBezTo>
              </a:path>
              <a:path stroke="0" w="21600" h="10203">
                <a:moveTo>
                  <a:pt x="89" y="10203"/>
                </a:moveTo>
                <a:cubicBezTo>
                  <a:pt x="29" y="9549"/>
                  <a:pt x="0" y="8894"/>
                  <a:pt x="0" y="8238"/>
                </a:cubicBezTo>
                <a:cubicBezTo>
                  <a:pt x="-1" y="5411"/>
                  <a:pt x="554" y="2612"/>
                  <a:pt x="1632" y="-1"/>
                </a:cubicBezTo>
                <a:lnTo>
                  <a:pt x="21600" y="8238"/>
                </a:lnTo>
                <a:lnTo>
                  <a:pt x="89" y="10203"/>
                </a:lnTo>
                <a:close/>
              </a:path>
            </a:pathLst>
          </a:custGeom>
          <a:noFill/>
          <a:ln w="0">
            <a:solidFill>
              <a:srgbClr val="993333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Arc 100"/>
          <p:cNvSpPr/>
          <p:nvPr/>
        </p:nvSpPr>
        <p:spPr>
          <a:xfrm>
            <a:off x="990720" y="3008160"/>
            <a:ext cx="755640" cy="357480"/>
          </a:xfrm>
          <a:custGeom>
            <a:avLst/>
            <a:gdLst>
              <a:gd name="textAreaLeft" fmla="*/ 0 w 755640"/>
              <a:gd name="textAreaRight" fmla="*/ 756000 w 755640"/>
              <a:gd name="textAreaTop" fmla="*/ 0 h 357480"/>
              <a:gd name="textAreaBottom" fmla="*/ 357480 h 357480"/>
            </a:gdLst>
            <a:ahLst/>
            <a:rect l="textAreaLeft" t="textAreaTop" r="textAreaRight" b="textAreaBottom"/>
            <a:pathLst>
              <a:path fill="none" w="21600" h="10203">
                <a:moveTo>
                  <a:pt x="88" y="10203"/>
                </a:moveTo>
                <a:cubicBezTo>
                  <a:pt x="29" y="9553"/>
                  <a:pt x="0" y="8901"/>
                  <a:pt x="0" y="8249"/>
                </a:cubicBezTo>
                <a:cubicBezTo>
                  <a:pt x="-1" y="5418"/>
                  <a:pt x="556" y="2615"/>
                  <a:pt x="1637" y="0"/>
                </a:cubicBezTo>
              </a:path>
              <a:path stroke="0" w="21600" h="10203">
                <a:moveTo>
                  <a:pt x="88" y="10203"/>
                </a:moveTo>
                <a:cubicBezTo>
                  <a:pt x="29" y="9553"/>
                  <a:pt x="0" y="8901"/>
                  <a:pt x="0" y="8249"/>
                </a:cubicBezTo>
                <a:cubicBezTo>
                  <a:pt x="-1" y="5418"/>
                  <a:pt x="556" y="2615"/>
                  <a:pt x="1637" y="0"/>
                </a:cubicBezTo>
                <a:lnTo>
                  <a:pt x="21600" y="8249"/>
                </a:lnTo>
                <a:lnTo>
                  <a:pt x="88" y="10203"/>
                </a:lnTo>
                <a:close/>
              </a:path>
            </a:pathLst>
          </a:custGeom>
          <a:noFill/>
          <a:ln w="0">
            <a:solidFill>
              <a:srgbClr val="993333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101"/>
          <p:cNvSpPr/>
          <p:nvPr/>
        </p:nvSpPr>
        <p:spPr>
          <a:xfrm flipH="1" flipV="1">
            <a:off x="988560" y="2984400"/>
            <a:ext cx="58680" cy="23760"/>
          </a:xfrm>
          <a:prstGeom prst="line">
            <a:avLst/>
          </a:prstGeom>
          <a:ln w="0">
            <a:solidFill>
              <a:srgbClr val="993333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Freeform 102"/>
          <p:cNvSpPr/>
          <p:nvPr/>
        </p:nvSpPr>
        <p:spPr>
          <a:xfrm>
            <a:off x="905040" y="3362400"/>
            <a:ext cx="115560" cy="57240"/>
          </a:xfrm>
          <a:custGeom>
            <a:avLst/>
            <a:gdLst>
              <a:gd name="textAreaLeft" fmla="*/ 0 w 115560"/>
              <a:gd name="textAreaRight" fmla="*/ 115920 w 115560"/>
              <a:gd name="textAreaTop" fmla="*/ 0 h 57240"/>
              <a:gd name="textAreaBottom" fmla="*/ 57600 h 57240"/>
            </a:gdLst>
            <a:ahLst/>
            <a:rect l="textAreaLeft" t="textAreaTop" r="textAreaRight" b="textAreaBottom"/>
            <a:pathLst>
              <a:path w="59" h="29">
                <a:moveTo>
                  <a:pt x="46" y="2"/>
                </a:moveTo>
                <a:lnTo>
                  <a:pt x="59" y="0"/>
                </a:lnTo>
                <a:lnTo>
                  <a:pt x="32" y="29"/>
                </a:lnTo>
                <a:lnTo>
                  <a:pt x="0" y="6"/>
                </a:lnTo>
                <a:lnTo>
                  <a:pt x="13" y="5"/>
                </a:lnTo>
              </a:path>
            </a:pathLst>
          </a:custGeom>
          <a:noFill/>
          <a:ln w="0">
            <a:solidFill>
              <a:srgbClr val="993333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0800" bIns="10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103"/>
          <p:cNvSpPr/>
          <p:nvPr/>
        </p:nvSpPr>
        <p:spPr>
          <a:xfrm>
            <a:off x="882720" y="3174840"/>
            <a:ext cx="49320" cy="255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104"/>
          <p:cNvSpPr/>
          <p:nvPr/>
        </p:nvSpPr>
        <p:spPr>
          <a:xfrm>
            <a:off x="565560" y="3084480"/>
            <a:ext cx="2779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700" spc="-1" strike="noStrike">
                <a:solidFill>
                  <a:srgbClr val="000000"/>
                </a:solidFill>
                <a:latin typeface="Arial"/>
              </a:rPr>
              <a:t>Zeo(R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Freeform 105"/>
          <p:cNvSpPr/>
          <p:nvPr/>
        </p:nvSpPr>
        <p:spPr>
          <a:xfrm>
            <a:off x="981000" y="2909880"/>
            <a:ext cx="106560" cy="85680"/>
          </a:xfrm>
          <a:custGeom>
            <a:avLst/>
            <a:gdLst>
              <a:gd name="textAreaLeft" fmla="*/ 0 w 106560"/>
              <a:gd name="textAreaRight" fmla="*/ 106920 w 106560"/>
              <a:gd name="textAreaTop" fmla="*/ 0 h 85680"/>
              <a:gd name="textAreaBottom" fmla="*/ 85680 h 85680"/>
            </a:gdLst>
            <a:ahLst/>
            <a:rect l="textAreaLeft" t="textAreaTop" r="textAreaRight" b="textAreaBottom"/>
            <a:pathLst>
              <a:path w="67" h="54">
                <a:moveTo>
                  <a:pt x="26" y="0"/>
                </a:moveTo>
                <a:lnTo>
                  <a:pt x="15" y="23"/>
                </a:lnTo>
                <a:lnTo>
                  <a:pt x="0" y="16"/>
                </a:lnTo>
                <a:lnTo>
                  <a:pt x="24" y="54"/>
                </a:lnTo>
                <a:lnTo>
                  <a:pt x="67" y="47"/>
                </a:lnTo>
                <a:lnTo>
                  <a:pt x="52" y="40"/>
                </a:lnTo>
                <a:lnTo>
                  <a:pt x="63" y="19"/>
                </a:lnTo>
                <a:lnTo>
                  <a:pt x="26" y="0"/>
                </a:lnTo>
                <a:close/>
              </a:path>
            </a:pathLst>
          </a:custGeom>
          <a:solidFill>
            <a:srgbClr val="8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Arc 106"/>
          <p:cNvSpPr/>
          <p:nvPr/>
        </p:nvSpPr>
        <p:spPr>
          <a:xfrm>
            <a:off x="1004760" y="2909880"/>
            <a:ext cx="741600" cy="387360"/>
          </a:xfrm>
          <a:custGeom>
            <a:avLst/>
            <a:gdLst>
              <a:gd name="textAreaLeft" fmla="*/ 0 w 741600"/>
              <a:gd name="textAreaRight" fmla="*/ 741960 w 741600"/>
              <a:gd name="textAreaTop" fmla="*/ 0 h 387360"/>
              <a:gd name="textAreaBottom" fmla="*/ 387720 h 387360"/>
            </a:gdLst>
            <a:ahLst/>
            <a:rect l="textAreaLeft" t="textAreaTop" r="textAreaRight" b="textAreaBottom"/>
            <a:pathLst>
              <a:path fill="none" w="19528" h="10183">
                <a:moveTo>
                  <a:pt x="0" y="951"/>
                </a:moveTo>
                <a:cubicBezTo>
                  <a:pt x="151" y="630"/>
                  <a:pt x="311" y="313"/>
                  <a:pt x="478" y="-1"/>
                </a:cubicBezTo>
              </a:path>
              <a:path stroke="0" w="19528" h="10183">
                <a:moveTo>
                  <a:pt x="0" y="951"/>
                </a:moveTo>
                <a:cubicBezTo>
                  <a:pt x="151" y="630"/>
                  <a:pt x="311" y="313"/>
                  <a:pt x="478" y="-1"/>
                </a:cubicBezTo>
                <a:lnTo>
                  <a:pt x="19528" y="10183"/>
                </a:lnTo>
                <a:lnTo>
                  <a:pt x="0" y="951"/>
                </a:lnTo>
                <a:close/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Arc 107"/>
          <p:cNvSpPr/>
          <p:nvPr/>
        </p:nvSpPr>
        <p:spPr>
          <a:xfrm>
            <a:off x="1063800" y="2940120"/>
            <a:ext cx="682560" cy="357120"/>
          </a:xfrm>
          <a:custGeom>
            <a:avLst/>
            <a:gdLst>
              <a:gd name="textAreaLeft" fmla="*/ 0 w 682560"/>
              <a:gd name="textAreaRight" fmla="*/ 682920 w 682560"/>
              <a:gd name="textAreaTop" fmla="*/ 0 h 357120"/>
              <a:gd name="textAreaBottom" fmla="*/ 357480 h 357120"/>
            </a:gdLst>
            <a:ahLst/>
            <a:rect l="textAreaLeft" t="textAreaTop" r="textAreaRight" b="textAreaBottom"/>
            <a:pathLst>
              <a:path fill="none" w="19519" h="10211">
                <a:moveTo>
                  <a:pt x="-1" y="960"/>
                </a:moveTo>
                <a:cubicBezTo>
                  <a:pt x="153" y="636"/>
                  <a:pt x="315" y="316"/>
                  <a:pt x="484" y="-1"/>
                </a:cubicBezTo>
              </a:path>
              <a:path stroke="0" w="19519" h="10211">
                <a:moveTo>
                  <a:pt x="-1" y="960"/>
                </a:moveTo>
                <a:cubicBezTo>
                  <a:pt x="153" y="636"/>
                  <a:pt x="315" y="316"/>
                  <a:pt x="484" y="-1"/>
                </a:cubicBezTo>
                <a:lnTo>
                  <a:pt x="19519" y="10211"/>
                </a:lnTo>
                <a:lnTo>
                  <a:pt x="-1" y="960"/>
                </a:lnTo>
                <a:close/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108"/>
          <p:cNvSpPr/>
          <p:nvPr/>
        </p:nvSpPr>
        <p:spPr>
          <a:xfrm flipH="1" flipV="1">
            <a:off x="1022040" y="2909880"/>
            <a:ext cx="58680" cy="30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Freeform 109"/>
          <p:cNvSpPr/>
          <p:nvPr/>
        </p:nvSpPr>
        <p:spPr>
          <a:xfrm>
            <a:off x="981000" y="2935440"/>
            <a:ext cx="106560" cy="60120"/>
          </a:xfrm>
          <a:custGeom>
            <a:avLst/>
            <a:gdLst>
              <a:gd name="textAreaLeft" fmla="*/ 0 w 106560"/>
              <a:gd name="textAreaRight" fmla="*/ 106920 w 106560"/>
              <a:gd name="textAreaTop" fmla="*/ 0 h 60120"/>
              <a:gd name="textAreaBottom" fmla="*/ 60480 h 60120"/>
            </a:gdLst>
            <a:ahLst/>
            <a:rect l="textAreaLeft" t="textAreaTop" r="textAreaRight" b="textAreaBottom"/>
            <a:pathLst>
              <a:path w="54" h="31">
                <a:moveTo>
                  <a:pt x="42" y="20"/>
                </a:moveTo>
                <a:lnTo>
                  <a:pt x="54" y="25"/>
                </a:lnTo>
                <a:lnTo>
                  <a:pt x="19" y="31"/>
                </a:lnTo>
                <a:lnTo>
                  <a:pt x="0" y="0"/>
                </a:lnTo>
                <a:lnTo>
                  <a:pt x="12" y="6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110"/>
          <p:cNvSpPr/>
          <p:nvPr/>
        </p:nvSpPr>
        <p:spPr>
          <a:xfrm>
            <a:off x="944640" y="2909880"/>
            <a:ext cx="60120" cy="363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111"/>
          <p:cNvSpPr/>
          <p:nvPr/>
        </p:nvSpPr>
        <p:spPr>
          <a:xfrm>
            <a:off x="326160" y="2787480"/>
            <a:ext cx="593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700" spc="-1" strike="noStrike">
                <a:solidFill>
                  <a:srgbClr val="000000"/>
                </a:solidFill>
                <a:latin typeface="Arial"/>
              </a:rPr>
              <a:t>EM7 promote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Freeform 112"/>
          <p:cNvSpPr/>
          <p:nvPr/>
        </p:nvSpPr>
        <p:spPr>
          <a:xfrm>
            <a:off x="2308320" y="2749680"/>
            <a:ext cx="196920" cy="247680"/>
          </a:xfrm>
          <a:custGeom>
            <a:avLst/>
            <a:gdLst>
              <a:gd name="textAreaLeft" fmla="*/ 0 w 196920"/>
              <a:gd name="textAreaRight" fmla="*/ 197280 w 196920"/>
              <a:gd name="textAreaTop" fmla="*/ 0 h 247680"/>
              <a:gd name="textAreaBottom" fmla="*/ 248040 h 247680"/>
            </a:gdLst>
            <a:ahLst/>
            <a:rect l="textAreaLeft" t="textAreaTop" r="textAreaRight" b="textAreaBottom"/>
            <a:pathLst>
              <a:path w="124" h="156">
                <a:moveTo>
                  <a:pt x="58" y="143"/>
                </a:moveTo>
                <a:lnTo>
                  <a:pt x="104" y="156"/>
                </a:lnTo>
                <a:lnTo>
                  <a:pt x="124" y="110"/>
                </a:lnTo>
                <a:lnTo>
                  <a:pt x="109" y="118"/>
                </a:lnTo>
                <a:lnTo>
                  <a:pt x="88" y="77"/>
                </a:lnTo>
                <a:lnTo>
                  <a:pt x="62" y="39"/>
                </a:lnTo>
                <a:lnTo>
                  <a:pt x="32" y="3"/>
                </a:lnTo>
                <a:lnTo>
                  <a:pt x="31" y="0"/>
                </a:lnTo>
                <a:lnTo>
                  <a:pt x="0" y="27"/>
                </a:lnTo>
                <a:lnTo>
                  <a:pt x="27" y="61"/>
                </a:lnTo>
                <a:lnTo>
                  <a:pt x="51" y="96"/>
                </a:lnTo>
                <a:lnTo>
                  <a:pt x="72" y="133"/>
                </a:lnTo>
                <a:lnTo>
                  <a:pt x="73" y="135"/>
                </a:lnTo>
                <a:lnTo>
                  <a:pt x="58" y="143"/>
                </a:lnTo>
                <a:close/>
              </a:path>
            </a:pathLst>
          </a:custGeom>
          <a:solidFill>
            <a:srgbClr val="66cc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Arc 113"/>
          <p:cNvSpPr/>
          <p:nvPr/>
        </p:nvSpPr>
        <p:spPr>
          <a:xfrm>
            <a:off x="1746360" y="2749680"/>
            <a:ext cx="736560" cy="547560"/>
          </a:xfrm>
          <a:custGeom>
            <a:avLst/>
            <a:gdLst>
              <a:gd name="textAreaLeft" fmla="*/ 0 w 736560"/>
              <a:gd name="textAreaRight" fmla="*/ 736920 w 736560"/>
              <a:gd name="textAreaTop" fmla="*/ 0 h 547560"/>
              <a:gd name="textAreaBottom" fmla="*/ 547920 h 547560"/>
            </a:gdLst>
            <a:ahLst/>
            <a:rect l="textAreaLeft" t="textAreaTop" r="textAreaRight" b="textAreaBottom"/>
            <a:pathLst>
              <a:path fill="none" w="19398" h="14407">
                <a:moveTo>
                  <a:pt x="16093" y="-1"/>
                </a:moveTo>
                <a:cubicBezTo>
                  <a:pt x="17414" y="1475"/>
                  <a:pt x="18526" y="3126"/>
                  <a:pt x="19398" y="4905"/>
                </a:cubicBezTo>
              </a:path>
              <a:path stroke="0" w="19398" h="14407">
                <a:moveTo>
                  <a:pt x="16093" y="-1"/>
                </a:moveTo>
                <a:cubicBezTo>
                  <a:pt x="17414" y="1475"/>
                  <a:pt x="18526" y="3126"/>
                  <a:pt x="19398" y="4905"/>
                </a:cubicBezTo>
                <a:lnTo>
                  <a:pt x="0" y="14407"/>
                </a:lnTo>
                <a:lnTo>
                  <a:pt x="16093" y="-1"/>
                </a:lnTo>
                <a:close/>
              </a:path>
            </a:pathLst>
          </a:custGeom>
          <a:noFill/>
          <a:ln w="0">
            <a:solidFill>
              <a:srgbClr val="00996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Arc 114"/>
          <p:cNvSpPr/>
          <p:nvPr/>
        </p:nvSpPr>
        <p:spPr>
          <a:xfrm>
            <a:off x="1746360" y="2792520"/>
            <a:ext cx="677880" cy="504720"/>
          </a:xfrm>
          <a:custGeom>
            <a:avLst/>
            <a:gdLst>
              <a:gd name="textAreaLeft" fmla="*/ 0 w 677880"/>
              <a:gd name="textAreaRight" fmla="*/ 678240 w 677880"/>
              <a:gd name="textAreaTop" fmla="*/ 0 h 504720"/>
              <a:gd name="textAreaBottom" fmla="*/ 505080 h 504720"/>
            </a:gdLst>
            <a:ahLst/>
            <a:rect l="textAreaLeft" t="textAreaTop" r="textAreaRight" b="textAreaBottom"/>
            <a:pathLst>
              <a:path fill="none" w="19387" h="14426">
                <a:moveTo>
                  <a:pt x="16076" y="-1"/>
                </a:moveTo>
                <a:cubicBezTo>
                  <a:pt x="17399" y="1474"/>
                  <a:pt x="18513" y="3123"/>
                  <a:pt x="19386" y="4902"/>
                </a:cubicBezTo>
              </a:path>
              <a:path stroke="0" w="19387" h="14426">
                <a:moveTo>
                  <a:pt x="16076" y="-1"/>
                </a:moveTo>
                <a:cubicBezTo>
                  <a:pt x="17399" y="1474"/>
                  <a:pt x="18513" y="3123"/>
                  <a:pt x="19386" y="4902"/>
                </a:cubicBezTo>
                <a:lnTo>
                  <a:pt x="0" y="14426"/>
                </a:lnTo>
                <a:lnTo>
                  <a:pt x="16076" y="-1"/>
                </a:lnTo>
                <a:close/>
              </a:path>
            </a:pathLst>
          </a:custGeom>
          <a:noFill/>
          <a:ln w="0">
            <a:solidFill>
              <a:srgbClr val="00996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115"/>
          <p:cNvSpPr/>
          <p:nvPr/>
        </p:nvSpPr>
        <p:spPr>
          <a:xfrm flipV="1">
            <a:off x="2308320" y="2749320"/>
            <a:ext cx="48960" cy="42840"/>
          </a:xfrm>
          <a:prstGeom prst="line">
            <a:avLst/>
          </a:prstGeom>
          <a:ln w="0">
            <a:solidFill>
              <a:srgbClr val="00996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Freeform 116"/>
          <p:cNvSpPr/>
          <p:nvPr/>
        </p:nvSpPr>
        <p:spPr>
          <a:xfrm>
            <a:off x="2400480" y="2924280"/>
            <a:ext cx="104760" cy="73080"/>
          </a:xfrm>
          <a:custGeom>
            <a:avLst/>
            <a:gdLst>
              <a:gd name="textAreaLeft" fmla="*/ 0 w 104760"/>
              <a:gd name="textAreaRight" fmla="*/ 105120 w 104760"/>
              <a:gd name="textAreaTop" fmla="*/ 0 h 73080"/>
              <a:gd name="textAreaBottom" fmla="*/ 73440 h 73080"/>
            </a:gdLst>
            <a:ahLst/>
            <a:rect l="textAreaLeft" t="textAreaTop" r="textAreaRight" b="textAreaBottom"/>
            <a:pathLst>
              <a:path w="53" h="37">
                <a:moveTo>
                  <a:pt x="12" y="20"/>
                </a:moveTo>
                <a:lnTo>
                  <a:pt x="0" y="26"/>
                </a:lnTo>
                <a:lnTo>
                  <a:pt x="37" y="37"/>
                </a:lnTo>
                <a:lnTo>
                  <a:pt x="53" y="0"/>
                </a:lnTo>
                <a:lnTo>
                  <a:pt x="41" y="6"/>
                </a:lnTo>
              </a:path>
            </a:pathLst>
          </a:custGeom>
          <a:noFill/>
          <a:ln w="0">
            <a:solidFill>
              <a:srgbClr val="00996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6640" bIns="26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117"/>
          <p:cNvSpPr/>
          <p:nvPr/>
        </p:nvSpPr>
        <p:spPr>
          <a:xfrm flipH="1">
            <a:off x="2439720" y="2849400"/>
            <a:ext cx="50760" cy="12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118"/>
          <p:cNvSpPr/>
          <p:nvPr/>
        </p:nvSpPr>
        <p:spPr>
          <a:xfrm>
            <a:off x="2496240" y="2759040"/>
            <a:ext cx="215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700" spc="-1" strike="noStrike">
                <a:solidFill>
                  <a:srgbClr val="000000"/>
                </a:solidFill>
                <a:latin typeface="Arial"/>
              </a:rPr>
              <a:t>attP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Freeform 119"/>
          <p:cNvSpPr/>
          <p:nvPr/>
        </p:nvSpPr>
        <p:spPr>
          <a:xfrm>
            <a:off x="973080" y="3548160"/>
            <a:ext cx="174600" cy="242640"/>
          </a:xfrm>
          <a:custGeom>
            <a:avLst/>
            <a:gdLst>
              <a:gd name="textAreaLeft" fmla="*/ 0 w 174600"/>
              <a:gd name="textAreaRight" fmla="*/ 174960 w 174600"/>
              <a:gd name="textAreaTop" fmla="*/ 0 h 242640"/>
              <a:gd name="textAreaBottom" fmla="*/ 243000 h 242640"/>
            </a:gdLst>
            <a:ahLst/>
            <a:rect l="textAreaLeft" t="textAreaTop" r="textAreaRight" b="textAreaBottom"/>
            <a:pathLst>
              <a:path w="110" h="153">
                <a:moveTo>
                  <a:pt x="0" y="14"/>
                </a:moveTo>
                <a:lnTo>
                  <a:pt x="16" y="56"/>
                </a:lnTo>
                <a:lnTo>
                  <a:pt x="37" y="97"/>
                </a:lnTo>
                <a:lnTo>
                  <a:pt x="62" y="137"/>
                </a:lnTo>
                <a:lnTo>
                  <a:pt x="65" y="139"/>
                </a:lnTo>
                <a:lnTo>
                  <a:pt x="51" y="148"/>
                </a:lnTo>
                <a:lnTo>
                  <a:pt x="101" y="153"/>
                </a:lnTo>
                <a:lnTo>
                  <a:pt x="110" y="106"/>
                </a:lnTo>
                <a:lnTo>
                  <a:pt x="98" y="116"/>
                </a:lnTo>
                <a:lnTo>
                  <a:pt x="75" y="80"/>
                </a:lnTo>
                <a:lnTo>
                  <a:pt x="55" y="41"/>
                </a:lnTo>
                <a:lnTo>
                  <a:pt x="39" y="2"/>
                </a:lnTo>
                <a:lnTo>
                  <a:pt x="39" y="0"/>
                </a:lnTo>
                <a:lnTo>
                  <a:pt x="0" y="14"/>
                </a:lnTo>
                <a:close/>
              </a:path>
            </a:pathLst>
          </a:custGeom>
          <a:solidFill>
            <a:srgbClr val="66cc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Arc 120"/>
          <p:cNvSpPr/>
          <p:nvPr/>
        </p:nvSpPr>
        <p:spPr>
          <a:xfrm>
            <a:off x="973080" y="3297240"/>
            <a:ext cx="773280" cy="471600"/>
          </a:xfrm>
          <a:custGeom>
            <a:avLst/>
            <a:gdLst>
              <a:gd name="textAreaLeft" fmla="*/ 0 w 773280"/>
              <a:gd name="textAreaRight" fmla="*/ 773640 w 773280"/>
              <a:gd name="textAreaTop" fmla="*/ 0 h 471600"/>
              <a:gd name="textAreaBottom" fmla="*/ 471960 h 471600"/>
            </a:gdLst>
            <a:ahLst/>
            <a:rect l="textAreaLeft" t="textAreaTop" r="textAreaRight" b="textAreaBottom"/>
            <a:pathLst>
              <a:path fill="none" w="20369" h="12424">
                <a:moveTo>
                  <a:pt x="2699" y="12423"/>
                </a:moveTo>
                <a:cubicBezTo>
                  <a:pt x="1564" y="10809"/>
                  <a:pt x="656" y="9047"/>
                  <a:pt x="-1" y="7187"/>
                </a:cubicBezTo>
              </a:path>
              <a:path stroke="0" w="20369" h="12424">
                <a:moveTo>
                  <a:pt x="2699" y="12423"/>
                </a:moveTo>
                <a:cubicBezTo>
                  <a:pt x="1564" y="10809"/>
                  <a:pt x="656" y="9047"/>
                  <a:pt x="-1" y="7187"/>
                </a:cubicBezTo>
                <a:lnTo>
                  <a:pt x="20369" y="0"/>
                </a:lnTo>
                <a:lnTo>
                  <a:pt x="2699" y="12423"/>
                </a:lnTo>
                <a:close/>
              </a:path>
            </a:pathLst>
          </a:custGeom>
          <a:noFill/>
          <a:ln w="0">
            <a:solidFill>
              <a:srgbClr val="00996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Arc 121"/>
          <p:cNvSpPr/>
          <p:nvPr/>
        </p:nvSpPr>
        <p:spPr>
          <a:xfrm>
            <a:off x="1035000" y="3297240"/>
            <a:ext cx="711360" cy="434880"/>
          </a:xfrm>
          <a:custGeom>
            <a:avLst/>
            <a:gdLst>
              <a:gd name="textAreaLeft" fmla="*/ 0 w 711360"/>
              <a:gd name="textAreaRight" fmla="*/ 711720 w 711360"/>
              <a:gd name="textAreaTop" fmla="*/ 0 h 434880"/>
              <a:gd name="textAreaBottom" fmla="*/ 435240 h 434880"/>
            </a:gdLst>
            <a:ahLst/>
            <a:rect l="textAreaLeft" t="textAreaTop" r="textAreaRight" b="textAreaBottom"/>
            <a:pathLst>
              <a:path fill="none" w="20373" h="12430">
                <a:moveTo>
                  <a:pt x="2707" y="12430"/>
                </a:moveTo>
                <a:cubicBezTo>
                  <a:pt x="1568" y="10811"/>
                  <a:pt x="657" y="9043"/>
                  <a:pt x="0" y="7176"/>
                </a:cubicBezTo>
              </a:path>
              <a:path stroke="0" w="20373" h="12430">
                <a:moveTo>
                  <a:pt x="2707" y="12430"/>
                </a:moveTo>
                <a:cubicBezTo>
                  <a:pt x="1568" y="10811"/>
                  <a:pt x="657" y="9043"/>
                  <a:pt x="0" y="7176"/>
                </a:cubicBezTo>
                <a:lnTo>
                  <a:pt x="20373" y="0"/>
                </a:lnTo>
                <a:lnTo>
                  <a:pt x="2707" y="12430"/>
                </a:lnTo>
                <a:close/>
              </a:path>
            </a:pathLst>
          </a:custGeom>
          <a:noFill/>
          <a:ln w="0">
            <a:solidFill>
              <a:srgbClr val="00996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122"/>
          <p:cNvSpPr/>
          <p:nvPr/>
        </p:nvSpPr>
        <p:spPr>
          <a:xfrm flipH="1">
            <a:off x="973080" y="3548160"/>
            <a:ext cx="61920" cy="21960"/>
          </a:xfrm>
          <a:prstGeom prst="line">
            <a:avLst/>
          </a:prstGeom>
          <a:ln w="0">
            <a:solidFill>
              <a:srgbClr val="00996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Freeform 123"/>
          <p:cNvSpPr/>
          <p:nvPr/>
        </p:nvSpPr>
        <p:spPr>
          <a:xfrm>
            <a:off x="1054080" y="3716280"/>
            <a:ext cx="93600" cy="74520"/>
          </a:xfrm>
          <a:custGeom>
            <a:avLst/>
            <a:gdLst>
              <a:gd name="textAreaLeft" fmla="*/ 0 w 93600"/>
              <a:gd name="textAreaRight" fmla="*/ 93960 w 9360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48" h="38">
                <a:moveTo>
                  <a:pt x="38" y="8"/>
                </a:moveTo>
                <a:lnTo>
                  <a:pt x="48" y="0"/>
                </a:lnTo>
                <a:lnTo>
                  <a:pt x="40" y="38"/>
                </a:lnTo>
                <a:lnTo>
                  <a:pt x="0" y="34"/>
                </a:lnTo>
                <a:lnTo>
                  <a:pt x="11" y="27"/>
                </a:lnTo>
              </a:path>
            </a:pathLst>
          </a:custGeom>
          <a:noFill/>
          <a:ln w="0">
            <a:solidFill>
              <a:srgbClr val="00996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124"/>
          <p:cNvSpPr/>
          <p:nvPr/>
        </p:nvSpPr>
        <p:spPr>
          <a:xfrm>
            <a:off x="1004760" y="3693960"/>
            <a:ext cx="255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125"/>
          <p:cNvSpPr/>
          <p:nvPr/>
        </p:nvSpPr>
        <p:spPr>
          <a:xfrm>
            <a:off x="761040" y="3656160"/>
            <a:ext cx="215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700" spc="-1" strike="noStrike">
                <a:solidFill>
                  <a:srgbClr val="000000"/>
                </a:solidFill>
                <a:latin typeface="Arial"/>
              </a:rPr>
              <a:t>attP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AutoShape 362"/>
          <p:cNvSpPr/>
          <p:nvPr/>
        </p:nvSpPr>
        <p:spPr>
          <a:xfrm>
            <a:off x="6804000" y="2421000"/>
            <a:ext cx="1920960" cy="1977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3" name="Group 155"/>
          <p:cNvGrpSpPr/>
          <p:nvPr/>
        </p:nvGrpSpPr>
        <p:grpSpPr>
          <a:xfrm>
            <a:off x="3479760" y="1628640"/>
            <a:ext cx="2380320" cy="1841760"/>
            <a:chOff x="3479760" y="1628640"/>
            <a:chExt cx="2380320" cy="1841760"/>
          </a:xfrm>
        </p:grpSpPr>
        <p:sp>
          <p:nvSpPr>
            <p:cNvPr id="114" name="AutoShape 154"/>
            <p:cNvSpPr/>
            <p:nvPr/>
          </p:nvSpPr>
          <p:spPr>
            <a:xfrm>
              <a:off x="3564000" y="1628640"/>
              <a:ext cx="2160360" cy="1841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Freeform 156"/>
            <p:cNvSpPr/>
            <p:nvPr/>
          </p:nvSpPr>
          <p:spPr>
            <a:xfrm>
              <a:off x="3800520" y="1859040"/>
              <a:ext cx="1563480" cy="1560600"/>
            </a:xfrm>
            <a:custGeom>
              <a:avLst/>
              <a:gdLst/>
              <a:ahLst/>
              <a:rect l="l" t="t" r="r" b="b"/>
              <a:pathLst>
                <a:path w="985" h="983">
                  <a:moveTo>
                    <a:pt x="496" y="0"/>
                  </a:moveTo>
                  <a:lnTo>
                    <a:pt x="453" y="1"/>
                  </a:lnTo>
                  <a:lnTo>
                    <a:pt x="409" y="7"/>
                  </a:lnTo>
                  <a:lnTo>
                    <a:pt x="366" y="17"/>
                  </a:lnTo>
                  <a:lnTo>
                    <a:pt x="324" y="30"/>
                  </a:lnTo>
                  <a:lnTo>
                    <a:pt x="284" y="47"/>
                  </a:lnTo>
                  <a:lnTo>
                    <a:pt x="245" y="66"/>
                  </a:lnTo>
                  <a:lnTo>
                    <a:pt x="207" y="91"/>
                  </a:lnTo>
                  <a:lnTo>
                    <a:pt x="173" y="117"/>
                  </a:lnTo>
                  <a:lnTo>
                    <a:pt x="140" y="148"/>
                  </a:lnTo>
                  <a:lnTo>
                    <a:pt x="111" y="181"/>
                  </a:lnTo>
                  <a:lnTo>
                    <a:pt x="86" y="216"/>
                  </a:lnTo>
                  <a:lnTo>
                    <a:pt x="62" y="253"/>
                  </a:lnTo>
                  <a:lnTo>
                    <a:pt x="43" y="292"/>
                  </a:lnTo>
                  <a:lnTo>
                    <a:pt x="26" y="334"/>
                  </a:lnTo>
                  <a:lnTo>
                    <a:pt x="14" y="376"/>
                  </a:lnTo>
                  <a:lnTo>
                    <a:pt x="5" y="419"/>
                  </a:lnTo>
                  <a:lnTo>
                    <a:pt x="2" y="462"/>
                  </a:lnTo>
                  <a:lnTo>
                    <a:pt x="0" y="507"/>
                  </a:lnTo>
                  <a:lnTo>
                    <a:pt x="4" y="551"/>
                  </a:lnTo>
                  <a:lnTo>
                    <a:pt x="11" y="594"/>
                  </a:lnTo>
                  <a:lnTo>
                    <a:pt x="22" y="636"/>
                  </a:lnTo>
                  <a:lnTo>
                    <a:pt x="37" y="679"/>
                  </a:lnTo>
                  <a:lnTo>
                    <a:pt x="56" y="717"/>
                  </a:lnTo>
                  <a:lnTo>
                    <a:pt x="78" y="756"/>
                  </a:lnTo>
                  <a:lnTo>
                    <a:pt x="103" y="792"/>
                  </a:lnTo>
                  <a:lnTo>
                    <a:pt x="132" y="826"/>
                  </a:lnTo>
                  <a:lnTo>
                    <a:pt x="163" y="856"/>
                  </a:lnTo>
                  <a:lnTo>
                    <a:pt x="197" y="884"/>
                  </a:lnTo>
                  <a:lnTo>
                    <a:pt x="233" y="909"/>
                  </a:lnTo>
                  <a:lnTo>
                    <a:pt x="271" y="931"/>
                  </a:lnTo>
                  <a:lnTo>
                    <a:pt x="312" y="948"/>
                  </a:lnTo>
                  <a:lnTo>
                    <a:pt x="353" y="963"/>
                  </a:lnTo>
                  <a:lnTo>
                    <a:pt x="395" y="974"/>
                  </a:lnTo>
                  <a:lnTo>
                    <a:pt x="439" y="980"/>
                  </a:lnTo>
                  <a:lnTo>
                    <a:pt x="483" y="983"/>
                  </a:lnTo>
                  <a:lnTo>
                    <a:pt x="527" y="982"/>
                  </a:lnTo>
                  <a:lnTo>
                    <a:pt x="570" y="977"/>
                  </a:lnTo>
                  <a:lnTo>
                    <a:pt x="614" y="968"/>
                  </a:lnTo>
                  <a:lnTo>
                    <a:pt x="657" y="955"/>
                  </a:lnTo>
                  <a:lnTo>
                    <a:pt x="697" y="938"/>
                  </a:lnTo>
                  <a:lnTo>
                    <a:pt x="736" y="919"/>
                  </a:lnTo>
                  <a:lnTo>
                    <a:pt x="773" y="895"/>
                  </a:lnTo>
                  <a:lnTo>
                    <a:pt x="809" y="868"/>
                  </a:lnTo>
                  <a:lnTo>
                    <a:pt x="840" y="839"/>
                  </a:lnTo>
                  <a:lnTo>
                    <a:pt x="871" y="806"/>
                  </a:lnTo>
                  <a:lnTo>
                    <a:pt x="897" y="771"/>
                  </a:lnTo>
                  <a:lnTo>
                    <a:pt x="920" y="734"/>
                  </a:lnTo>
                  <a:lnTo>
                    <a:pt x="940" y="696"/>
                  </a:lnTo>
                  <a:lnTo>
                    <a:pt x="957" y="654"/>
                  </a:lnTo>
                  <a:lnTo>
                    <a:pt x="969" y="612"/>
                  </a:lnTo>
                  <a:lnTo>
                    <a:pt x="979" y="569"/>
                  </a:lnTo>
                  <a:lnTo>
                    <a:pt x="984" y="525"/>
                  </a:lnTo>
                  <a:lnTo>
                    <a:pt x="985" y="482"/>
                  </a:lnTo>
                  <a:lnTo>
                    <a:pt x="981" y="438"/>
                  </a:lnTo>
                  <a:lnTo>
                    <a:pt x="975" y="394"/>
                  </a:lnTo>
                  <a:lnTo>
                    <a:pt x="964" y="352"/>
                  </a:lnTo>
                  <a:lnTo>
                    <a:pt x="950" y="309"/>
                  </a:lnTo>
                  <a:lnTo>
                    <a:pt x="931" y="269"/>
                  </a:lnTo>
                  <a:lnTo>
                    <a:pt x="911" y="232"/>
                  </a:lnTo>
                  <a:lnTo>
                    <a:pt x="885" y="195"/>
                  </a:lnTo>
                  <a:lnTo>
                    <a:pt x="857" y="161"/>
                  </a:lnTo>
                  <a:lnTo>
                    <a:pt x="827" y="130"/>
                  </a:lnTo>
                  <a:lnTo>
                    <a:pt x="793" y="102"/>
                  </a:lnTo>
                  <a:lnTo>
                    <a:pt x="756" y="76"/>
                  </a:lnTo>
                  <a:lnTo>
                    <a:pt x="719" y="54"/>
                  </a:lnTo>
                  <a:lnTo>
                    <a:pt x="679" y="36"/>
                  </a:lnTo>
                  <a:lnTo>
                    <a:pt x="637" y="21"/>
                  </a:lnTo>
                  <a:lnTo>
                    <a:pt x="595" y="10"/>
                  </a:lnTo>
                  <a:lnTo>
                    <a:pt x="551" y="3"/>
                  </a:lnTo>
                  <a:lnTo>
                    <a:pt x="507" y="0"/>
                  </a:lnTo>
                  <a:lnTo>
                    <a:pt x="497" y="0"/>
                  </a:lnTo>
                  <a:lnTo>
                    <a:pt x="497" y="10"/>
                  </a:lnTo>
                  <a:lnTo>
                    <a:pt x="540" y="13"/>
                  </a:lnTo>
                  <a:lnTo>
                    <a:pt x="583" y="19"/>
                  </a:lnTo>
                  <a:lnTo>
                    <a:pt x="625" y="29"/>
                  </a:lnTo>
                  <a:lnTo>
                    <a:pt x="665" y="42"/>
                  </a:lnTo>
                  <a:lnTo>
                    <a:pt x="705" y="59"/>
                  </a:lnTo>
                  <a:lnTo>
                    <a:pt x="743" y="80"/>
                  </a:lnTo>
                  <a:lnTo>
                    <a:pt x="778" y="104"/>
                  </a:lnTo>
                  <a:lnTo>
                    <a:pt x="812" y="131"/>
                  </a:lnTo>
                  <a:lnTo>
                    <a:pt x="843" y="161"/>
                  </a:lnTo>
                  <a:lnTo>
                    <a:pt x="871" y="194"/>
                  </a:lnTo>
                  <a:lnTo>
                    <a:pt x="896" y="229"/>
                  </a:lnTo>
                  <a:lnTo>
                    <a:pt x="918" y="266"/>
                  </a:lnTo>
                  <a:lnTo>
                    <a:pt x="936" y="304"/>
                  </a:lnTo>
                  <a:lnTo>
                    <a:pt x="951" y="345"/>
                  </a:lnTo>
                  <a:lnTo>
                    <a:pt x="963" y="387"/>
                  </a:lnTo>
                  <a:lnTo>
                    <a:pt x="970" y="430"/>
                  </a:lnTo>
                  <a:lnTo>
                    <a:pt x="974" y="472"/>
                  </a:lnTo>
                  <a:lnTo>
                    <a:pt x="974" y="515"/>
                  </a:lnTo>
                  <a:lnTo>
                    <a:pt x="969" y="558"/>
                  </a:lnTo>
                  <a:lnTo>
                    <a:pt x="962" y="600"/>
                  </a:lnTo>
                  <a:lnTo>
                    <a:pt x="950" y="642"/>
                  </a:lnTo>
                  <a:lnTo>
                    <a:pt x="935" y="682"/>
                  </a:lnTo>
                  <a:lnTo>
                    <a:pt x="915" y="721"/>
                  </a:lnTo>
                  <a:lnTo>
                    <a:pt x="894" y="757"/>
                  </a:lnTo>
                  <a:lnTo>
                    <a:pt x="868" y="793"/>
                  </a:lnTo>
                  <a:lnTo>
                    <a:pt x="840" y="824"/>
                  </a:lnTo>
                  <a:lnTo>
                    <a:pt x="809" y="855"/>
                  </a:lnTo>
                  <a:lnTo>
                    <a:pt x="776" y="881"/>
                  </a:lnTo>
                  <a:lnTo>
                    <a:pt x="739" y="904"/>
                  </a:lnTo>
                  <a:lnTo>
                    <a:pt x="702" y="925"/>
                  </a:lnTo>
                  <a:lnTo>
                    <a:pt x="662" y="942"/>
                  </a:lnTo>
                  <a:lnTo>
                    <a:pt x="620" y="955"/>
                  </a:lnTo>
                  <a:lnTo>
                    <a:pt x="579" y="965"/>
                  </a:lnTo>
                  <a:lnTo>
                    <a:pt x="536" y="971"/>
                  </a:lnTo>
                  <a:lnTo>
                    <a:pt x="493" y="972"/>
                  </a:lnTo>
                  <a:lnTo>
                    <a:pt x="450" y="971"/>
                  </a:lnTo>
                  <a:lnTo>
                    <a:pt x="408" y="965"/>
                  </a:lnTo>
                  <a:lnTo>
                    <a:pt x="365" y="955"/>
                  </a:lnTo>
                  <a:lnTo>
                    <a:pt x="325" y="942"/>
                  </a:lnTo>
                  <a:lnTo>
                    <a:pt x="285" y="925"/>
                  </a:lnTo>
                  <a:lnTo>
                    <a:pt x="247" y="906"/>
                  </a:lnTo>
                  <a:lnTo>
                    <a:pt x="211" y="881"/>
                  </a:lnTo>
                  <a:lnTo>
                    <a:pt x="177" y="855"/>
                  </a:lnTo>
                  <a:lnTo>
                    <a:pt x="146" y="826"/>
                  </a:lnTo>
                  <a:lnTo>
                    <a:pt x="117" y="793"/>
                  </a:lnTo>
                  <a:lnTo>
                    <a:pt x="92" y="759"/>
                  </a:lnTo>
                  <a:lnTo>
                    <a:pt x="70" y="721"/>
                  </a:lnTo>
                  <a:lnTo>
                    <a:pt x="50" y="683"/>
                  </a:lnTo>
                  <a:lnTo>
                    <a:pt x="36" y="643"/>
                  </a:lnTo>
                  <a:lnTo>
                    <a:pt x="24" y="601"/>
                  </a:lnTo>
                  <a:lnTo>
                    <a:pt x="16" y="560"/>
                  </a:lnTo>
                  <a:lnTo>
                    <a:pt x="11" y="516"/>
                  </a:lnTo>
                  <a:lnTo>
                    <a:pt x="11" y="473"/>
                  </a:lnTo>
                  <a:lnTo>
                    <a:pt x="15" y="431"/>
                  </a:lnTo>
                  <a:lnTo>
                    <a:pt x="22" y="388"/>
                  </a:lnTo>
                  <a:lnTo>
                    <a:pt x="33" y="346"/>
                  </a:lnTo>
                  <a:lnTo>
                    <a:pt x="48" y="306"/>
                  </a:lnTo>
                  <a:lnTo>
                    <a:pt x="66" y="267"/>
                  </a:lnTo>
                  <a:lnTo>
                    <a:pt x="88" y="230"/>
                  </a:lnTo>
                  <a:lnTo>
                    <a:pt x="113" y="195"/>
                  </a:lnTo>
                  <a:lnTo>
                    <a:pt x="141" y="162"/>
                  </a:lnTo>
                  <a:lnTo>
                    <a:pt x="172" y="132"/>
                  </a:lnTo>
                  <a:lnTo>
                    <a:pt x="206" y="105"/>
                  </a:lnTo>
                  <a:lnTo>
                    <a:pt x="241" y="81"/>
                  </a:lnTo>
                  <a:lnTo>
                    <a:pt x="279" y="60"/>
                  </a:lnTo>
                  <a:lnTo>
                    <a:pt x="319" y="42"/>
                  </a:lnTo>
                  <a:lnTo>
                    <a:pt x="359" y="29"/>
                  </a:lnTo>
                  <a:lnTo>
                    <a:pt x="401" y="19"/>
                  </a:lnTo>
                  <a:lnTo>
                    <a:pt x="444" y="13"/>
                  </a:lnTo>
                  <a:lnTo>
                    <a:pt x="487" y="10"/>
                  </a:lnTo>
                  <a:lnTo>
                    <a:pt x="496" y="10"/>
                  </a:lnTo>
                  <a:lnTo>
                    <a:pt x="496" y="0"/>
                  </a:lnTo>
                  <a:close/>
                </a:path>
              </a:pathLst>
            </a:custGeom>
            <a:solidFill>
              <a:srgbClr val="ff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Oval 157"/>
            <p:cNvSpPr/>
            <p:nvPr/>
          </p:nvSpPr>
          <p:spPr>
            <a:xfrm>
              <a:off x="3800520" y="1859040"/>
              <a:ext cx="1563480" cy="1560600"/>
            </a:xfrm>
            <a:prstGeom prst="ellipse">
              <a:avLst/>
            </a:prstGeom>
            <a:noFill/>
            <a:ln w="0">
              <a:solidFill>
                <a:srgbClr val="cccc99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Oval 158"/>
            <p:cNvSpPr/>
            <p:nvPr/>
          </p:nvSpPr>
          <p:spPr>
            <a:xfrm>
              <a:off x="3817800" y="1874880"/>
              <a:ext cx="1528920" cy="1527120"/>
            </a:xfrm>
            <a:prstGeom prst="ellipse">
              <a:avLst/>
            </a:prstGeom>
            <a:noFill/>
            <a:ln w="0">
              <a:solidFill>
                <a:srgbClr val="cccc99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159"/>
            <p:cNvSpPr/>
            <p:nvPr/>
          </p:nvSpPr>
          <p:spPr>
            <a:xfrm flipV="1">
              <a:off x="4587840" y="1859040"/>
              <a:ext cx="1800" cy="15840"/>
            </a:xfrm>
            <a:prstGeom prst="line">
              <a:avLst/>
            </a:prstGeom>
            <a:ln w="0">
              <a:solidFill>
                <a:srgbClr val="cccc99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160"/>
            <p:cNvSpPr/>
            <p:nvPr/>
          </p:nvSpPr>
          <p:spPr>
            <a:xfrm>
              <a:off x="4277160" y="2517840"/>
              <a:ext cx="619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pDONR-GBSS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161"/>
            <p:cNvSpPr/>
            <p:nvPr/>
          </p:nvSpPr>
          <p:spPr>
            <a:xfrm>
              <a:off x="4479480" y="2668680"/>
              <a:ext cx="317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3906 b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Freeform 162"/>
            <p:cNvSpPr/>
            <p:nvPr/>
          </p:nvSpPr>
          <p:spPr>
            <a:xfrm>
              <a:off x="4786200" y="1854360"/>
              <a:ext cx="327240" cy="226800"/>
            </a:xfrm>
            <a:custGeom>
              <a:avLst/>
              <a:gdLst/>
              <a:ahLst/>
              <a:rect l="l" t="t" r="r" b="b"/>
              <a:pathLst>
                <a:path w="206" h="143">
                  <a:moveTo>
                    <a:pt x="206" y="113"/>
                  </a:moveTo>
                  <a:lnTo>
                    <a:pt x="171" y="85"/>
                  </a:lnTo>
                  <a:lnTo>
                    <a:pt x="133" y="60"/>
                  </a:lnTo>
                  <a:lnTo>
                    <a:pt x="93" y="39"/>
                  </a:lnTo>
                  <a:lnTo>
                    <a:pt x="51" y="21"/>
                  </a:lnTo>
                  <a:lnTo>
                    <a:pt x="37" y="16"/>
                  </a:lnTo>
                  <a:lnTo>
                    <a:pt x="42" y="0"/>
                  </a:lnTo>
                  <a:lnTo>
                    <a:pt x="0" y="26"/>
                  </a:lnTo>
                  <a:lnTo>
                    <a:pt x="19" y="69"/>
                  </a:lnTo>
                  <a:lnTo>
                    <a:pt x="24" y="54"/>
                  </a:lnTo>
                  <a:lnTo>
                    <a:pt x="62" y="69"/>
                  </a:lnTo>
                  <a:lnTo>
                    <a:pt x="100" y="88"/>
                  </a:lnTo>
                  <a:lnTo>
                    <a:pt x="135" y="109"/>
                  </a:lnTo>
                  <a:lnTo>
                    <a:pt x="169" y="135"/>
                  </a:lnTo>
                  <a:lnTo>
                    <a:pt x="179" y="143"/>
                  </a:lnTo>
                  <a:lnTo>
                    <a:pt x="206" y="113"/>
                  </a:lnTo>
                  <a:close/>
                </a:path>
              </a:pathLst>
            </a:custGeom>
            <a:solidFill>
              <a:srgbClr val="ff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Arc 163"/>
            <p:cNvSpPr/>
            <p:nvPr/>
          </p:nvSpPr>
          <p:spPr>
            <a:xfrm>
              <a:off x="4583160" y="1879560"/>
              <a:ext cx="528480" cy="760320"/>
            </a:xfrm>
            <a:custGeom>
              <a:avLst/>
              <a:gdLst/>
              <a:ahLst/>
              <a:rect l="l" t="t" r="r" b="b"/>
              <a:pathLst>
                <a:path fill="none" w="14218" h="20422">
                  <a:moveTo>
                    <a:pt x="7035" y="-1"/>
                  </a:moveTo>
                  <a:cubicBezTo>
                    <a:pt x="9675" y="909"/>
                    <a:pt x="12115" y="2322"/>
                    <a:pt x="14217" y="4161"/>
                  </a:cubicBezTo>
                </a:path>
                <a:path stroke="0" w="14218" h="20422">
                  <a:moveTo>
                    <a:pt x="7035" y="-1"/>
                  </a:moveTo>
                  <a:cubicBezTo>
                    <a:pt x="9675" y="909"/>
                    <a:pt x="12115" y="2322"/>
                    <a:pt x="14217" y="4161"/>
                  </a:cubicBezTo>
                  <a:lnTo>
                    <a:pt x="0" y="20422"/>
                  </a:lnTo>
                  <a:lnTo>
                    <a:pt x="7035" y="-1"/>
                  </a:lnTo>
                  <a:close/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Arc 164"/>
            <p:cNvSpPr/>
            <p:nvPr/>
          </p:nvSpPr>
          <p:spPr>
            <a:xfrm>
              <a:off x="4583160" y="1940040"/>
              <a:ext cx="487440" cy="699840"/>
            </a:xfrm>
            <a:custGeom>
              <a:avLst/>
              <a:gdLst/>
              <a:ahLst/>
              <a:rect l="l" t="t" r="r" b="b"/>
              <a:pathLst>
                <a:path fill="none" w="14197" h="20421">
                  <a:moveTo>
                    <a:pt x="7038" y="0"/>
                  </a:moveTo>
                  <a:cubicBezTo>
                    <a:pt x="9669" y="906"/>
                    <a:pt x="12100" y="2313"/>
                    <a:pt x="14196" y="4142"/>
                  </a:cubicBezTo>
                </a:path>
                <a:path stroke="0" w="14197" h="20421">
                  <a:moveTo>
                    <a:pt x="7038" y="0"/>
                  </a:moveTo>
                  <a:cubicBezTo>
                    <a:pt x="9669" y="906"/>
                    <a:pt x="12100" y="2313"/>
                    <a:pt x="14196" y="4142"/>
                  </a:cubicBezTo>
                  <a:lnTo>
                    <a:pt x="0" y="20421"/>
                  </a:lnTo>
                  <a:lnTo>
                    <a:pt x="7038" y="0"/>
                  </a:lnTo>
                  <a:close/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165"/>
            <p:cNvSpPr/>
            <p:nvPr/>
          </p:nvSpPr>
          <p:spPr>
            <a:xfrm flipV="1">
              <a:off x="5070600" y="2033640"/>
              <a:ext cx="42840" cy="47520"/>
            </a:xfrm>
            <a:prstGeom prst="line">
              <a:avLst/>
            </a:prstGeom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Freeform 166"/>
            <p:cNvSpPr/>
            <p:nvPr/>
          </p:nvSpPr>
          <p:spPr>
            <a:xfrm>
              <a:off x="4786200" y="1854360"/>
              <a:ext cx="66960" cy="109440"/>
            </a:xfrm>
            <a:custGeom>
              <a:avLst/>
              <a:gdLst/>
              <a:ahLst/>
              <a:rect l="l" t="t" r="r" b="b"/>
              <a:pathLst>
                <a:path w="34" h="57">
                  <a:moveTo>
                    <a:pt x="19" y="44"/>
                  </a:moveTo>
                  <a:lnTo>
                    <a:pt x="15" y="57"/>
                  </a:lnTo>
                  <a:lnTo>
                    <a:pt x="0" y="21"/>
                  </a:lnTo>
                  <a:lnTo>
                    <a:pt x="34" y="0"/>
                  </a:lnTo>
                  <a:lnTo>
                    <a:pt x="30" y="13"/>
                  </a:lnTo>
                </a:path>
              </a:pathLst>
            </a:custGeom>
            <a:noFill/>
            <a:ln w="0">
              <a:solidFill>
                <a:srgbClr val="9933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167"/>
            <p:cNvSpPr/>
            <p:nvPr/>
          </p:nvSpPr>
          <p:spPr>
            <a:xfrm flipH="1">
              <a:off x="4962240" y="1881360"/>
              <a:ext cx="3240" cy="50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168"/>
            <p:cNvSpPr/>
            <p:nvPr/>
          </p:nvSpPr>
          <p:spPr>
            <a:xfrm>
              <a:off x="4973400" y="1792440"/>
              <a:ext cx="277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Zeo(R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Freeform 169"/>
            <p:cNvSpPr/>
            <p:nvPr/>
          </p:nvSpPr>
          <p:spPr>
            <a:xfrm>
              <a:off x="5045040" y="3173400"/>
              <a:ext cx="93600" cy="96840"/>
            </a:xfrm>
            <a:custGeom>
              <a:avLst/>
              <a:gdLst/>
              <a:ahLst/>
              <a:rect l="l" t="t" r="r" b="b"/>
              <a:pathLst>
                <a:path w="59" h="61">
                  <a:moveTo>
                    <a:pt x="0" y="6"/>
                  </a:moveTo>
                  <a:lnTo>
                    <a:pt x="1" y="51"/>
                  </a:lnTo>
                  <a:lnTo>
                    <a:pt x="48" y="61"/>
                  </a:lnTo>
                  <a:lnTo>
                    <a:pt x="37" y="49"/>
                  </a:lnTo>
                  <a:lnTo>
                    <a:pt x="59" y="29"/>
                  </a:lnTo>
                  <a:lnTo>
                    <a:pt x="31" y="0"/>
                  </a:lnTo>
                  <a:lnTo>
                    <a:pt x="11" y="18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66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Arc 170"/>
            <p:cNvSpPr/>
            <p:nvPr/>
          </p:nvSpPr>
          <p:spPr>
            <a:xfrm>
              <a:off x="4583160" y="2639880"/>
              <a:ext cx="557280" cy="613080"/>
            </a:xfrm>
            <a:custGeom>
              <a:avLst/>
              <a:gdLst/>
              <a:ahLst/>
              <a:rect l="l" t="t" r="r" b="b"/>
              <a:pathLst>
                <a:path fill="none" w="14950" h="16442">
                  <a:moveTo>
                    <a:pt x="14950" y="15590"/>
                  </a:moveTo>
                  <a:cubicBezTo>
                    <a:pt x="14644" y="15883"/>
                    <a:pt x="14330" y="16167"/>
                    <a:pt x="14007" y="16441"/>
                  </a:cubicBezTo>
                </a:path>
                <a:path stroke="0" w="14950" h="16442">
                  <a:moveTo>
                    <a:pt x="14950" y="15590"/>
                  </a:moveTo>
                  <a:cubicBezTo>
                    <a:pt x="14644" y="15883"/>
                    <a:pt x="14330" y="16167"/>
                    <a:pt x="14007" y="16441"/>
                  </a:cubicBezTo>
                  <a:lnTo>
                    <a:pt x="0" y="0"/>
                  </a:lnTo>
                  <a:lnTo>
                    <a:pt x="14950" y="15590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Arc 171"/>
            <p:cNvSpPr/>
            <p:nvPr/>
          </p:nvSpPr>
          <p:spPr>
            <a:xfrm>
              <a:off x="4583160" y="2639880"/>
              <a:ext cx="512640" cy="563760"/>
            </a:xfrm>
            <a:custGeom>
              <a:avLst/>
              <a:gdLst/>
              <a:ahLst/>
              <a:rect l="l" t="t" r="r" b="b"/>
              <a:pathLst>
                <a:path fill="none" w="14945" h="16433">
                  <a:moveTo>
                    <a:pt x="14945" y="15595"/>
                  </a:moveTo>
                  <a:cubicBezTo>
                    <a:pt x="14644" y="15883"/>
                    <a:pt x="14335" y="16162"/>
                    <a:pt x="14018" y="16432"/>
                  </a:cubicBezTo>
                </a:path>
                <a:path stroke="0" w="14945" h="16433">
                  <a:moveTo>
                    <a:pt x="14945" y="15595"/>
                  </a:moveTo>
                  <a:cubicBezTo>
                    <a:pt x="14644" y="15883"/>
                    <a:pt x="14335" y="16162"/>
                    <a:pt x="14018" y="16432"/>
                  </a:cubicBezTo>
                  <a:lnTo>
                    <a:pt x="0" y="0"/>
                  </a:lnTo>
                  <a:lnTo>
                    <a:pt x="14945" y="15595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172"/>
            <p:cNvSpPr/>
            <p:nvPr/>
          </p:nvSpPr>
          <p:spPr>
            <a:xfrm>
              <a:off x="5094360" y="3173400"/>
              <a:ext cx="44280" cy="46080"/>
            </a:xfrm>
            <a:prstGeom prst="line">
              <a:avLst/>
            </a:prstGeom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Freeform 173"/>
            <p:cNvSpPr/>
            <p:nvPr/>
          </p:nvSpPr>
          <p:spPr>
            <a:xfrm>
              <a:off x="5045040" y="3182760"/>
              <a:ext cx="76320" cy="87480"/>
            </a:xfrm>
            <a:custGeom>
              <a:avLst/>
              <a:gdLst/>
              <a:ahLst/>
              <a:rect l="l" t="t" r="r" b="b"/>
              <a:pathLst>
                <a:path w="39" h="45">
                  <a:moveTo>
                    <a:pt x="9" y="10"/>
                  </a:moveTo>
                  <a:lnTo>
                    <a:pt x="0" y="0"/>
                  </a:lnTo>
                  <a:lnTo>
                    <a:pt x="1" y="37"/>
                  </a:lnTo>
                  <a:lnTo>
                    <a:pt x="39" y="45"/>
                  </a:lnTo>
                  <a:lnTo>
                    <a:pt x="30" y="35"/>
                  </a:lnTo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174"/>
            <p:cNvSpPr/>
            <p:nvPr/>
          </p:nvSpPr>
          <p:spPr>
            <a:xfrm flipH="1" flipV="1">
              <a:off x="5103720" y="3250800"/>
              <a:ext cx="61920" cy="20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175"/>
            <p:cNvSpPr/>
            <p:nvPr/>
          </p:nvSpPr>
          <p:spPr>
            <a:xfrm>
              <a:off x="5171040" y="3271680"/>
              <a:ext cx="209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attL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Freeform 176"/>
            <p:cNvSpPr/>
            <p:nvPr/>
          </p:nvSpPr>
          <p:spPr>
            <a:xfrm>
              <a:off x="4575240" y="1809720"/>
              <a:ext cx="100080" cy="115920"/>
            </a:xfrm>
            <a:custGeom>
              <a:avLst/>
              <a:gdLst/>
              <a:ahLst/>
              <a:rect l="l" t="t" r="r" b="b"/>
              <a:pathLst>
                <a:path w="63" h="73">
                  <a:moveTo>
                    <a:pt x="63" y="20"/>
                  </a:moveTo>
                  <a:lnTo>
                    <a:pt x="31" y="17"/>
                  </a:lnTo>
                  <a:lnTo>
                    <a:pt x="33" y="0"/>
                  </a:lnTo>
                  <a:lnTo>
                    <a:pt x="0" y="37"/>
                  </a:lnTo>
                  <a:lnTo>
                    <a:pt x="29" y="73"/>
                  </a:lnTo>
                  <a:lnTo>
                    <a:pt x="29" y="57"/>
                  </a:lnTo>
                  <a:lnTo>
                    <a:pt x="58" y="60"/>
                  </a:lnTo>
                  <a:lnTo>
                    <a:pt x="63" y="20"/>
                  </a:lnTo>
                  <a:close/>
                </a:path>
              </a:pathLst>
            </a:custGeom>
            <a:solidFill>
              <a:srgbClr val="66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Arc 177"/>
            <p:cNvSpPr/>
            <p:nvPr/>
          </p:nvSpPr>
          <p:spPr>
            <a:xfrm>
              <a:off x="4583160" y="1836720"/>
              <a:ext cx="92160" cy="803160"/>
            </a:xfrm>
            <a:custGeom>
              <a:avLst/>
              <a:gdLst/>
              <a:ahLst/>
              <a:rect l="l" t="t" r="r" b="b"/>
              <a:pathLst>
                <a:path fill="none" w="2474" h="21572">
                  <a:moveTo>
                    <a:pt x="1107" y="0"/>
                  </a:moveTo>
                  <a:cubicBezTo>
                    <a:pt x="1564" y="23"/>
                    <a:pt x="2019" y="61"/>
                    <a:pt x="2473" y="114"/>
                  </a:cubicBezTo>
                </a:path>
                <a:path stroke="0" w="2474" h="21572">
                  <a:moveTo>
                    <a:pt x="1107" y="0"/>
                  </a:moveTo>
                  <a:cubicBezTo>
                    <a:pt x="1564" y="23"/>
                    <a:pt x="2019" y="61"/>
                    <a:pt x="2473" y="114"/>
                  </a:cubicBezTo>
                  <a:lnTo>
                    <a:pt x="0" y="21572"/>
                  </a:lnTo>
                  <a:lnTo>
                    <a:pt x="1107" y="0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Arc 178"/>
            <p:cNvSpPr/>
            <p:nvPr/>
          </p:nvSpPr>
          <p:spPr>
            <a:xfrm>
              <a:off x="4583160" y="1900080"/>
              <a:ext cx="84240" cy="739800"/>
            </a:xfrm>
            <a:custGeom>
              <a:avLst/>
              <a:gdLst/>
              <a:ahLst/>
              <a:rect l="l" t="t" r="r" b="b"/>
              <a:pathLst>
                <a:path fill="none" w="2457" h="21571">
                  <a:moveTo>
                    <a:pt x="1111" y="-1"/>
                  </a:moveTo>
                  <a:cubicBezTo>
                    <a:pt x="1560" y="22"/>
                    <a:pt x="2009" y="59"/>
                    <a:pt x="2456" y="111"/>
                  </a:cubicBezTo>
                </a:path>
                <a:path stroke="0" w="2457" h="21571">
                  <a:moveTo>
                    <a:pt x="1111" y="-1"/>
                  </a:moveTo>
                  <a:cubicBezTo>
                    <a:pt x="1560" y="22"/>
                    <a:pt x="2009" y="59"/>
                    <a:pt x="2456" y="111"/>
                  </a:cubicBezTo>
                  <a:lnTo>
                    <a:pt x="0" y="21571"/>
                  </a:lnTo>
                  <a:lnTo>
                    <a:pt x="1111" y="-1"/>
                  </a:lnTo>
                  <a:close/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179"/>
            <p:cNvSpPr/>
            <p:nvPr/>
          </p:nvSpPr>
          <p:spPr>
            <a:xfrm flipV="1">
              <a:off x="4667400" y="1841040"/>
              <a:ext cx="7920" cy="63720"/>
            </a:xfrm>
            <a:prstGeom prst="line">
              <a:avLst/>
            </a:prstGeom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Freeform 180"/>
            <p:cNvSpPr/>
            <p:nvPr/>
          </p:nvSpPr>
          <p:spPr>
            <a:xfrm>
              <a:off x="4575240" y="1809720"/>
              <a:ext cx="52200" cy="115920"/>
            </a:xfrm>
            <a:custGeom>
              <a:avLst/>
              <a:gdLst/>
              <a:ahLst/>
              <a:rect l="l" t="t" r="r" b="b"/>
              <a:pathLst>
                <a:path w="27" h="60">
                  <a:moveTo>
                    <a:pt x="24" y="47"/>
                  </a:moveTo>
                  <a:lnTo>
                    <a:pt x="24" y="60"/>
                  </a:lnTo>
                  <a:lnTo>
                    <a:pt x="0" y="30"/>
                  </a:lnTo>
                  <a:lnTo>
                    <a:pt x="27" y="0"/>
                  </a:lnTo>
                  <a:lnTo>
                    <a:pt x="26" y="14"/>
                  </a:lnTo>
                </a:path>
              </a:pathLst>
            </a:custGeom>
            <a:noFill/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181"/>
            <p:cNvSpPr/>
            <p:nvPr/>
          </p:nvSpPr>
          <p:spPr>
            <a:xfrm>
              <a:off x="4611600" y="1736640"/>
              <a:ext cx="12960" cy="100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182"/>
            <p:cNvSpPr/>
            <p:nvPr/>
          </p:nvSpPr>
          <p:spPr>
            <a:xfrm>
              <a:off x="4617000" y="1647720"/>
              <a:ext cx="209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attL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Freeform 183"/>
            <p:cNvSpPr/>
            <p:nvPr/>
          </p:nvSpPr>
          <p:spPr>
            <a:xfrm>
              <a:off x="3778200" y="1811160"/>
              <a:ext cx="1284480" cy="1632240"/>
            </a:xfrm>
            <a:custGeom>
              <a:avLst/>
              <a:gdLst/>
              <a:ahLst/>
              <a:rect l="l" t="t" r="r" b="b"/>
              <a:pathLst>
                <a:path w="809" h="1028">
                  <a:moveTo>
                    <a:pt x="470" y="72"/>
                  </a:moveTo>
                  <a:lnTo>
                    <a:pt x="499" y="36"/>
                  </a:lnTo>
                  <a:lnTo>
                    <a:pt x="464" y="0"/>
                  </a:lnTo>
                  <a:lnTo>
                    <a:pt x="465" y="16"/>
                  </a:lnTo>
                  <a:lnTo>
                    <a:pt x="420" y="22"/>
                  </a:lnTo>
                  <a:lnTo>
                    <a:pt x="377" y="32"/>
                  </a:lnTo>
                  <a:lnTo>
                    <a:pt x="333" y="45"/>
                  </a:lnTo>
                  <a:lnTo>
                    <a:pt x="292" y="62"/>
                  </a:lnTo>
                  <a:lnTo>
                    <a:pt x="251" y="84"/>
                  </a:lnTo>
                  <a:lnTo>
                    <a:pt x="214" y="108"/>
                  </a:lnTo>
                  <a:lnTo>
                    <a:pt x="177" y="136"/>
                  </a:lnTo>
                  <a:lnTo>
                    <a:pt x="144" y="167"/>
                  </a:lnTo>
                  <a:lnTo>
                    <a:pt x="114" y="201"/>
                  </a:lnTo>
                  <a:lnTo>
                    <a:pt x="87" y="237"/>
                  </a:lnTo>
                  <a:lnTo>
                    <a:pt x="63" y="276"/>
                  </a:lnTo>
                  <a:lnTo>
                    <a:pt x="44" y="316"/>
                  </a:lnTo>
                  <a:lnTo>
                    <a:pt x="27" y="359"/>
                  </a:lnTo>
                  <a:lnTo>
                    <a:pt x="14" y="401"/>
                  </a:lnTo>
                  <a:lnTo>
                    <a:pt x="5" y="446"/>
                  </a:lnTo>
                  <a:lnTo>
                    <a:pt x="1" y="491"/>
                  </a:lnTo>
                  <a:lnTo>
                    <a:pt x="0" y="536"/>
                  </a:lnTo>
                  <a:lnTo>
                    <a:pt x="4" y="582"/>
                  </a:lnTo>
                  <a:lnTo>
                    <a:pt x="11" y="626"/>
                  </a:lnTo>
                  <a:lnTo>
                    <a:pt x="22" y="671"/>
                  </a:lnTo>
                  <a:lnTo>
                    <a:pt x="38" y="713"/>
                  </a:lnTo>
                  <a:lnTo>
                    <a:pt x="56" y="753"/>
                  </a:lnTo>
                  <a:lnTo>
                    <a:pt x="79" y="794"/>
                  </a:lnTo>
                  <a:lnTo>
                    <a:pt x="104" y="830"/>
                  </a:lnTo>
                  <a:lnTo>
                    <a:pt x="135" y="865"/>
                  </a:lnTo>
                  <a:lnTo>
                    <a:pt x="166" y="897"/>
                  </a:lnTo>
                  <a:lnTo>
                    <a:pt x="202" y="926"/>
                  </a:lnTo>
                  <a:lnTo>
                    <a:pt x="238" y="951"/>
                  </a:lnTo>
                  <a:lnTo>
                    <a:pt x="278" y="973"/>
                  </a:lnTo>
                  <a:lnTo>
                    <a:pt x="319" y="993"/>
                  </a:lnTo>
                  <a:lnTo>
                    <a:pt x="362" y="1007"/>
                  </a:lnTo>
                  <a:lnTo>
                    <a:pt x="406" y="1018"/>
                  </a:lnTo>
                  <a:lnTo>
                    <a:pt x="451" y="1024"/>
                  </a:lnTo>
                  <a:lnTo>
                    <a:pt x="496" y="1028"/>
                  </a:lnTo>
                  <a:lnTo>
                    <a:pt x="542" y="1027"/>
                  </a:lnTo>
                  <a:lnTo>
                    <a:pt x="587" y="1022"/>
                  </a:lnTo>
                  <a:lnTo>
                    <a:pt x="631" y="1012"/>
                  </a:lnTo>
                  <a:lnTo>
                    <a:pt x="674" y="999"/>
                  </a:lnTo>
                  <a:lnTo>
                    <a:pt x="717" y="983"/>
                  </a:lnTo>
                  <a:lnTo>
                    <a:pt x="757" y="962"/>
                  </a:lnTo>
                  <a:lnTo>
                    <a:pt x="795" y="938"/>
                  </a:lnTo>
                  <a:lnTo>
                    <a:pt x="809" y="927"/>
                  </a:lnTo>
                  <a:lnTo>
                    <a:pt x="786" y="896"/>
                  </a:lnTo>
                  <a:lnTo>
                    <a:pt x="751" y="919"/>
                  </a:lnTo>
                  <a:lnTo>
                    <a:pt x="714" y="939"/>
                  </a:lnTo>
                  <a:lnTo>
                    <a:pt x="677" y="956"/>
                  </a:lnTo>
                  <a:lnTo>
                    <a:pt x="637" y="970"/>
                  </a:lnTo>
                  <a:lnTo>
                    <a:pt x="597" y="979"/>
                  </a:lnTo>
                  <a:lnTo>
                    <a:pt x="555" y="985"/>
                  </a:lnTo>
                  <a:lnTo>
                    <a:pt x="514" y="988"/>
                  </a:lnTo>
                  <a:lnTo>
                    <a:pt x="471" y="987"/>
                  </a:lnTo>
                  <a:lnTo>
                    <a:pt x="430" y="982"/>
                  </a:lnTo>
                  <a:lnTo>
                    <a:pt x="390" y="973"/>
                  </a:lnTo>
                  <a:lnTo>
                    <a:pt x="350" y="961"/>
                  </a:lnTo>
                  <a:lnTo>
                    <a:pt x="311" y="945"/>
                  </a:lnTo>
                  <a:lnTo>
                    <a:pt x="275" y="926"/>
                  </a:lnTo>
                  <a:lnTo>
                    <a:pt x="239" y="904"/>
                  </a:lnTo>
                  <a:lnTo>
                    <a:pt x="205" y="879"/>
                  </a:lnTo>
                  <a:lnTo>
                    <a:pt x="175" y="849"/>
                  </a:lnTo>
                  <a:lnTo>
                    <a:pt x="147" y="819"/>
                  </a:lnTo>
                  <a:lnTo>
                    <a:pt x="121" y="785"/>
                  </a:lnTo>
                  <a:lnTo>
                    <a:pt x="100" y="750"/>
                  </a:lnTo>
                  <a:lnTo>
                    <a:pt x="81" y="713"/>
                  </a:lnTo>
                  <a:lnTo>
                    <a:pt x="66" y="675"/>
                  </a:lnTo>
                  <a:lnTo>
                    <a:pt x="53" y="634"/>
                  </a:lnTo>
                  <a:lnTo>
                    <a:pt x="45" y="593"/>
                  </a:lnTo>
                  <a:lnTo>
                    <a:pt x="41" y="552"/>
                  </a:lnTo>
                  <a:lnTo>
                    <a:pt x="40" y="511"/>
                  </a:lnTo>
                  <a:lnTo>
                    <a:pt x="42" y="468"/>
                  </a:lnTo>
                  <a:lnTo>
                    <a:pt x="50" y="427"/>
                  </a:lnTo>
                  <a:lnTo>
                    <a:pt x="59" y="387"/>
                  </a:lnTo>
                  <a:lnTo>
                    <a:pt x="73" y="348"/>
                  </a:lnTo>
                  <a:lnTo>
                    <a:pt x="91" y="310"/>
                  </a:lnTo>
                  <a:lnTo>
                    <a:pt x="112" y="274"/>
                  </a:lnTo>
                  <a:lnTo>
                    <a:pt x="135" y="238"/>
                  </a:lnTo>
                  <a:lnTo>
                    <a:pt x="162" y="207"/>
                  </a:lnTo>
                  <a:lnTo>
                    <a:pt x="191" y="178"/>
                  </a:lnTo>
                  <a:lnTo>
                    <a:pt x="223" y="151"/>
                  </a:lnTo>
                  <a:lnTo>
                    <a:pt x="258" y="127"/>
                  </a:lnTo>
                  <a:lnTo>
                    <a:pt x="294" y="106"/>
                  </a:lnTo>
                  <a:lnTo>
                    <a:pt x="332" y="89"/>
                  </a:lnTo>
                  <a:lnTo>
                    <a:pt x="371" y="74"/>
                  </a:lnTo>
                  <a:lnTo>
                    <a:pt x="412" y="65"/>
                  </a:lnTo>
                  <a:lnTo>
                    <a:pt x="453" y="57"/>
                  </a:lnTo>
                  <a:lnTo>
                    <a:pt x="469" y="56"/>
                  </a:lnTo>
                  <a:lnTo>
                    <a:pt x="470" y="72"/>
                  </a:lnTo>
                  <a:close/>
                </a:path>
              </a:pathLst>
            </a:custGeom>
            <a:solidFill>
              <a:srgbClr val="00b0f0"/>
            </a:solidFill>
            <a:ln w="9360">
              <a:solidFill>
                <a:srgbClr val="00b0f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186"/>
            <p:cNvSpPr/>
            <p:nvPr/>
          </p:nvSpPr>
          <p:spPr>
            <a:xfrm>
              <a:off x="5025960" y="3233880"/>
              <a:ext cx="36720" cy="48960"/>
            </a:xfrm>
            <a:prstGeom prst="line">
              <a:avLst/>
            </a:prstGeom>
            <a:ln w="0">
              <a:solidFill>
                <a:srgbClr val="00996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188"/>
            <p:cNvSpPr/>
            <p:nvPr/>
          </p:nvSpPr>
          <p:spPr>
            <a:xfrm flipV="1">
              <a:off x="3784680" y="2897280"/>
              <a:ext cx="3636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189"/>
            <p:cNvSpPr/>
            <p:nvPr/>
          </p:nvSpPr>
          <p:spPr>
            <a:xfrm>
              <a:off x="3479760" y="2905200"/>
              <a:ext cx="276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GBSS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Freeform 190"/>
            <p:cNvSpPr/>
            <p:nvPr/>
          </p:nvSpPr>
          <p:spPr>
            <a:xfrm>
              <a:off x="5073480" y="2038320"/>
              <a:ext cx="86040" cy="85680"/>
            </a:xfrm>
            <a:custGeom>
              <a:avLst/>
              <a:gdLst/>
              <a:ahLst/>
              <a:rect l="l" t="t" r="r" b="b"/>
              <a:pathLst>
                <a:path w="54" h="54">
                  <a:moveTo>
                    <a:pt x="54" y="26"/>
                  </a:moveTo>
                  <a:lnTo>
                    <a:pt x="39" y="12"/>
                  </a:lnTo>
                  <a:lnTo>
                    <a:pt x="50" y="0"/>
                  </a:lnTo>
                  <a:lnTo>
                    <a:pt x="11" y="13"/>
                  </a:lnTo>
                  <a:lnTo>
                    <a:pt x="0" y="52"/>
                  </a:lnTo>
                  <a:lnTo>
                    <a:pt x="13" y="41"/>
                  </a:lnTo>
                  <a:lnTo>
                    <a:pt x="26" y="54"/>
                  </a:lnTo>
                  <a:lnTo>
                    <a:pt x="54" y="26"/>
                  </a:lnTo>
                  <a:close/>
                </a:path>
              </a:pathLst>
            </a:custGeom>
            <a:solidFill>
              <a:srgbClr val="8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Arc 191"/>
            <p:cNvSpPr/>
            <p:nvPr/>
          </p:nvSpPr>
          <p:spPr>
            <a:xfrm>
              <a:off x="4583160" y="2055960"/>
              <a:ext cx="576360" cy="583920"/>
            </a:xfrm>
            <a:custGeom>
              <a:avLst/>
              <a:gdLst/>
              <a:ahLst/>
              <a:rect l="l" t="t" r="r" b="b"/>
              <a:pathLst>
                <a:path fill="none" w="15485" h="15674">
                  <a:moveTo>
                    <a:pt x="14862" y="-1"/>
                  </a:moveTo>
                  <a:cubicBezTo>
                    <a:pt x="15073" y="200"/>
                    <a:pt x="15281" y="405"/>
                    <a:pt x="15485" y="614"/>
                  </a:cubicBezTo>
                </a:path>
                <a:path stroke="0" w="15485" h="15674">
                  <a:moveTo>
                    <a:pt x="14862" y="-1"/>
                  </a:moveTo>
                  <a:cubicBezTo>
                    <a:pt x="15073" y="200"/>
                    <a:pt x="15281" y="405"/>
                    <a:pt x="15485" y="614"/>
                  </a:cubicBezTo>
                  <a:lnTo>
                    <a:pt x="0" y="15674"/>
                  </a:lnTo>
                  <a:lnTo>
                    <a:pt x="14862" y="-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Arc 192"/>
            <p:cNvSpPr/>
            <p:nvPr/>
          </p:nvSpPr>
          <p:spPr>
            <a:xfrm>
              <a:off x="4583160" y="2103480"/>
              <a:ext cx="531720" cy="536400"/>
            </a:xfrm>
            <a:custGeom>
              <a:avLst/>
              <a:gdLst/>
              <a:ahLst/>
              <a:rect l="l" t="t" r="r" b="b"/>
              <a:pathLst>
                <a:path fill="none" w="15503" h="15639">
                  <a:moveTo>
                    <a:pt x="14899" y="-1"/>
                  </a:moveTo>
                  <a:cubicBezTo>
                    <a:pt x="15104" y="195"/>
                    <a:pt x="15305" y="395"/>
                    <a:pt x="15503" y="598"/>
                  </a:cubicBezTo>
                </a:path>
                <a:path stroke="0" w="15503" h="15639">
                  <a:moveTo>
                    <a:pt x="14899" y="-1"/>
                  </a:moveTo>
                  <a:cubicBezTo>
                    <a:pt x="15104" y="195"/>
                    <a:pt x="15305" y="395"/>
                    <a:pt x="15503" y="598"/>
                  </a:cubicBezTo>
                  <a:lnTo>
                    <a:pt x="0" y="15639"/>
                  </a:lnTo>
                  <a:lnTo>
                    <a:pt x="14899" y="-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193"/>
            <p:cNvSpPr/>
            <p:nvPr/>
          </p:nvSpPr>
          <p:spPr>
            <a:xfrm flipV="1">
              <a:off x="5114880" y="2079360"/>
              <a:ext cx="44640" cy="4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Freeform 194"/>
            <p:cNvSpPr/>
            <p:nvPr/>
          </p:nvSpPr>
          <p:spPr>
            <a:xfrm>
              <a:off x="5073480" y="2038320"/>
              <a:ext cx="79560" cy="82440"/>
            </a:xfrm>
            <a:custGeom>
              <a:avLst/>
              <a:gdLst/>
              <a:ahLst/>
              <a:rect l="l" t="t" r="r" b="b"/>
              <a:pathLst>
                <a:path w="41" h="43">
                  <a:moveTo>
                    <a:pt x="10" y="34"/>
                  </a:moveTo>
                  <a:lnTo>
                    <a:pt x="0" y="43"/>
                  </a:lnTo>
                  <a:lnTo>
                    <a:pt x="9" y="11"/>
                  </a:lnTo>
                  <a:lnTo>
                    <a:pt x="41" y="0"/>
                  </a:lnTo>
                  <a:lnTo>
                    <a:pt x="32" y="1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195"/>
            <p:cNvSpPr/>
            <p:nvPr/>
          </p:nvSpPr>
          <p:spPr>
            <a:xfrm flipH="1">
              <a:off x="5135400" y="2011320"/>
              <a:ext cx="122400" cy="46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196"/>
            <p:cNvSpPr/>
            <p:nvPr/>
          </p:nvSpPr>
          <p:spPr>
            <a:xfrm>
              <a:off x="5266440" y="1922400"/>
              <a:ext cx="593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000000"/>
                  </a:solidFill>
                  <a:latin typeface="Arial"/>
                </a:rPr>
                <a:t>EM7 promote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3" name="Group 344"/>
          <p:cNvGrpSpPr/>
          <p:nvPr/>
        </p:nvGrpSpPr>
        <p:grpSpPr>
          <a:xfrm>
            <a:off x="6877080" y="2565360"/>
            <a:ext cx="1942920" cy="2040480"/>
            <a:chOff x="6877080" y="2565360"/>
            <a:chExt cx="1942920" cy="2040480"/>
          </a:xfrm>
        </p:grpSpPr>
        <p:sp>
          <p:nvSpPr>
            <p:cNvPr id="154" name="AutoShape 343"/>
            <p:cNvSpPr/>
            <p:nvPr/>
          </p:nvSpPr>
          <p:spPr>
            <a:xfrm>
              <a:off x="6877080" y="2565360"/>
              <a:ext cx="1942920" cy="203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345"/>
            <p:cNvSpPr/>
            <p:nvPr/>
          </p:nvSpPr>
          <p:spPr>
            <a:xfrm>
              <a:off x="7207200" y="2782800"/>
              <a:ext cx="1595520" cy="1595520"/>
            </a:xfrm>
            <a:custGeom>
              <a:avLst/>
              <a:gdLst>
                <a:gd name="textAreaLeft" fmla="*/ 0 w 1595520"/>
                <a:gd name="textAreaRight" fmla="*/ 1595880 w 1595520"/>
                <a:gd name="textAreaTop" fmla="*/ 0 h 1595520"/>
                <a:gd name="textAreaBottom" fmla="*/ 1595880 h 1595520"/>
              </a:gdLst>
              <a:ahLst/>
              <a:rect l="textAreaLeft" t="textAreaTop" r="textAreaRight" b="textAreaBottom"/>
              <a:pathLst>
                <a:path w="1005" h="1005">
                  <a:moveTo>
                    <a:pt x="506" y="0"/>
                  </a:moveTo>
                  <a:lnTo>
                    <a:pt x="461" y="2"/>
                  </a:lnTo>
                  <a:lnTo>
                    <a:pt x="417" y="8"/>
                  </a:lnTo>
                  <a:lnTo>
                    <a:pt x="373" y="17"/>
                  </a:lnTo>
                  <a:lnTo>
                    <a:pt x="330" y="31"/>
                  </a:lnTo>
                  <a:lnTo>
                    <a:pt x="289" y="48"/>
                  </a:lnTo>
                  <a:lnTo>
                    <a:pt x="249" y="69"/>
                  </a:lnTo>
                  <a:lnTo>
                    <a:pt x="211" y="93"/>
                  </a:lnTo>
                  <a:lnTo>
                    <a:pt x="175" y="121"/>
                  </a:lnTo>
                  <a:lnTo>
                    <a:pt x="143" y="151"/>
                  </a:lnTo>
                  <a:lnTo>
                    <a:pt x="113" y="185"/>
                  </a:lnTo>
                  <a:lnTo>
                    <a:pt x="86" y="221"/>
                  </a:lnTo>
                  <a:lnTo>
                    <a:pt x="62" y="259"/>
                  </a:lnTo>
                  <a:lnTo>
                    <a:pt x="42" y="299"/>
                  </a:lnTo>
                  <a:lnTo>
                    <a:pt x="26" y="341"/>
                  </a:lnTo>
                  <a:lnTo>
                    <a:pt x="14" y="384"/>
                  </a:lnTo>
                  <a:lnTo>
                    <a:pt x="5" y="428"/>
                  </a:lnTo>
                  <a:lnTo>
                    <a:pt x="0" y="473"/>
                  </a:lnTo>
                  <a:lnTo>
                    <a:pt x="0" y="518"/>
                  </a:lnTo>
                  <a:lnTo>
                    <a:pt x="3" y="563"/>
                  </a:lnTo>
                  <a:lnTo>
                    <a:pt x="10" y="607"/>
                  </a:lnTo>
                  <a:lnTo>
                    <a:pt x="22" y="651"/>
                  </a:lnTo>
                  <a:lnTo>
                    <a:pt x="37" y="693"/>
                  </a:lnTo>
                  <a:lnTo>
                    <a:pt x="56" y="734"/>
                  </a:lnTo>
                  <a:lnTo>
                    <a:pt x="78" y="773"/>
                  </a:lnTo>
                  <a:lnTo>
                    <a:pt x="104" y="809"/>
                  </a:lnTo>
                  <a:lnTo>
                    <a:pt x="133" y="844"/>
                  </a:lnTo>
                  <a:lnTo>
                    <a:pt x="165" y="876"/>
                  </a:lnTo>
                  <a:lnTo>
                    <a:pt x="199" y="904"/>
                  </a:lnTo>
                  <a:lnTo>
                    <a:pt x="237" y="929"/>
                  </a:lnTo>
                  <a:lnTo>
                    <a:pt x="276" y="951"/>
                  </a:lnTo>
                  <a:lnTo>
                    <a:pt x="317" y="970"/>
                  </a:lnTo>
                  <a:lnTo>
                    <a:pt x="359" y="985"/>
                  </a:lnTo>
                  <a:lnTo>
                    <a:pt x="403" y="996"/>
                  </a:lnTo>
                  <a:lnTo>
                    <a:pt x="447" y="1002"/>
                  </a:lnTo>
                  <a:lnTo>
                    <a:pt x="492" y="1005"/>
                  </a:lnTo>
                  <a:lnTo>
                    <a:pt x="537" y="1004"/>
                  </a:lnTo>
                  <a:lnTo>
                    <a:pt x="581" y="999"/>
                  </a:lnTo>
                  <a:lnTo>
                    <a:pt x="625" y="990"/>
                  </a:lnTo>
                  <a:lnTo>
                    <a:pt x="669" y="977"/>
                  </a:lnTo>
                  <a:lnTo>
                    <a:pt x="710" y="960"/>
                  </a:lnTo>
                  <a:lnTo>
                    <a:pt x="750" y="940"/>
                  </a:lnTo>
                  <a:lnTo>
                    <a:pt x="789" y="916"/>
                  </a:lnTo>
                  <a:lnTo>
                    <a:pt x="824" y="888"/>
                  </a:lnTo>
                  <a:lnTo>
                    <a:pt x="857" y="858"/>
                  </a:lnTo>
                  <a:lnTo>
                    <a:pt x="887" y="825"/>
                  </a:lnTo>
                  <a:lnTo>
                    <a:pt x="915" y="789"/>
                  </a:lnTo>
                  <a:lnTo>
                    <a:pt x="939" y="751"/>
                  </a:lnTo>
                  <a:lnTo>
                    <a:pt x="959" y="711"/>
                  </a:lnTo>
                  <a:lnTo>
                    <a:pt x="976" y="669"/>
                  </a:lnTo>
                  <a:lnTo>
                    <a:pt x="989" y="626"/>
                  </a:lnTo>
                  <a:lnTo>
                    <a:pt x="998" y="583"/>
                  </a:lnTo>
                  <a:lnTo>
                    <a:pt x="1003" y="538"/>
                  </a:lnTo>
                  <a:lnTo>
                    <a:pt x="1005" y="493"/>
                  </a:lnTo>
                  <a:lnTo>
                    <a:pt x="1002" y="448"/>
                  </a:lnTo>
                  <a:lnTo>
                    <a:pt x="995" y="404"/>
                  </a:lnTo>
                  <a:lnTo>
                    <a:pt x="984" y="360"/>
                  </a:lnTo>
                  <a:lnTo>
                    <a:pt x="969" y="318"/>
                  </a:lnTo>
                  <a:lnTo>
                    <a:pt x="951" y="276"/>
                  </a:lnTo>
                  <a:lnTo>
                    <a:pt x="929" y="237"/>
                  </a:lnTo>
                  <a:lnTo>
                    <a:pt x="903" y="200"/>
                  </a:lnTo>
                  <a:lnTo>
                    <a:pt x="875" y="166"/>
                  </a:lnTo>
                  <a:lnTo>
                    <a:pt x="843" y="134"/>
                  </a:lnTo>
                  <a:lnTo>
                    <a:pt x="809" y="104"/>
                  </a:lnTo>
                  <a:lnTo>
                    <a:pt x="772" y="79"/>
                  </a:lnTo>
                  <a:lnTo>
                    <a:pt x="733" y="56"/>
                  </a:lnTo>
                  <a:lnTo>
                    <a:pt x="692" y="37"/>
                  </a:lnTo>
                  <a:lnTo>
                    <a:pt x="650" y="22"/>
                  </a:lnTo>
                  <a:lnTo>
                    <a:pt x="606" y="11"/>
                  </a:lnTo>
                  <a:lnTo>
                    <a:pt x="562" y="4"/>
                  </a:lnTo>
                  <a:lnTo>
                    <a:pt x="517" y="0"/>
                  </a:lnTo>
                  <a:lnTo>
                    <a:pt x="507" y="0"/>
                  </a:lnTo>
                  <a:lnTo>
                    <a:pt x="507" y="11"/>
                  </a:lnTo>
                  <a:lnTo>
                    <a:pt x="551" y="13"/>
                  </a:lnTo>
                  <a:lnTo>
                    <a:pt x="595" y="20"/>
                  </a:lnTo>
                  <a:lnTo>
                    <a:pt x="637" y="30"/>
                  </a:lnTo>
                  <a:lnTo>
                    <a:pt x="679" y="44"/>
                  </a:lnTo>
                  <a:lnTo>
                    <a:pt x="720" y="61"/>
                  </a:lnTo>
                  <a:lnTo>
                    <a:pt x="758" y="82"/>
                  </a:lnTo>
                  <a:lnTo>
                    <a:pt x="794" y="107"/>
                  </a:lnTo>
                  <a:lnTo>
                    <a:pt x="829" y="135"/>
                  </a:lnTo>
                  <a:lnTo>
                    <a:pt x="860" y="165"/>
                  </a:lnTo>
                  <a:lnTo>
                    <a:pt x="888" y="199"/>
                  </a:lnTo>
                  <a:lnTo>
                    <a:pt x="914" y="234"/>
                  </a:lnTo>
                  <a:lnTo>
                    <a:pt x="936" y="273"/>
                  </a:lnTo>
                  <a:lnTo>
                    <a:pt x="956" y="312"/>
                  </a:lnTo>
                  <a:lnTo>
                    <a:pt x="971" y="353"/>
                  </a:lnTo>
                  <a:lnTo>
                    <a:pt x="982" y="396"/>
                  </a:lnTo>
                  <a:lnTo>
                    <a:pt x="990" y="439"/>
                  </a:lnTo>
                  <a:lnTo>
                    <a:pt x="993" y="483"/>
                  </a:lnTo>
                  <a:lnTo>
                    <a:pt x="993" y="527"/>
                  </a:lnTo>
                  <a:lnTo>
                    <a:pt x="989" y="571"/>
                  </a:lnTo>
                  <a:lnTo>
                    <a:pt x="981" y="614"/>
                  </a:lnTo>
                  <a:lnTo>
                    <a:pt x="969" y="657"/>
                  </a:lnTo>
                  <a:lnTo>
                    <a:pt x="954" y="698"/>
                  </a:lnTo>
                  <a:lnTo>
                    <a:pt x="934" y="737"/>
                  </a:lnTo>
                  <a:lnTo>
                    <a:pt x="911" y="775"/>
                  </a:lnTo>
                  <a:lnTo>
                    <a:pt x="886" y="810"/>
                  </a:lnTo>
                  <a:lnTo>
                    <a:pt x="857" y="844"/>
                  </a:lnTo>
                  <a:lnTo>
                    <a:pt x="825" y="874"/>
                  </a:lnTo>
                  <a:lnTo>
                    <a:pt x="791" y="901"/>
                  </a:lnTo>
                  <a:lnTo>
                    <a:pt x="754" y="925"/>
                  </a:lnTo>
                  <a:lnTo>
                    <a:pt x="715" y="946"/>
                  </a:lnTo>
                  <a:lnTo>
                    <a:pt x="674" y="963"/>
                  </a:lnTo>
                  <a:lnTo>
                    <a:pt x="633" y="977"/>
                  </a:lnTo>
                  <a:lnTo>
                    <a:pt x="590" y="987"/>
                  </a:lnTo>
                  <a:lnTo>
                    <a:pt x="546" y="993"/>
                  </a:lnTo>
                  <a:lnTo>
                    <a:pt x="502" y="995"/>
                  </a:lnTo>
                  <a:lnTo>
                    <a:pt x="458" y="993"/>
                  </a:lnTo>
                  <a:lnTo>
                    <a:pt x="415" y="987"/>
                  </a:lnTo>
                  <a:lnTo>
                    <a:pt x="372" y="977"/>
                  </a:lnTo>
                  <a:lnTo>
                    <a:pt x="330" y="964"/>
                  </a:lnTo>
                  <a:lnTo>
                    <a:pt x="290" y="947"/>
                  </a:lnTo>
                  <a:lnTo>
                    <a:pt x="251" y="925"/>
                  </a:lnTo>
                  <a:lnTo>
                    <a:pt x="214" y="901"/>
                  </a:lnTo>
                  <a:lnTo>
                    <a:pt x="179" y="874"/>
                  </a:lnTo>
                  <a:lnTo>
                    <a:pt x="148" y="844"/>
                  </a:lnTo>
                  <a:lnTo>
                    <a:pt x="119" y="811"/>
                  </a:lnTo>
                  <a:lnTo>
                    <a:pt x="93" y="776"/>
                  </a:lnTo>
                  <a:lnTo>
                    <a:pt x="70" y="738"/>
                  </a:lnTo>
                  <a:lnTo>
                    <a:pt x="51" y="698"/>
                  </a:lnTo>
                  <a:lnTo>
                    <a:pt x="35" y="657"/>
                  </a:lnTo>
                  <a:lnTo>
                    <a:pt x="23" y="615"/>
                  </a:lnTo>
                  <a:lnTo>
                    <a:pt x="15" y="571"/>
                  </a:lnTo>
                  <a:lnTo>
                    <a:pt x="11" y="528"/>
                  </a:lnTo>
                  <a:lnTo>
                    <a:pt x="10" y="484"/>
                  </a:lnTo>
                  <a:lnTo>
                    <a:pt x="14" y="440"/>
                  </a:lnTo>
                  <a:lnTo>
                    <a:pt x="22" y="396"/>
                  </a:lnTo>
                  <a:lnTo>
                    <a:pt x="33" y="354"/>
                  </a:lnTo>
                  <a:lnTo>
                    <a:pt x="48" y="313"/>
                  </a:lnTo>
                  <a:lnTo>
                    <a:pt x="67" y="273"/>
                  </a:lnTo>
                  <a:lnTo>
                    <a:pt x="89" y="235"/>
                  </a:lnTo>
                  <a:lnTo>
                    <a:pt x="115" y="199"/>
                  </a:lnTo>
                  <a:lnTo>
                    <a:pt x="144" y="166"/>
                  </a:lnTo>
                  <a:lnTo>
                    <a:pt x="175" y="135"/>
                  </a:lnTo>
                  <a:lnTo>
                    <a:pt x="209" y="107"/>
                  </a:lnTo>
                  <a:lnTo>
                    <a:pt x="245" y="83"/>
                  </a:lnTo>
                  <a:lnTo>
                    <a:pt x="284" y="61"/>
                  </a:lnTo>
                  <a:lnTo>
                    <a:pt x="324" y="44"/>
                  </a:lnTo>
                  <a:lnTo>
                    <a:pt x="366" y="30"/>
                  </a:lnTo>
                  <a:lnTo>
                    <a:pt x="409" y="20"/>
                  </a:lnTo>
                  <a:lnTo>
                    <a:pt x="452" y="13"/>
                  </a:lnTo>
                  <a:lnTo>
                    <a:pt x="496" y="11"/>
                  </a:lnTo>
                  <a:lnTo>
                    <a:pt x="506" y="11"/>
                  </a:lnTo>
                  <a:lnTo>
                    <a:pt x="506" y="0"/>
                  </a:lnTo>
                  <a:close/>
                </a:path>
              </a:pathLst>
            </a:cu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Oval 346"/>
            <p:cNvSpPr/>
            <p:nvPr/>
          </p:nvSpPr>
          <p:spPr>
            <a:xfrm>
              <a:off x="7207200" y="2782800"/>
              <a:ext cx="1590840" cy="1592280"/>
            </a:xfrm>
            <a:prstGeom prst="ellipse">
              <a:avLst/>
            </a:pr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Oval 347"/>
            <p:cNvSpPr/>
            <p:nvPr/>
          </p:nvSpPr>
          <p:spPr>
            <a:xfrm>
              <a:off x="7223040" y="2800440"/>
              <a:ext cx="1559160" cy="1558800"/>
            </a:xfrm>
            <a:prstGeom prst="ellipse">
              <a:avLst/>
            </a:pr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348"/>
            <p:cNvSpPr/>
            <p:nvPr/>
          </p:nvSpPr>
          <p:spPr>
            <a:xfrm flipV="1">
              <a:off x="8010360" y="2782440"/>
              <a:ext cx="1800" cy="176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349"/>
            <p:cNvSpPr/>
            <p:nvPr/>
          </p:nvSpPr>
          <p:spPr>
            <a:xfrm>
              <a:off x="7741440" y="3454560"/>
              <a:ext cx="488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800" spc="-1" strike="noStrike">
                  <a:solidFill>
                    <a:srgbClr val="000000"/>
                  </a:solidFill>
                  <a:latin typeface="Arial"/>
                </a:rPr>
                <a:t>pH-GBSS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ectangle 350"/>
            <p:cNvSpPr/>
            <p:nvPr/>
          </p:nvSpPr>
          <p:spPr>
            <a:xfrm>
              <a:off x="7821720" y="3587760"/>
              <a:ext cx="366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12445 b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Freeform 351"/>
            <p:cNvSpPr/>
            <p:nvPr/>
          </p:nvSpPr>
          <p:spPr>
            <a:xfrm>
              <a:off x="7202520" y="3100320"/>
              <a:ext cx="189000" cy="276120"/>
            </a:xfrm>
            <a:custGeom>
              <a:avLst/>
              <a:gdLst>
                <a:gd name="textAreaLeft" fmla="*/ 0 w 189000"/>
                <a:gd name="textAreaRight" fmla="*/ 189360 w 189000"/>
                <a:gd name="textAreaTop" fmla="*/ 0 h 276120"/>
                <a:gd name="textAreaBottom" fmla="*/ 276480 h 276120"/>
              </a:gdLst>
              <a:ahLst/>
              <a:rect l="textAreaLeft" t="textAreaTop" r="textAreaRight" b="textAreaBottom"/>
              <a:pathLst>
                <a:path w="119" h="174">
                  <a:moveTo>
                    <a:pt x="85" y="0"/>
                  </a:moveTo>
                  <a:lnTo>
                    <a:pt x="60" y="38"/>
                  </a:lnTo>
                  <a:lnTo>
                    <a:pt x="38" y="79"/>
                  </a:lnTo>
                  <a:lnTo>
                    <a:pt x="20" y="122"/>
                  </a:lnTo>
                  <a:lnTo>
                    <a:pt x="15" y="136"/>
                  </a:lnTo>
                  <a:lnTo>
                    <a:pt x="0" y="131"/>
                  </a:lnTo>
                  <a:lnTo>
                    <a:pt x="25" y="174"/>
                  </a:lnTo>
                  <a:lnTo>
                    <a:pt x="69" y="154"/>
                  </a:lnTo>
                  <a:lnTo>
                    <a:pt x="54" y="149"/>
                  </a:lnTo>
                  <a:lnTo>
                    <a:pt x="69" y="109"/>
                  </a:lnTo>
                  <a:lnTo>
                    <a:pt x="88" y="71"/>
                  </a:lnTo>
                  <a:lnTo>
                    <a:pt x="110" y="35"/>
                  </a:lnTo>
                  <a:lnTo>
                    <a:pt x="119" y="24"/>
                  </a:lnTo>
                  <a:lnTo>
                    <a:pt x="85" y="0"/>
                  </a:lnTo>
                  <a:close/>
                </a:path>
              </a:pathLst>
            </a:custGeom>
            <a:solidFill>
              <a:srgbClr val="33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Arc 352"/>
            <p:cNvSpPr/>
            <p:nvPr/>
          </p:nvSpPr>
          <p:spPr>
            <a:xfrm>
              <a:off x="7226280" y="3100320"/>
              <a:ext cx="776160" cy="479520"/>
            </a:xfrm>
            <a:custGeom>
              <a:avLst/>
              <a:gdLst>
                <a:gd name="textAreaLeft" fmla="*/ 0 w 776160"/>
                <a:gd name="textAreaRight" fmla="*/ 776520 w 776160"/>
                <a:gd name="textAreaTop" fmla="*/ 0 h 479520"/>
                <a:gd name="textAreaBottom" fmla="*/ 479880 h 479520"/>
              </a:gdLst>
              <a:ahLst/>
              <a:rect l="textAreaLeft" t="textAreaTop" r="textAreaRight" b="textAreaBottom"/>
              <a:pathLst>
                <a:path fill="none" w="20454" h="12630">
                  <a:moveTo>
                    <a:pt x="0" y="5687"/>
                  </a:moveTo>
                  <a:cubicBezTo>
                    <a:pt x="689" y="3656"/>
                    <a:pt x="1677" y="1739"/>
                    <a:pt x="2931" y="0"/>
                  </a:cubicBezTo>
                </a:path>
                <a:path stroke="0" w="20454" h="12630">
                  <a:moveTo>
                    <a:pt x="0" y="5687"/>
                  </a:moveTo>
                  <a:cubicBezTo>
                    <a:pt x="689" y="3656"/>
                    <a:pt x="1677" y="1739"/>
                    <a:pt x="2931" y="0"/>
                  </a:cubicBezTo>
                  <a:lnTo>
                    <a:pt x="20454" y="12630"/>
                  </a:lnTo>
                  <a:lnTo>
                    <a:pt x="0" y="5687"/>
                  </a:lnTo>
                  <a:close/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Arc 353"/>
            <p:cNvSpPr/>
            <p:nvPr/>
          </p:nvSpPr>
          <p:spPr>
            <a:xfrm>
              <a:off x="7289640" y="3138480"/>
              <a:ext cx="714600" cy="441360"/>
            </a:xfrm>
            <a:custGeom>
              <a:avLst/>
              <a:gdLst>
                <a:gd name="textAreaLeft" fmla="*/ 0 w 714600"/>
                <a:gd name="textAreaRight" fmla="*/ 714960 w 714600"/>
                <a:gd name="textAreaTop" fmla="*/ 0 h 441360"/>
                <a:gd name="textAreaBottom" fmla="*/ 441720 h 441360"/>
              </a:gdLst>
              <a:ahLst/>
              <a:rect l="textAreaLeft" t="textAreaTop" r="textAreaRight" b="textAreaBottom"/>
              <a:pathLst>
                <a:path fill="none" w="20455" h="12623">
                  <a:moveTo>
                    <a:pt x="-1" y="5683"/>
                  </a:moveTo>
                  <a:cubicBezTo>
                    <a:pt x="688" y="3654"/>
                    <a:pt x="1675" y="1738"/>
                    <a:pt x="2927" y="-1"/>
                  </a:cubicBezTo>
                </a:path>
                <a:path stroke="0" w="20455" h="12623">
                  <a:moveTo>
                    <a:pt x="-1" y="5683"/>
                  </a:moveTo>
                  <a:cubicBezTo>
                    <a:pt x="688" y="3654"/>
                    <a:pt x="1675" y="1738"/>
                    <a:pt x="2927" y="-1"/>
                  </a:cubicBezTo>
                  <a:lnTo>
                    <a:pt x="20455" y="12623"/>
                  </a:lnTo>
                  <a:lnTo>
                    <a:pt x="-1" y="5683"/>
                  </a:lnTo>
                  <a:close/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354"/>
            <p:cNvSpPr/>
            <p:nvPr/>
          </p:nvSpPr>
          <p:spPr>
            <a:xfrm flipH="1" flipV="1">
              <a:off x="7337520" y="3100320"/>
              <a:ext cx="54000" cy="381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Freeform 355"/>
            <p:cNvSpPr/>
            <p:nvPr/>
          </p:nvSpPr>
          <p:spPr>
            <a:xfrm>
              <a:off x="7202520" y="3308400"/>
              <a:ext cx="109440" cy="68040"/>
            </a:xfrm>
            <a:custGeom>
              <a:avLst/>
              <a:gdLst>
                <a:gd name="textAreaLeft" fmla="*/ 0 w 109440"/>
                <a:gd name="textAreaRight" fmla="*/ 109800 w 10944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142" h="88">
                  <a:moveTo>
                    <a:pt x="111" y="37"/>
                  </a:moveTo>
                  <a:lnTo>
                    <a:pt x="142" y="48"/>
                  </a:lnTo>
                  <a:lnTo>
                    <a:pt x="52" y="88"/>
                  </a:lnTo>
                  <a:lnTo>
                    <a:pt x="0" y="0"/>
                  </a:lnTo>
                  <a:lnTo>
                    <a:pt x="32" y="11"/>
                  </a:lnTo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356"/>
            <p:cNvSpPr/>
            <p:nvPr/>
          </p:nvSpPr>
          <p:spPr>
            <a:xfrm>
              <a:off x="7124760" y="3214800"/>
              <a:ext cx="137880" cy="12600"/>
            </a:xfrm>
            <a:prstGeom prst="line">
              <a:avLst/>
            </a:prstGeom>
            <a:ln w="1440">
              <a:solidFill>
                <a:srgbClr val="ff00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357"/>
            <p:cNvSpPr/>
            <p:nvPr/>
          </p:nvSpPr>
          <p:spPr>
            <a:xfrm>
              <a:off x="6969600" y="3125880"/>
              <a:ext cx="195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Egf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358"/>
            <p:cNvSpPr/>
            <p:nvPr/>
          </p:nvSpPr>
          <p:spPr>
            <a:xfrm>
              <a:off x="8001000" y="2730600"/>
              <a:ext cx="1440" cy="122040"/>
            </a:xfrm>
            <a:prstGeom prst="line">
              <a:avLst/>
            </a:prstGeom>
            <a:ln w="1584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359"/>
            <p:cNvSpPr/>
            <p:nvPr/>
          </p:nvSpPr>
          <p:spPr>
            <a:xfrm>
              <a:off x="7929720" y="2664000"/>
              <a:ext cx="71280" cy="66600"/>
            </a:xfrm>
            <a:prstGeom prst="line">
              <a:avLst/>
            </a:prstGeom>
            <a:ln w="1440">
              <a:solidFill>
                <a:srgbClr val="ff00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Rectangle 360"/>
            <p:cNvSpPr/>
            <p:nvPr/>
          </p:nvSpPr>
          <p:spPr>
            <a:xfrm>
              <a:off x="7753680" y="2575080"/>
              <a:ext cx="22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att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361"/>
            <p:cNvSpPr/>
            <p:nvPr/>
          </p:nvSpPr>
          <p:spPr>
            <a:xfrm>
              <a:off x="7316640" y="3079800"/>
              <a:ext cx="98640" cy="73080"/>
            </a:xfrm>
            <a:prstGeom prst="line">
              <a:avLst/>
            </a:prstGeom>
            <a:ln w="1584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362"/>
            <p:cNvSpPr/>
            <p:nvPr/>
          </p:nvSpPr>
          <p:spPr>
            <a:xfrm>
              <a:off x="7197840" y="3076560"/>
              <a:ext cx="118800" cy="3240"/>
            </a:xfrm>
            <a:prstGeom prst="line">
              <a:avLst/>
            </a:prstGeom>
            <a:ln w="1440">
              <a:solidFill>
                <a:srgbClr val="ff00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363"/>
            <p:cNvSpPr/>
            <p:nvPr/>
          </p:nvSpPr>
          <p:spPr>
            <a:xfrm>
              <a:off x="7023240" y="2987640"/>
              <a:ext cx="22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attB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Freeform 364"/>
            <p:cNvSpPr/>
            <p:nvPr/>
          </p:nvSpPr>
          <p:spPr>
            <a:xfrm>
              <a:off x="7354800" y="2752560"/>
              <a:ext cx="644760" cy="351000"/>
            </a:xfrm>
            <a:custGeom>
              <a:avLst/>
              <a:gdLst>
                <a:gd name="textAreaLeft" fmla="*/ 0 w 644760"/>
                <a:gd name="textAreaRight" fmla="*/ 645120 w 644760"/>
                <a:gd name="textAreaTop" fmla="*/ 0 h 351000"/>
                <a:gd name="textAreaBottom" fmla="*/ 351360 h 351000"/>
              </a:gdLst>
              <a:ahLst/>
              <a:rect l="textAreaLeft" t="textAreaTop" r="textAreaRight" b="textAreaBottom"/>
              <a:pathLst>
                <a:path w="406" h="221">
                  <a:moveTo>
                    <a:pt x="406" y="0"/>
                  </a:moveTo>
                  <a:lnTo>
                    <a:pt x="359" y="2"/>
                  </a:lnTo>
                  <a:lnTo>
                    <a:pt x="313" y="8"/>
                  </a:lnTo>
                  <a:lnTo>
                    <a:pt x="268" y="19"/>
                  </a:lnTo>
                  <a:lnTo>
                    <a:pt x="223" y="33"/>
                  </a:lnTo>
                  <a:lnTo>
                    <a:pt x="181" y="52"/>
                  </a:lnTo>
                  <a:lnTo>
                    <a:pt x="140" y="74"/>
                  </a:lnTo>
                  <a:lnTo>
                    <a:pt x="102" y="100"/>
                  </a:lnTo>
                  <a:lnTo>
                    <a:pt x="65" y="129"/>
                  </a:lnTo>
                  <a:lnTo>
                    <a:pt x="32" y="161"/>
                  </a:lnTo>
                  <a:lnTo>
                    <a:pt x="12" y="183"/>
                  </a:lnTo>
                  <a:lnTo>
                    <a:pt x="0" y="172"/>
                  </a:lnTo>
                  <a:lnTo>
                    <a:pt x="8" y="221"/>
                  </a:lnTo>
                  <a:lnTo>
                    <a:pt x="56" y="220"/>
                  </a:lnTo>
                  <a:lnTo>
                    <a:pt x="43" y="209"/>
                  </a:lnTo>
                  <a:lnTo>
                    <a:pt x="72" y="178"/>
                  </a:lnTo>
                  <a:lnTo>
                    <a:pt x="104" y="149"/>
                  </a:lnTo>
                  <a:lnTo>
                    <a:pt x="139" y="123"/>
                  </a:lnTo>
                  <a:lnTo>
                    <a:pt x="175" y="101"/>
                  </a:lnTo>
                  <a:lnTo>
                    <a:pt x="213" y="82"/>
                  </a:lnTo>
                  <a:lnTo>
                    <a:pt x="253" y="66"/>
                  </a:lnTo>
                  <a:lnTo>
                    <a:pt x="294" y="54"/>
                  </a:lnTo>
                  <a:lnTo>
                    <a:pt x="337" y="46"/>
                  </a:lnTo>
                  <a:lnTo>
                    <a:pt x="379" y="41"/>
                  </a:lnTo>
                  <a:lnTo>
                    <a:pt x="406" y="41"/>
                  </a:lnTo>
                  <a:lnTo>
                    <a:pt x="406" y="0"/>
                  </a:lnTo>
                  <a:close/>
                </a:path>
              </a:pathLst>
            </a:custGeom>
            <a:solidFill>
              <a:srgbClr val="00b0f0"/>
            </a:solidFill>
            <a:ln w="9360">
              <a:solidFill>
                <a:srgbClr val="00b0f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Arc 365"/>
            <p:cNvSpPr/>
            <p:nvPr/>
          </p:nvSpPr>
          <p:spPr>
            <a:xfrm>
              <a:off x="7373880" y="2752560"/>
              <a:ext cx="628560" cy="827280"/>
            </a:xfrm>
            <a:custGeom>
              <a:avLst/>
              <a:gdLst>
                <a:gd name="textAreaLeft" fmla="*/ 0 w 628560"/>
                <a:gd name="textAreaRight" fmla="*/ 628920 w 628560"/>
                <a:gd name="textAreaTop" fmla="*/ 0 h 827280"/>
                <a:gd name="textAreaBottom" fmla="*/ 827640 h 827280"/>
              </a:gdLst>
              <a:ahLst/>
              <a:rect l="textAreaLeft" t="textAreaTop" r="textAreaRight" b="textAreaBottom"/>
              <a:pathLst>
                <a:path fill="none" w="16423" h="21600">
                  <a:moveTo>
                    <a:pt x="0" y="7569"/>
                  </a:moveTo>
                  <a:cubicBezTo>
                    <a:pt x="4085" y="2787"/>
                    <a:pt x="10051" y="24"/>
                    <a:pt x="16340" y="0"/>
                  </a:cubicBezTo>
                </a:path>
                <a:path stroke="0" w="16423" h="21600">
                  <a:moveTo>
                    <a:pt x="0" y="7569"/>
                  </a:moveTo>
                  <a:cubicBezTo>
                    <a:pt x="4085" y="2787"/>
                    <a:pt x="10051" y="24"/>
                    <a:pt x="16340" y="0"/>
                  </a:cubicBezTo>
                  <a:lnTo>
                    <a:pt x="16423" y="21600"/>
                  </a:lnTo>
                  <a:lnTo>
                    <a:pt x="0" y="7569"/>
                  </a:lnTo>
                  <a:close/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Arc 366"/>
            <p:cNvSpPr/>
            <p:nvPr/>
          </p:nvSpPr>
          <p:spPr>
            <a:xfrm>
              <a:off x="7423200" y="2817720"/>
              <a:ext cx="579240" cy="762120"/>
            </a:xfrm>
            <a:custGeom>
              <a:avLst/>
              <a:gdLst>
                <a:gd name="textAreaLeft" fmla="*/ 0 w 579240"/>
                <a:gd name="textAreaRight" fmla="*/ 579600 w 579240"/>
                <a:gd name="textAreaTop" fmla="*/ 0 h 762120"/>
                <a:gd name="textAreaBottom" fmla="*/ 762480 h 762120"/>
              </a:gdLst>
              <a:ahLst/>
              <a:rect l="textAreaLeft" t="textAreaTop" r="textAreaRight" b="textAreaBottom"/>
              <a:pathLst>
                <a:path fill="none" w="16419" h="21600">
                  <a:moveTo>
                    <a:pt x="0" y="7565"/>
                  </a:moveTo>
                  <a:cubicBezTo>
                    <a:pt x="4083" y="2788"/>
                    <a:pt x="10044" y="26"/>
                    <a:pt x="16329" y="0"/>
                  </a:cubicBezTo>
                </a:path>
                <a:path stroke="0" w="16419" h="21600">
                  <a:moveTo>
                    <a:pt x="0" y="7565"/>
                  </a:moveTo>
                  <a:cubicBezTo>
                    <a:pt x="4083" y="2788"/>
                    <a:pt x="10044" y="26"/>
                    <a:pt x="16329" y="0"/>
                  </a:cubicBezTo>
                  <a:lnTo>
                    <a:pt x="16419" y="21600"/>
                  </a:lnTo>
                  <a:lnTo>
                    <a:pt x="0" y="7565"/>
                  </a:lnTo>
                  <a:close/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Line 367"/>
            <p:cNvSpPr/>
            <p:nvPr/>
          </p:nvSpPr>
          <p:spPr>
            <a:xfrm flipV="1">
              <a:off x="7999560" y="2752200"/>
              <a:ext cx="1440" cy="651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Freeform 368"/>
            <p:cNvSpPr/>
            <p:nvPr/>
          </p:nvSpPr>
          <p:spPr>
            <a:xfrm>
              <a:off x="7354800" y="3025800"/>
              <a:ext cx="88920" cy="77760"/>
            </a:xfrm>
            <a:custGeom>
              <a:avLst/>
              <a:gdLst>
                <a:gd name="textAreaLeft" fmla="*/ 0 w 88920"/>
                <a:gd name="textAreaRight" fmla="*/ 89280 w 8892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114" h="101">
                  <a:moveTo>
                    <a:pt x="89" y="76"/>
                  </a:moveTo>
                  <a:lnTo>
                    <a:pt x="114" y="98"/>
                  </a:lnTo>
                  <a:lnTo>
                    <a:pt x="16" y="101"/>
                  </a:lnTo>
                  <a:lnTo>
                    <a:pt x="0" y="0"/>
                  </a:lnTo>
                  <a:lnTo>
                    <a:pt x="26" y="22"/>
                  </a:lnTo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369"/>
            <p:cNvSpPr/>
            <p:nvPr/>
          </p:nvSpPr>
          <p:spPr>
            <a:xfrm>
              <a:off x="7480440" y="2800440"/>
              <a:ext cx="150840" cy="41040"/>
            </a:xfrm>
            <a:prstGeom prst="line">
              <a:avLst/>
            </a:prstGeom>
            <a:ln w="1440">
              <a:solidFill>
                <a:srgbClr val="ff00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Rectangle 370"/>
            <p:cNvSpPr/>
            <p:nvPr/>
          </p:nvSpPr>
          <p:spPr>
            <a:xfrm>
              <a:off x="7257240" y="2711520"/>
              <a:ext cx="276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GBSS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Freeform 371"/>
            <p:cNvSpPr/>
            <p:nvPr/>
          </p:nvSpPr>
          <p:spPr>
            <a:xfrm>
              <a:off x="7182000" y="3481560"/>
              <a:ext cx="269640" cy="653760"/>
            </a:xfrm>
            <a:custGeom>
              <a:avLst/>
              <a:gdLst>
                <a:gd name="textAreaLeft" fmla="*/ 0 w 269640"/>
                <a:gd name="textAreaRight" fmla="*/ 270000 w 269640"/>
                <a:gd name="textAreaTop" fmla="*/ 0 h 653760"/>
                <a:gd name="textAreaBottom" fmla="*/ 653760 h 653760"/>
              </a:gdLst>
              <a:ahLst/>
              <a:rect l="textAreaLeft" t="textAreaTop" r="textAreaRight" b="textAreaBottom"/>
              <a:pathLst>
                <a:path w="170" h="412">
                  <a:moveTo>
                    <a:pt x="4" y="0"/>
                  </a:moveTo>
                  <a:lnTo>
                    <a:pt x="0" y="46"/>
                  </a:lnTo>
                  <a:lnTo>
                    <a:pt x="1" y="93"/>
                  </a:lnTo>
                  <a:lnTo>
                    <a:pt x="6" y="139"/>
                  </a:lnTo>
                  <a:lnTo>
                    <a:pt x="15" y="184"/>
                  </a:lnTo>
                  <a:lnTo>
                    <a:pt x="28" y="229"/>
                  </a:lnTo>
                  <a:lnTo>
                    <a:pt x="45" y="272"/>
                  </a:lnTo>
                  <a:lnTo>
                    <a:pt x="65" y="313"/>
                  </a:lnTo>
                  <a:lnTo>
                    <a:pt x="89" y="353"/>
                  </a:lnTo>
                  <a:lnTo>
                    <a:pt x="117" y="390"/>
                  </a:lnTo>
                  <a:lnTo>
                    <a:pt x="127" y="402"/>
                  </a:lnTo>
                  <a:lnTo>
                    <a:pt x="115" y="412"/>
                  </a:lnTo>
                  <a:lnTo>
                    <a:pt x="165" y="412"/>
                  </a:lnTo>
                  <a:lnTo>
                    <a:pt x="170" y="364"/>
                  </a:lnTo>
                  <a:lnTo>
                    <a:pt x="158" y="375"/>
                  </a:lnTo>
                  <a:lnTo>
                    <a:pt x="131" y="341"/>
                  </a:lnTo>
                  <a:lnTo>
                    <a:pt x="108" y="306"/>
                  </a:lnTo>
                  <a:lnTo>
                    <a:pt x="88" y="268"/>
                  </a:lnTo>
                  <a:lnTo>
                    <a:pt x="71" y="229"/>
                  </a:lnTo>
                  <a:lnTo>
                    <a:pt x="58" y="188"/>
                  </a:lnTo>
                  <a:lnTo>
                    <a:pt x="49" y="147"/>
                  </a:lnTo>
                  <a:lnTo>
                    <a:pt x="43" y="104"/>
                  </a:lnTo>
                  <a:lnTo>
                    <a:pt x="41" y="62"/>
                  </a:lnTo>
                  <a:lnTo>
                    <a:pt x="43" y="19"/>
                  </a:lnTo>
                  <a:lnTo>
                    <a:pt x="45" y="5"/>
                  </a:lnTo>
                  <a:lnTo>
                    <a:pt x="4" y="0"/>
                  </a:lnTo>
                  <a:close/>
                </a:path>
              </a:pathLst>
            </a:custGeom>
            <a:solidFill>
              <a:srgbClr val="ffcc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Arc 372"/>
            <p:cNvSpPr/>
            <p:nvPr/>
          </p:nvSpPr>
          <p:spPr>
            <a:xfrm>
              <a:off x="7182000" y="3481560"/>
              <a:ext cx="820440" cy="636480"/>
            </a:xfrm>
            <a:custGeom>
              <a:avLst/>
              <a:gdLst>
                <a:gd name="textAreaLeft" fmla="*/ 0 w 820440"/>
                <a:gd name="textAreaRight" fmla="*/ 820800 w 820440"/>
                <a:gd name="textAreaTop" fmla="*/ 0 h 636480"/>
                <a:gd name="textAreaBottom" fmla="*/ 636840 h 636480"/>
              </a:gdLst>
              <a:ahLst/>
              <a:rect l="textAreaLeft" t="textAreaTop" r="textAreaRight" b="textAreaBottom"/>
              <a:pathLst>
                <a:path fill="none" w="21600" h="16786">
                  <a:moveTo>
                    <a:pt x="5318" y="16786"/>
                  </a:moveTo>
                  <a:cubicBezTo>
                    <a:pt x="1889" y="12852"/>
                    <a:pt x="0" y="7810"/>
                    <a:pt x="0" y="2592"/>
                  </a:cubicBezTo>
                  <a:cubicBezTo>
                    <a:pt x="-1" y="1725"/>
                    <a:pt x="52" y="860"/>
                    <a:pt x="156" y="0"/>
                  </a:cubicBezTo>
                </a:path>
                <a:path stroke="0" w="21600" h="16786">
                  <a:moveTo>
                    <a:pt x="5318" y="16786"/>
                  </a:moveTo>
                  <a:cubicBezTo>
                    <a:pt x="1889" y="12852"/>
                    <a:pt x="0" y="7810"/>
                    <a:pt x="0" y="2592"/>
                  </a:cubicBezTo>
                  <a:cubicBezTo>
                    <a:pt x="-1" y="1725"/>
                    <a:pt x="52" y="860"/>
                    <a:pt x="156" y="0"/>
                  </a:cubicBezTo>
                  <a:lnTo>
                    <a:pt x="21600" y="2592"/>
                  </a:lnTo>
                  <a:lnTo>
                    <a:pt x="5318" y="16786"/>
                  </a:lnTo>
                  <a:close/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Arc 373"/>
            <p:cNvSpPr/>
            <p:nvPr/>
          </p:nvSpPr>
          <p:spPr>
            <a:xfrm>
              <a:off x="7248600" y="3489480"/>
              <a:ext cx="755640" cy="585720"/>
            </a:xfrm>
            <a:custGeom>
              <a:avLst/>
              <a:gdLst>
                <a:gd name="textAreaLeft" fmla="*/ 0 w 755640"/>
                <a:gd name="textAreaRight" fmla="*/ 756000 w 755640"/>
                <a:gd name="textAreaTop" fmla="*/ 0 h 585720"/>
                <a:gd name="textAreaBottom" fmla="*/ 586080 h 585720"/>
              </a:gdLst>
              <a:ahLst/>
              <a:rect l="textAreaLeft" t="textAreaTop" r="textAreaRight" b="textAreaBottom"/>
              <a:pathLst>
                <a:path fill="none" w="21600" h="16756">
                  <a:moveTo>
                    <a:pt x="5299" y="16756"/>
                  </a:moveTo>
                  <a:cubicBezTo>
                    <a:pt x="1882" y="12825"/>
                    <a:pt x="0" y="7792"/>
                    <a:pt x="0" y="2584"/>
                  </a:cubicBezTo>
                  <a:cubicBezTo>
                    <a:pt x="-1" y="1720"/>
                    <a:pt x="51" y="857"/>
                    <a:pt x="155" y="0"/>
                  </a:cubicBezTo>
                </a:path>
                <a:path stroke="0" w="21600" h="16756">
                  <a:moveTo>
                    <a:pt x="5299" y="16756"/>
                  </a:moveTo>
                  <a:cubicBezTo>
                    <a:pt x="1882" y="12825"/>
                    <a:pt x="0" y="7792"/>
                    <a:pt x="0" y="2584"/>
                  </a:cubicBezTo>
                  <a:cubicBezTo>
                    <a:pt x="-1" y="1720"/>
                    <a:pt x="51" y="857"/>
                    <a:pt x="155" y="0"/>
                  </a:cubicBezTo>
                  <a:lnTo>
                    <a:pt x="21600" y="2584"/>
                  </a:lnTo>
                  <a:lnTo>
                    <a:pt x="5299" y="16756"/>
                  </a:lnTo>
                  <a:close/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374"/>
            <p:cNvSpPr/>
            <p:nvPr/>
          </p:nvSpPr>
          <p:spPr>
            <a:xfrm flipH="1" flipV="1">
              <a:off x="7187760" y="3481560"/>
              <a:ext cx="65160" cy="7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Freeform 375"/>
            <p:cNvSpPr/>
            <p:nvPr/>
          </p:nvSpPr>
          <p:spPr>
            <a:xfrm>
              <a:off x="7364520" y="4059360"/>
              <a:ext cx="87120" cy="7596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114" h="98">
                  <a:moveTo>
                    <a:pt x="88" y="22"/>
                  </a:moveTo>
                  <a:lnTo>
                    <a:pt x="114" y="0"/>
                  </a:lnTo>
                  <a:lnTo>
                    <a:pt x="102" y="98"/>
                  </a:lnTo>
                  <a:lnTo>
                    <a:pt x="0" y="98"/>
                  </a:lnTo>
                  <a:lnTo>
                    <a:pt x="25" y="77"/>
                  </a:lnTo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Line 376"/>
            <p:cNvSpPr/>
            <p:nvPr/>
          </p:nvSpPr>
          <p:spPr>
            <a:xfrm>
              <a:off x="7086600" y="3809880"/>
              <a:ext cx="139680" cy="36720"/>
            </a:xfrm>
            <a:prstGeom prst="line">
              <a:avLst/>
            </a:prstGeom>
            <a:ln w="1440">
              <a:solidFill>
                <a:srgbClr val="ff00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377"/>
            <p:cNvSpPr/>
            <p:nvPr/>
          </p:nvSpPr>
          <p:spPr>
            <a:xfrm>
              <a:off x="6955560" y="3811680"/>
              <a:ext cx="16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Hyg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Freeform 378"/>
            <p:cNvSpPr/>
            <p:nvPr/>
          </p:nvSpPr>
          <p:spPr>
            <a:xfrm>
              <a:off x="8028000" y="2724120"/>
              <a:ext cx="411120" cy="200160"/>
            </a:xfrm>
            <a:custGeom>
              <a:avLst/>
              <a:gdLst>
                <a:gd name="textAreaLeft" fmla="*/ 0 w 411120"/>
                <a:gd name="textAreaRight" fmla="*/ 411480 w 411120"/>
                <a:gd name="textAreaTop" fmla="*/ 0 h 200160"/>
                <a:gd name="textAreaBottom" fmla="*/ 200520 h 200160"/>
              </a:gdLst>
              <a:ahLst/>
              <a:rect l="textAreaLeft" t="textAreaTop" r="textAreaRight" b="textAreaBottom"/>
              <a:pathLst>
                <a:path w="259" h="126">
                  <a:moveTo>
                    <a:pt x="259" y="92"/>
                  </a:moveTo>
                  <a:lnTo>
                    <a:pt x="218" y="69"/>
                  </a:lnTo>
                  <a:lnTo>
                    <a:pt x="176" y="50"/>
                  </a:lnTo>
                  <a:lnTo>
                    <a:pt x="132" y="35"/>
                  </a:lnTo>
                  <a:lnTo>
                    <a:pt x="86" y="24"/>
                  </a:lnTo>
                  <a:lnTo>
                    <a:pt x="40" y="17"/>
                  </a:lnTo>
                  <a:lnTo>
                    <a:pt x="35" y="17"/>
                  </a:lnTo>
                  <a:lnTo>
                    <a:pt x="37" y="0"/>
                  </a:lnTo>
                  <a:lnTo>
                    <a:pt x="0" y="35"/>
                  </a:lnTo>
                  <a:lnTo>
                    <a:pt x="30" y="74"/>
                  </a:lnTo>
                  <a:lnTo>
                    <a:pt x="31" y="58"/>
                  </a:lnTo>
                  <a:lnTo>
                    <a:pt x="74" y="63"/>
                  </a:lnTo>
                  <a:lnTo>
                    <a:pt x="115" y="73"/>
                  </a:lnTo>
                  <a:lnTo>
                    <a:pt x="156" y="87"/>
                  </a:lnTo>
                  <a:lnTo>
                    <a:pt x="196" y="103"/>
                  </a:lnTo>
                  <a:lnTo>
                    <a:pt x="234" y="124"/>
                  </a:lnTo>
                  <a:lnTo>
                    <a:pt x="238" y="126"/>
                  </a:lnTo>
                  <a:lnTo>
                    <a:pt x="259" y="92"/>
                  </a:lnTo>
                  <a:close/>
                </a:path>
              </a:pathLst>
            </a:custGeom>
            <a:solidFill>
              <a:srgbClr val="ff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Arc 379"/>
            <p:cNvSpPr/>
            <p:nvPr/>
          </p:nvSpPr>
          <p:spPr>
            <a:xfrm>
              <a:off x="8002440" y="2751120"/>
              <a:ext cx="436680" cy="828720"/>
            </a:xfrm>
            <a:custGeom>
              <a:avLst/>
              <a:gdLst>
                <a:gd name="textAreaLeft" fmla="*/ 0 w 436680"/>
                <a:gd name="textAreaRight" fmla="*/ 437040 w 436680"/>
                <a:gd name="textAreaTop" fmla="*/ 0 h 828720"/>
                <a:gd name="textAreaBottom" fmla="*/ 829080 h 828720"/>
              </a:gdLst>
              <a:ahLst/>
              <a:rect l="textAreaLeft" t="textAreaTop" r="textAreaRight" b="textAreaBottom"/>
              <a:pathLst>
                <a:path fill="none" w="11318" h="21498">
                  <a:moveTo>
                    <a:pt x="2099" y="0"/>
                  </a:moveTo>
                  <a:cubicBezTo>
                    <a:pt x="5368" y="319"/>
                    <a:pt x="8521" y="1379"/>
                    <a:pt x="11318" y="3100"/>
                  </a:cubicBezTo>
                </a:path>
                <a:path stroke="0" w="11318" h="21498">
                  <a:moveTo>
                    <a:pt x="2099" y="0"/>
                  </a:moveTo>
                  <a:cubicBezTo>
                    <a:pt x="5368" y="319"/>
                    <a:pt x="8521" y="1379"/>
                    <a:pt x="11318" y="3100"/>
                  </a:cubicBezTo>
                  <a:lnTo>
                    <a:pt x="0" y="21498"/>
                  </a:lnTo>
                  <a:lnTo>
                    <a:pt x="2099" y="0"/>
                  </a:lnTo>
                  <a:close/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Arc 380"/>
            <p:cNvSpPr/>
            <p:nvPr/>
          </p:nvSpPr>
          <p:spPr>
            <a:xfrm>
              <a:off x="8002440" y="2816280"/>
              <a:ext cx="401760" cy="763560"/>
            </a:xfrm>
            <a:custGeom>
              <a:avLst/>
              <a:gdLst>
                <a:gd name="textAreaLeft" fmla="*/ 0 w 401760"/>
                <a:gd name="textAreaRight" fmla="*/ 402120 w 401760"/>
                <a:gd name="textAreaTop" fmla="*/ 0 h 763560"/>
                <a:gd name="textAreaBottom" fmla="*/ 763920 h 763560"/>
              </a:gdLst>
              <a:ahLst/>
              <a:rect l="textAreaLeft" t="textAreaTop" r="textAreaRight" b="textAreaBottom"/>
              <a:pathLst>
                <a:path fill="none" w="11324" h="21497">
                  <a:moveTo>
                    <a:pt x="2103" y="-1"/>
                  </a:moveTo>
                  <a:cubicBezTo>
                    <a:pt x="5372" y="319"/>
                    <a:pt x="8526" y="1380"/>
                    <a:pt x="11323" y="3103"/>
                  </a:cubicBezTo>
                </a:path>
                <a:path stroke="0" w="11324" h="21497">
                  <a:moveTo>
                    <a:pt x="2103" y="-1"/>
                  </a:moveTo>
                  <a:cubicBezTo>
                    <a:pt x="5372" y="319"/>
                    <a:pt x="8526" y="1380"/>
                    <a:pt x="11323" y="3103"/>
                  </a:cubicBezTo>
                  <a:lnTo>
                    <a:pt x="0" y="21497"/>
                  </a:lnTo>
                  <a:lnTo>
                    <a:pt x="2103" y="-1"/>
                  </a:lnTo>
                  <a:close/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Line 381"/>
            <p:cNvSpPr/>
            <p:nvPr/>
          </p:nvSpPr>
          <p:spPr>
            <a:xfrm flipV="1">
              <a:off x="8405640" y="2870280"/>
              <a:ext cx="33480" cy="540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Freeform 382"/>
            <p:cNvSpPr/>
            <p:nvPr/>
          </p:nvSpPr>
          <p:spPr>
            <a:xfrm>
              <a:off x="8028000" y="2724120"/>
              <a:ext cx="58680" cy="11736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117360"/>
                <a:gd name="textAreaBottom" fmla="*/ 117720 h 117360"/>
              </a:gdLst>
              <a:ahLst/>
              <a:rect l="textAreaLeft" t="textAreaTop" r="textAreaRight" b="textAreaBottom"/>
              <a:pathLst>
                <a:path w="74" h="150">
                  <a:moveTo>
                    <a:pt x="63" y="117"/>
                  </a:moveTo>
                  <a:lnTo>
                    <a:pt x="60" y="150"/>
                  </a:lnTo>
                  <a:lnTo>
                    <a:pt x="0" y="71"/>
                  </a:lnTo>
                  <a:lnTo>
                    <a:pt x="74" y="0"/>
                  </a:lnTo>
                  <a:lnTo>
                    <a:pt x="71" y="33"/>
                  </a:lnTo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Line 383"/>
            <p:cNvSpPr/>
            <p:nvPr/>
          </p:nvSpPr>
          <p:spPr>
            <a:xfrm flipH="1">
              <a:off x="8241840" y="2664000"/>
              <a:ext cx="104760" cy="117360"/>
            </a:xfrm>
            <a:prstGeom prst="line">
              <a:avLst/>
            </a:prstGeom>
            <a:ln w="1440">
              <a:solidFill>
                <a:srgbClr val="ff00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384"/>
            <p:cNvSpPr/>
            <p:nvPr/>
          </p:nvSpPr>
          <p:spPr>
            <a:xfrm>
              <a:off x="8348040" y="2575080"/>
              <a:ext cx="21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p35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Freeform 385"/>
            <p:cNvSpPr/>
            <p:nvPr/>
          </p:nvSpPr>
          <p:spPr>
            <a:xfrm>
              <a:off x="7191360" y="3370320"/>
              <a:ext cx="82440" cy="100080"/>
            </a:xfrm>
            <a:custGeom>
              <a:avLst/>
              <a:gdLst>
                <a:gd name="textAreaLeft" fmla="*/ 0 w 82440"/>
                <a:gd name="textAreaRight" fmla="*/ 82800 w 82440"/>
                <a:gd name="textAreaTop" fmla="*/ 0 h 100080"/>
                <a:gd name="textAreaBottom" fmla="*/ 100440 h 100080"/>
              </a:gdLst>
              <a:ahLst/>
              <a:rect l="textAreaLeft" t="textAreaTop" r="textAreaRight" b="textAreaBottom"/>
              <a:pathLst>
                <a:path w="52" h="63">
                  <a:moveTo>
                    <a:pt x="12" y="0"/>
                  </a:moveTo>
                  <a:lnTo>
                    <a:pt x="2" y="45"/>
                  </a:lnTo>
                  <a:lnTo>
                    <a:pt x="0" y="57"/>
                  </a:lnTo>
                  <a:lnTo>
                    <a:pt x="40" y="63"/>
                  </a:lnTo>
                  <a:lnTo>
                    <a:pt x="48" y="21"/>
                  </a:lnTo>
                  <a:lnTo>
                    <a:pt x="52" y="10"/>
                  </a:lnTo>
                  <a:lnTo>
                    <a:pt x="12" y="0"/>
                  </a:lnTo>
                  <a:close/>
                </a:path>
              </a:pathLst>
            </a:custGeom>
            <a:solidFill>
              <a:srgbClr val="ff66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Arc 386"/>
            <p:cNvSpPr/>
            <p:nvPr/>
          </p:nvSpPr>
          <p:spPr>
            <a:xfrm>
              <a:off x="7191360" y="3370320"/>
              <a:ext cx="811080" cy="209520"/>
            </a:xfrm>
            <a:custGeom>
              <a:avLst/>
              <a:gdLst>
                <a:gd name="textAreaLeft" fmla="*/ 0 w 811080"/>
                <a:gd name="textAreaRight" fmla="*/ 811440 w 811080"/>
                <a:gd name="textAreaTop" fmla="*/ 0 h 209520"/>
                <a:gd name="textAreaBottom" fmla="*/ 209880 h 209520"/>
              </a:gdLst>
              <a:ahLst/>
              <a:rect l="textAreaLeft" t="textAreaTop" r="textAreaRight" b="textAreaBottom"/>
              <a:pathLst>
                <a:path fill="none" w="21371" h="5524">
                  <a:moveTo>
                    <a:pt x="0" y="2387"/>
                  </a:moveTo>
                  <a:cubicBezTo>
                    <a:pt x="118" y="1582"/>
                    <a:pt x="281" y="785"/>
                    <a:pt x="489" y="0"/>
                  </a:cubicBezTo>
                </a:path>
                <a:path stroke="0" w="21371" h="5524">
                  <a:moveTo>
                    <a:pt x="0" y="2387"/>
                  </a:moveTo>
                  <a:cubicBezTo>
                    <a:pt x="118" y="1582"/>
                    <a:pt x="281" y="785"/>
                    <a:pt x="489" y="0"/>
                  </a:cubicBezTo>
                  <a:lnTo>
                    <a:pt x="21371" y="5524"/>
                  </a:lnTo>
                  <a:lnTo>
                    <a:pt x="0" y="2387"/>
                  </a:lnTo>
                  <a:close/>
                </a:path>
              </a:pathLst>
            </a:custGeom>
            <a:noFill/>
            <a:ln w="144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Arc 387"/>
            <p:cNvSpPr/>
            <p:nvPr/>
          </p:nvSpPr>
          <p:spPr>
            <a:xfrm>
              <a:off x="7256520" y="3386160"/>
              <a:ext cx="747720" cy="193680"/>
            </a:xfrm>
            <a:custGeom>
              <a:avLst/>
              <a:gdLst>
                <a:gd name="textAreaLeft" fmla="*/ 0 w 747720"/>
                <a:gd name="textAreaRight" fmla="*/ 748080 w 747720"/>
                <a:gd name="textAreaTop" fmla="*/ 0 h 193680"/>
                <a:gd name="textAreaBottom" fmla="*/ 194040 h 193680"/>
              </a:gdLst>
              <a:ahLst/>
              <a:rect l="textAreaLeft" t="textAreaTop" r="textAreaRight" b="textAreaBottom"/>
              <a:pathLst>
                <a:path fill="none" w="21373" h="5537">
                  <a:moveTo>
                    <a:pt x="0" y="2413"/>
                  </a:moveTo>
                  <a:cubicBezTo>
                    <a:pt x="118" y="1599"/>
                    <a:pt x="284" y="794"/>
                    <a:pt x="494" y="-1"/>
                  </a:cubicBezTo>
                </a:path>
                <a:path stroke="0" w="21373" h="5537">
                  <a:moveTo>
                    <a:pt x="0" y="2413"/>
                  </a:moveTo>
                  <a:cubicBezTo>
                    <a:pt x="118" y="1599"/>
                    <a:pt x="284" y="794"/>
                    <a:pt x="494" y="-1"/>
                  </a:cubicBezTo>
                  <a:lnTo>
                    <a:pt x="21373" y="5537"/>
                  </a:lnTo>
                  <a:lnTo>
                    <a:pt x="0" y="2413"/>
                  </a:lnTo>
                  <a:close/>
                </a:path>
              </a:pathLst>
            </a:custGeom>
            <a:noFill/>
            <a:ln w="144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Line 388"/>
            <p:cNvSpPr/>
            <p:nvPr/>
          </p:nvSpPr>
          <p:spPr>
            <a:xfrm flipH="1" flipV="1">
              <a:off x="7210440" y="3370320"/>
              <a:ext cx="63360" cy="15840"/>
            </a:xfrm>
            <a:prstGeom prst="line">
              <a:avLst/>
            </a:prstGeom>
            <a:ln w="144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389"/>
            <p:cNvSpPr/>
            <p:nvPr/>
          </p:nvSpPr>
          <p:spPr>
            <a:xfrm flipH="1" flipV="1">
              <a:off x="7191360" y="3460320"/>
              <a:ext cx="63360" cy="9720"/>
            </a:xfrm>
            <a:prstGeom prst="line">
              <a:avLst/>
            </a:prstGeom>
            <a:ln w="144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Line 390"/>
            <p:cNvSpPr/>
            <p:nvPr/>
          </p:nvSpPr>
          <p:spPr>
            <a:xfrm>
              <a:off x="7054920" y="3398760"/>
              <a:ext cx="144360" cy="15840"/>
            </a:xfrm>
            <a:prstGeom prst="line">
              <a:avLst/>
            </a:prstGeom>
            <a:ln w="1440">
              <a:solidFill>
                <a:srgbClr val="ff00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391"/>
            <p:cNvSpPr/>
            <p:nvPr/>
          </p:nvSpPr>
          <p:spPr>
            <a:xfrm>
              <a:off x="6886080" y="3398760"/>
              <a:ext cx="21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T35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Freeform 392"/>
            <p:cNvSpPr/>
            <p:nvPr/>
          </p:nvSpPr>
          <p:spPr>
            <a:xfrm>
              <a:off x="8404200" y="2884320"/>
              <a:ext cx="103320" cy="98640"/>
            </a:xfrm>
            <a:custGeom>
              <a:avLst/>
              <a:gdLst>
                <a:gd name="textAreaLeft" fmla="*/ 0 w 103320"/>
                <a:gd name="textAreaRight" fmla="*/ 103680 w 103320"/>
                <a:gd name="textAreaTop" fmla="*/ 0 h 98640"/>
                <a:gd name="textAreaBottom" fmla="*/ 99000 h 98640"/>
              </a:gdLst>
              <a:ahLst/>
              <a:rect l="textAreaLeft" t="textAreaTop" r="textAreaRight" b="textAreaBottom"/>
              <a:pathLst>
                <a:path w="65" h="62">
                  <a:moveTo>
                    <a:pt x="65" y="30"/>
                  </a:moveTo>
                  <a:lnTo>
                    <a:pt x="27" y="3"/>
                  </a:lnTo>
                  <a:lnTo>
                    <a:pt x="22" y="0"/>
                  </a:lnTo>
                  <a:lnTo>
                    <a:pt x="0" y="35"/>
                  </a:lnTo>
                  <a:lnTo>
                    <a:pt x="36" y="59"/>
                  </a:lnTo>
                  <a:lnTo>
                    <a:pt x="40" y="62"/>
                  </a:lnTo>
                  <a:lnTo>
                    <a:pt x="65" y="30"/>
                  </a:lnTo>
                  <a:close/>
                </a:path>
              </a:pathLst>
            </a:custGeom>
            <a:solidFill>
              <a:srgbClr val="cccc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Arc 393"/>
            <p:cNvSpPr/>
            <p:nvPr/>
          </p:nvSpPr>
          <p:spPr>
            <a:xfrm>
              <a:off x="8002440" y="2886120"/>
              <a:ext cx="505080" cy="693720"/>
            </a:xfrm>
            <a:custGeom>
              <a:avLst/>
              <a:gdLst>
                <a:gd name="textAreaLeft" fmla="*/ 0 w 505080"/>
                <a:gd name="textAreaRight" fmla="*/ 505440 w 505080"/>
                <a:gd name="textAreaTop" fmla="*/ 0 h 693720"/>
                <a:gd name="textAreaBottom" fmla="*/ 694080 h 693720"/>
              </a:gdLst>
              <a:ahLst/>
              <a:rect l="textAreaLeft" t="textAreaTop" r="textAreaRight" b="textAreaBottom"/>
              <a:pathLst>
                <a:path fill="none" w="13278" h="18293">
                  <a:moveTo>
                    <a:pt x="11485" y="-1"/>
                  </a:moveTo>
                  <a:cubicBezTo>
                    <a:pt x="12103" y="387"/>
                    <a:pt x="12701" y="807"/>
                    <a:pt x="13277" y="1256"/>
                  </a:cubicBezTo>
                </a:path>
                <a:path stroke="0" w="13278" h="18293">
                  <a:moveTo>
                    <a:pt x="11485" y="-1"/>
                  </a:moveTo>
                  <a:cubicBezTo>
                    <a:pt x="12103" y="387"/>
                    <a:pt x="12701" y="807"/>
                    <a:pt x="13277" y="1256"/>
                  </a:cubicBezTo>
                  <a:lnTo>
                    <a:pt x="0" y="18293"/>
                  </a:lnTo>
                  <a:lnTo>
                    <a:pt x="11485" y="-1"/>
                  </a:lnTo>
                  <a:close/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Arc 394"/>
            <p:cNvSpPr/>
            <p:nvPr/>
          </p:nvSpPr>
          <p:spPr>
            <a:xfrm>
              <a:off x="8004240" y="2940120"/>
              <a:ext cx="463320" cy="639720"/>
            </a:xfrm>
            <a:custGeom>
              <a:avLst/>
              <a:gdLst>
                <a:gd name="textAreaLeft" fmla="*/ 0 w 463320"/>
                <a:gd name="textAreaRight" fmla="*/ 463680 w 463320"/>
                <a:gd name="textAreaTop" fmla="*/ 0 h 639720"/>
                <a:gd name="textAreaBottom" fmla="*/ 640080 h 639720"/>
              </a:gdLst>
              <a:ahLst/>
              <a:rect l="textAreaLeft" t="textAreaTop" r="textAreaRight" b="textAreaBottom"/>
              <a:pathLst>
                <a:path fill="none" w="13249" h="18314">
                  <a:moveTo>
                    <a:pt x="11452" y="-1"/>
                  </a:moveTo>
                  <a:cubicBezTo>
                    <a:pt x="12071" y="387"/>
                    <a:pt x="12671" y="806"/>
                    <a:pt x="13248" y="1254"/>
                  </a:cubicBezTo>
                </a:path>
                <a:path stroke="0" w="13249" h="18314">
                  <a:moveTo>
                    <a:pt x="11452" y="-1"/>
                  </a:moveTo>
                  <a:cubicBezTo>
                    <a:pt x="12071" y="387"/>
                    <a:pt x="12671" y="806"/>
                    <a:pt x="13248" y="1254"/>
                  </a:cubicBezTo>
                  <a:lnTo>
                    <a:pt x="0" y="18314"/>
                  </a:lnTo>
                  <a:lnTo>
                    <a:pt x="11452" y="-1"/>
                  </a:lnTo>
                  <a:close/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Line 395"/>
            <p:cNvSpPr/>
            <p:nvPr/>
          </p:nvSpPr>
          <p:spPr>
            <a:xfrm flipV="1">
              <a:off x="8467560" y="2931840"/>
              <a:ext cx="39960" cy="50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Line 396"/>
            <p:cNvSpPr/>
            <p:nvPr/>
          </p:nvSpPr>
          <p:spPr>
            <a:xfrm flipV="1">
              <a:off x="8404200" y="2883960"/>
              <a:ext cx="34920" cy="55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Line 397"/>
            <p:cNvSpPr/>
            <p:nvPr/>
          </p:nvSpPr>
          <p:spPr>
            <a:xfrm flipH="1">
              <a:off x="8474040" y="2800440"/>
              <a:ext cx="125280" cy="106200"/>
            </a:xfrm>
            <a:prstGeom prst="line">
              <a:avLst/>
            </a:prstGeom>
            <a:ln w="1440">
              <a:solidFill>
                <a:srgbClr val="ff00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398"/>
            <p:cNvSpPr/>
            <p:nvPr/>
          </p:nvSpPr>
          <p:spPr>
            <a:xfrm>
              <a:off x="8607960" y="2711520"/>
              <a:ext cx="128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R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Freeform 399"/>
            <p:cNvSpPr/>
            <p:nvPr/>
          </p:nvSpPr>
          <p:spPr>
            <a:xfrm>
              <a:off x="7421400" y="4113360"/>
              <a:ext cx="141480" cy="136440"/>
            </a:xfrm>
            <a:custGeom>
              <a:avLst/>
              <a:gdLst>
                <a:gd name="textAreaLeft" fmla="*/ 0 w 141480"/>
                <a:gd name="textAreaRight" fmla="*/ 141840 w 141480"/>
                <a:gd name="textAreaTop" fmla="*/ 0 h 136440"/>
                <a:gd name="textAreaBottom" fmla="*/ 136800 h 136440"/>
              </a:gdLst>
              <a:ahLst/>
              <a:rect l="textAreaLeft" t="textAreaTop" r="textAreaRight" b="textAreaBottom"/>
              <a:pathLst>
                <a:path w="89" h="86">
                  <a:moveTo>
                    <a:pt x="0" y="29"/>
                  </a:moveTo>
                  <a:lnTo>
                    <a:pt x="34" y="61"/>
                  </a:lnTo>
                  <a:lnTo>
                    <a:pt x="65" y="86"/>
                  </a:lnTo>
                  <a:lnTo>
                    <a:pt x="89" y="52"/>
                  </a:lnTo>
                  <a:lnTo>
                    <a:pt x="56" y="26"/>
                  </a:lnTo>
                  <a:lnTo>
                    <a:pt x="29" y="0"/>
                  </a:lnTo>
                  <a:lnTo>
                    <a:pt x="0" y="29"/>
                  </a:lnTo>
                  <a:close/>
                </a:path>
              </a:pathLst>
            </a:custGeom>
            <a:solidFill>
              <a:srgbClr val="cccc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Arc 400"/>
            <p:cNvSpPr/>
            <p:nvPr/>
          </p:nvSpPr>
          <p:spPr>
            <a:xfrm>
              <a:off x="7421400" y="3579840"/>
              <a:ext cx="581040" cy="666720"/>
            </a:xfrm>
            <a:custGeom>
              <a:avLst/>
              <a:gdLst>
                <a:gd name="textAreaLeft" fmla="*/ 0 w 581040"/>
                <a:gd name="textAreaRight" fmla="*/ 581400 w 581040"/>
                <a:gd name="textAreaTop" fmla="*/ 0 h 666720"/>
                <a:gd name="textAreaBottom" fmla="*/ 667080 h 666720"/>
              </a:gdLst>
              <a:ahLst/>
              <a:rect l="textAreaLeft" t="textAreaTop" r="textAreaRight" b="textAreaBottom"/>
              <a:pathLst>
                <a:path fill="none" w="15294" h="17585">
                  <a:moveTo>
                    <a:pt x="2750" y="17585"/>
                  </a:moveTo>
                  <a:cubicBezTo>
                    <a:pt x="1770" y="16885"/>
                    <a:pt x="850" y="16105"/>
                    <a:pt x="0" y="15252"/>
                  </a:cubicBezTo>
                </a:path>
                <a:path stroke="0" w="15294" h="17585">
                  <a:moveTo>
                    <a:pt x="2750" y="17585"/>
                  </a:moveTo>
                  <a:cubicBezTo>
                    <a:pt x="1770" y="16885"/>
                    <a:pt x="850" y="16105"/>
                    <a:pt x="0" y="15252"/>
                  </a:cubicBezTo>
                  <a:lnTo>
                    <a:pt x="15294" y="0"/>
                  </a:lnTo>
                  <a:lnTo>
                    <a:pt x="2750" y="17585"/>
                  </a:lnTo>
                  <a:close/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Arc 401"/>
            <p:cNvSpPr/>
            <p:nvPr/>
          </p:nvSpPr>
          <p:spPr>
            <a:xfrm>
              <a:off x="7469280" y="3579840"/>
              <a:ext cx="534960" cy="614160"/>
            </a:xfrm>
            <a:custGeom>
              <a:avLst/>
              <a:gdLst>
                <a:gd name="textAreaLeft" fmla="*/ 0 w 534960"/>
                <a:gd name="textAreaRight" fmla="*/ 535320 w 534960"/>
                <a:gd name="textAreaTop" fmla="*/ 0 h 614160"/>
                <a:gd name="textAreaBottom" fmla="*/ 614520 h 614160"/>
              </a:gdLst>
              <a:ahLst/>
              <a:rect l="textAreaLeft" t="textAreaTop" r="textAreaRight" b="textAreaBottom"/>
              <a:pathLst>
                <a:path fill="none" w="15319" h="17558">
                  <a:moveTo>
                    <a:pt x="2738" y="17558"/>
                  </a:moveTo>
                  <a:cubicBezTo>
                    <a:pt x="1762" y="16859"/>
                    <a:pt x="846" y="16079"/>
                    <a:pt x="0" y="15227"/>
                  </a:cubicBezTo>
                </a:path>
                <a:path stroke="0" w="15319" h="17558">
                  <a:moveTo>
                    <a:pt x="2738" y="17558"/>
                  </a:moveTo>
                  <a:cubicBezTo>
                    <a:pt x="1762" y="16859"/>
                    <a:pt x="846" y="16079"/>
                    <a:pt x="0" y="15227"/>
                  </a:cubicBezTo>
                  <a:lnTo>
                    <a:pt x="15319" y="0"/>
                  </a:lnTo>
                  <a:lnTo>
                    <a:pt x="2738" y="17558"/>
                  </a:lnTo>
                  <a:close/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402"/>
            <p:cNvSpPr/>
            <p:nvPr/>
          </p:nvSpPr>
          <p:spPr>
            <a:xfrm flipH="1">
              <a:off x="7421400" y="4113360"/>
              <a:ext cx="46080" cy="45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Line 403"/>
            <p:cNvSpPr/>
            <p:nvPr/>
          </p:nvSpPr>
          <p:spPr>
            <a:xfrm flipH="1">
              <a:off x="7524720" y="4195800"/>
              <a:ext cx="38160" cy="540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Line 404"/>
            <p:cNvSpPr/>
            <p:nvPr/>
          </p:nvSpPr>
          <p:spPr>
            <a:xfrm flipV="1">
              <a:off x="7310520" y="4206960"/>
              <a:ext cx="162000" cy="15840"/>
            </a:xfrm>
            <a:prstGeom prst="line">
              <a:avLst/>
            </a:prstGeom>
            <a:ln w="1440">
              <a:solidFill>
                <a:srgbClr val="ff00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405"/>
            <p:cNvSpPr/>
            <p:nvPr/>
          </p:nvSpPr>
          <p:spPr>
            <a:xfrm>
              <a:off x="7223760" y="4224240"/>
              <a:ext cx="118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L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Freeform 406"/>
            <p:cNvSpPr/>
            <p:nvPr/>
          </p:nvSpPr>
          <p:spPr>
            <a:xfrm>
              <a:off x="7527960" y="4197240"/>
              <a:ext cx="484200" cy="230400"/>
            </a:xfrm>
            <a:custGeom>
              <a:avLst/>
              <a:gdLst>
                <a:gd name="textAreaLeft" fmla="*/ 0 w 484200"/>
                <a:gd name="textAreaRight" fmla="*/ 484560 w 484200"/>
                <a:gd name="textAreaTop" fmla="*/ 0 h 230400"/>
                <a:gd name="textAreaBottom" fmla="*/ 230760 h 230400"/>
              </a:gdLst>
              <a:ahLst/>
              <a:rect l="textAreaLeft" t="textAreaTop" r="textAreaRight" b="textAreaBottom"/>
              <a:pathLst>
                <a:path w="305" h="145">
                  <a:moveTo>
                    <a:pt x="0" y="33"/>
                  </a:moveTo>
                  <a:lnTo>
                    <a:pt x="39" y="58"/>
                  </a:lnTo>
                  <a:lnTo>
                    <a:pt x="79" y="80"/>
                  </a:lnTo>
                  <a:lnTo>
                    <a:pt x="122" y="98"/>
                  </a:lnTo>
                  <a:lnTo>
                    <a:pt x="166" y="112"/>
                  </a:lnTo>
                  <a:lnTo>
                    <a:pt x="211" y="122"/>
                  </a:lnTo>
                  <a:lnTo>
                    <a:pt x="257" y="128"/>
                  </a:lnTo>
                  <a:lnTo>
                    <a:pt x="272" y="129"/>
                  </a:lnTo>
                  <a:lnTo>
                    <a:pt x="271" y="145"/>
                  </a:lnTo>
                  <a:lnTo>
                    <a:pt x="305" y="109"/>
                  </a:lnTo>
                  <a:lnTo>
                    <a:pt x="275" y="71"/>
                  </a:lnTo>
                  <a:lnTo>
                    <a:pt x="274" y="87"/>
                  </a:lnTo>
                  <a:lnTo>
                    <a:pt x="232" y="83"/>
                  </a:lnTo>
                  <a:lnTo>
                    <a:pt x="189" y="76"/>
                  </a:lnTo>
                  <a:lnTo>
                    <a:pt x="149" y="64"/>
                  </a:lnTo>
                  <a:lnTo>
                    <a:pt x="109" y="49"/>
                  </a:lnTo>
                  <a:lnTo>
                    <a:pt x="70" y="30"/>
                  </a:lnTo>
                  <a:lnTo>
                    <a:pt x="34" y="8"/>
                  </a:lnTo>
                  <a:lnTo>
                    <a:pt x="23" y="0"/>
                  </a:lnTo>
                  <a:lnTo>
                    <a:pt x="0" y="33"/>
                  </a:lnTo>
                  <a:close/>
                </a:path>
              </a:pathLst>
            </a:cu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Arc 407"/>
            <p:cNvSpPr/>
            <p:nvPr/>
          </p:nvSpPr>
          <p:spPr>
            <a:xfrm>
              <a:off x="7527960" y="3579840"/>
              <a:ext cx="474480" cy="819000"/>
            </a:xfrm>
            <a:custGeom>
              <a:avLst/>
              <a:gdLst>
                <a:gd name="textAreaLeft" fmla="*/ 0 w 474480"/>
                <a:gd name="textAreaRight" fmla="*/ 474840 w 474480"/>
                <a:gd name="textAreaTop" fmla="*/ 0 h 819000"/>
                <a:gd name="textAreaBottom" fmla="*/ 819360 h 819000"/>
              </a:gdLst>
              <a:ahLst/>
              <a:rect l="textAreaLeft" t="textAreaTop" r="textAreaRight" b="textAreaBottom"/>
              <a:pathLst>
                <a:path fill="none" w="12487" h="21571">
                  <a:moveTo>
                    <a:pt x="11363" y="21570"/>
                  </a:moveTo>
                  <a:cubicBezTo>
                    <a:pt x="7277" y="21357"/>
                    <a:pt x="3337" y="19989"/>
                    <a:pt x="-1" y="17624"/>
                  </a:cubicBezTo>
                </a:path>
                <a:path stroke="0" w="12487" h="21571">
                  <a:moveTo>
                    <a:pt x="11363" y="21570"/>
                  </a:moveTo>
                  <a:cubicBezTo>
                    <a:pt x="7277" y="21357"/>
                    <a:pt x="3337" y="19989"/>
                    <a:pt x="-1" y="17624"/>
                  </a:cubicBezTo>
                  <a:lnTo>
                    <a:pt x="12487" y="0"/>
                  </a:lnTo>
                  <a:lnTo>
                    <a:pt x="11363" y="21570"/>
                  </a:lnTo>
                  <a:close/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Arc 408"/>
            <p:cNvSpPr/>
            <p:nvPr/>
          </p:nvSpPr>
          <p:spPr>
            <a:xfrm>
              <a:off x="7566120" y="3579840"/>
              <a:ext cx="438120" cy="754200"/>
            </a:xfrm>
            <a:custGeom>
              <a:avLst/>
              <a:gdLst>
                <a:gd name="textAreaLeft" fmla="*/ 0 w 438120"/>
                <a:gd name="textAreaRight" fmla="*/ 438480 w 438120"/>
                <a:gd name="textAreaTop" fmla="*/ 0 h 754200"/>
                <a:gd name="textAreaBottom" fmla="*/ 754560 h 754200"/>
              </a:gdLst>
              <a:ahLst/>
              <a:rect l="textAreaLeft" t="textAreaTop" r="textAreaRight" b="textAreaBottom"/>
              <a:pathLst>
                <a:path fill="none" w="12529" h="21568">
                  <a:moveTo>
                    <a:pt x="11351" y="21567"/>
                  </a:moveTo>
                  <a:cubicBezTo>
                    <a:pt x="7267" y="21344"/>
                    <a:pt x="3331" y="19967"/>
                    <a:pt x="-1" y="17595"/>
                  </a:cubicBezTo>
                </a:path>
                <a:path stroke="0" w="12529" h="21568">
                  <a:moveTo>
                    <a:pt x="11351" y="21567"/>
                  </a:moveTo>
                  <a:cubicBezTo>
                    <a:pt x="7267" y="21344"/>
                    <a:pt x="3331" y="19967"/>
                    <a:pt x="-1" y="17595"/>
                  </a:cubicBezTo>
                  <a:lnTo>
                    <a:pt x="12529" y="0"/>
                  </a:lnTo>
                  <a:lnTo>
                    <a:pt x="11351" y="21567"/>
                  </a:lnTo>
                  <a:close/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Line 409"/>
            <p:cNvSpPr/>
            <p:nvPr/>
          </p:nvSpPr>
          <p:spPr>
            <a:xfrm flipH="1">
              <a:off x="7527600" y="4197240"/>
              <a:ext cx="36360" cy="525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Freeform 410"/>
            <p:cNvSpPr/>
            <p:nvPr/>
          </p:nvSpPr>
          <p:spPr>
            <a:xfrm>
              <a:off x="7958160" y="4309920"/>
              <a:ext cx="54000" cy="117720"/>
            </a:xfrm>
            <a:custGeom>
              <a:avLst/>
              <a:gdLst>
                <a:gd name="textAreaLeft" fmla="*/ 0 w 54000"/>
                <a:gd name="textAreaRight" fmla="*/ 54360 w 54000"/>
                <a:gd name="textAreaTop" fmla="*/ 0 h 117720"/>
                <a:gd name="textAreaBottom" fmla="*/ 118080 h 117720"/>
              </a:gdLst>
              <a:ahLst/>
              <a:rect l="textAreaLeft" t="textAreaTop" r="textAreaRight" b="textAreaBottom"/>
              <a:pathLst>
                <a:path w="71" h="150">
                  <a:moveTo>
                    <a:pt x="6" y="33"/>
                  </a:moveTo>
                  <a:lnTo>
                    <a:pt x="8" y="0"/>
                  </a:lnTo>
                  <a:lnTo>
                    <a:pt x="71" y="77"/>
                  </a:lnTo>
                  <a:lnTo>
                    <a:pt x="0" y="150"/>
                  </a:lnTo>
                  <a:lnTo>
                    <a:pt x="2" y="117"/>
                  </a:lnTo>
                </a:path>
              </a:pathLst>
            </a:custGeom>
            <a:noFill/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Line 411"/>
            <p:cNvSpPr/>
            <p:nvPr/>
          </p:nvSpPr>
          <p:spPr>
            <a:xfrm flipV="1">
              <a:off x="7645320" y="4365720"/>
              <a:ext cx="112680" cy="131760"/>
            </a:xfrm>
            <a:prstGeom prst="line">
              <a:avLst/>
            </a:prstGeom>
            <a:ln w="1440">
              <a:solidFill>
                <a:srgbClr val="ff00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Rectangle 412"/>
            <p:cNvSpPr/>
            <p:nvPr/>
          </p:nvSpPr>
          <p:spPr>
            <a:xfrm>
              <a:off x="7366320" y="4498920"/>
              <a:ext cx="340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Sm/Sp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3" name="Group 416"/>
          <p:cNvGrpSpPr/>
          <p:nvPr/>
        </p:nvGrpSpPr>
        <p:grpSpPr>
          <a:xfrm>
            <a:off x="3780000" y="3860640"/>
            <a:ext cx="1871640" cy="1827360"/>
            <a:chOff x="3780000" y="3860640"/>
            <a:chExt cx="1871640" cy="1827360"/>
          </a:xfrm>
        </p:grpSpPr>
        <p:sp>
          <p:nvSpPr>
            <p:cNvPr id="224" name="AutoShape 415"/>
            <p:cNvSpPr/>
            <p:nvPr/>
          </p:nvSpPr>
          <p:spPr>
            <a:xfrm>
              <a:off x="3780000" y="3860640"/>
              <a:ext cx="1871640" cy="182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Freeform 417"/>
            <p:cNvSpPr/>
            <p:nvPr/>
          </p:nvSpPr>
          <p:spPr>
            <a:xfrm>
              <a:off x="4084560" y="4076640"/>
              <a:ext cx="1528920" cy="1524240"/>
            </a:xfrm>
            <a:custGeom>
              <a:avLst/>
              <a:gdLst>
                <a:gd name="textAreaLeft" fmla="*/ 0 w 1528920"/>
                <a:gd name="textAreaRight" fmla="*/ 1529280 w 1528920"/>
                <a:gd name="textAreaTop" fmla="*/ 0 h 1524240"/>
                <a:gd name="textAreaBottom" fmla="*/ 1524600 h 1524240"/>
              </a:gdLst>
              <a:ahLst/>
              <a:rect l="textAreaLeft" t="textAreaTop" r="textAreaRight" b="textAreaBottom"/>
              <a:pathLst>
                <a:path w="963" h="960">
                  <a:moveTo>
                    <a:pt x="486" y="0"/>
                  </a:moveTo>
                  <a:lnTo>
                    <a:pt x="442" y="1"/>
                  </a:lnTo>
                  <a:lnTo>
                    <a:pt x="399" y="6"/>
                  </a:lnTo>
                  <a:lnTo>
                    <a:pt x="358" y="16"/>
                  </a:lnTo>
                  <a:lnTo>
                    <a:pt x="317" y="28"/>
                  </a:lnTo>
                  <a:lnTo>
                    <a:pt x="277" y="45"/>
                  </a:lnTo>
                  <a:lnTo>
                    <a:pt x="239" y="65"/>
                  </a:lnTo>
                  <a:lnTo>
                    <a:pt x="203" y="88"/>
                  </a:lnTo>
                  <a:lnTo>
                    <a:pt x="169" y="115"/>
                  </a:lnTo>
                  <a:lnTo>
                    <a:pt x="137" y="144"/>
                  </a:lnTo>
                  <a:lnTo>
                    <a:pt x="109" y="176"/>
                  </a:lnTo>
                  <a:lnTo>
                    <a:pt x="82" y="210"/>
                  </a:lnTo>
                  <a:lnTo>
                    <a:pt x="60" y="247"/>
                  </a:lnTo>
                  <a:lnTo>
                    <a:pt x="41" y="285"/>
                  </a:lnTo>
                  <a:lnTo>
                    <a:pt x="25" y="325"/>
                  </a:lnTo>
                  <a:lnTo>
                    <a:pt x="14" y="366"/>
                  </a:lnTo>
                  <a:lnTo>
                    <a:pt x="5" y="408"/>
                  </a:lnTo>
                  <a:lnTo>
                    <a:pt x="1" y="452"/>
                  </a:lnTo>
                  <a:lnTo>
                    <a:pt x="0" y="495"/>
                  </a:lnTo>
                  <a:lnTo>
                    <a:pt x="3" y="537"/>
                  </a:lnTo>
                  <a:lnTo>
                    <a:pt x="11" y="580"/>
                  </a:lnTo>
                  <a:lnTo>
                    <a:pt x="21" y="621"/>
                  </a:lnTo>
                  <a:lnTo>
                    <a:pt x="36" y="662"/>
                  </a:lnTo>
                  <a:lnTo>
                    <a:pt x="54" y="701"/>
                  </a:lnTo>
                  <a:lnTo>
                    <a:pt x="75" y="738"/>
                  </a:lnTo>
                  <a:lnTo>
                    <a:pt x="100" y="773"/>
                  </a:lnTo>
                  <a:lnTo>
                    <a:pt x="128" y="805"/>
                  </a:lnTo>
                  <a:lnTo>
                    <a:pt x="158" y="836"/>
                  </a:lnTo>
                  <a:lnTo>
                    <a:pt x="191" y="863"/>
                  </a:lnTo>
                  <a:lnTo>
                    <a:pt x="227" y="888"/>
                  </a:lnTo>
                  <a:lnTo>
                    <a:pt x="265" y="909"/>
                  </a:lnTo>
                  <a:lnTo>
                    <a:pt x="304" y="927"/>
                  </a:lnTo>
                  <a:lnTo>
                    <a:pt x="344" y="940"/>
                  </a:lnTo>
                  <a:lnTo>
                    <a:pt x="386" y="951"/>
                  </a:lnTo>
                  <a:lnTo>
                    <a:pt x="429" y="957"/>
                  </a:lnTo>
                  <a:lnTo>
                    <a:pt x="472" y="960"/>
                  </a:lnTo>
                  <a:lnTo>
                    <a:pt x="515" y="959"/>
                  </a:lnTo>
                  <a:lnTo>
                    <a:pt x="557" y="954"/>
                  </a:lnTo>
                  <a:lnTo>
                    <a:pt x="600" y="946"/>
                  </a:lnTo>
                  <a:lnTo>
                    <a:pt x="641" y="933"/>
                  </a:lnTo>
                  <a:lnTo>
                    <a:pt x="681" y="917"/>
                  </a:lnTo>
                  <a:lnTo>
                    <a:pt x="719" y="897"/>
                  </a:lnTo>
                  <a:lnTo>
                    <a:pt x="756" y="874"/>
                  </a:lnTo>
                  <a:lnTo>
                    <a:pt x="790" y="849"/>
                  </a:lnTo>
                  <a:lnTo>
                    <a:pt x="821" y="819"/>
                  </a:lnTo>
                  <a:lnTo>
                    <a:pt x="851" y="788"/>
                  </a:lnTo>
                  <a:lnTo>
                    <a:pt x="876" y="754"/>
                  </a:lnTo>
                  <a:lnTo>
                    <a:pt x="899" y="717"/>
                  </a:lnTo>
                  <a:lnTo>
                    <a:pt x="920" y="679"/>
                  </a:lnTo>
                  <a:lnTo>
                    <a:pt x="935" y="639"/>
                  </a:lnTo>
                  <a:lnTo>
                    <a:pt x="948" y="598"/>
                  </a:lnTo>
                  <a:lnTo>
                    <a:pt x="956" y="556"/>
                  </a:lnTo>
                  <a:lnTo>
                    <a:pt x="962" y="514"/>
                  </a:lnTo>
                  <a:lnTo>
                    <a:pt x="963" y="471"/>
                  </a:lnTo>
                  <a:lnTo>
                    <a:pt x="960" y="427"/>
                  </a:lnTo>
                  <a:lnTo>
                    <a:pt x="953" y="385"/>
                  </a:lnTo>
                  <a:lnTo>
                    <a:pt x="943" y="343"/>
                  </a:lnTo>
                  <a:lnTo>
                    <a:pt x="929" y="303"/>
                  </a:lnTo>
                  <a:lnTo>
                    <a:pt x="911" y="264"/>
                  </a:lnTo>
                  <a:lnTo>
                    <a:pt x="890" y="226"/>
                  </a:lnTo>
                  <a:lnTo>
                    <a:pt x="866" y="190"/>
                  </a:lnTo>
                  <a:lnTo>
                    <a:pt x="838" y="158"/>
                  </a:lnTo>
                  <a:lnTo>
                    <a:pt x="808" y="127"/>
                  </a:lnTo>
                  <a:lnTo>
                    <a:pt x="775" y="100"/>
                  </a:lnTo>
                  <a:lnTo>
                    <a:pt x="740" y="75"/>
                  </a:lnTo>
                  <a:lnTo>
                    <a:pt x="703" y="54"/>
                  </a:lnTo>
                  <a:lnTo>
                    <a:pt x="664" y="36"/>
                  </a:lnTo>
                  <a:lnTo>
                    <a:pt x="623" y="21"/>
                  </a:lnTo>
                  <a:lnTo>
                    <a:pt x="582" y="10"/>
                  </a:lnTo>
                  <a:lnTo>
                    <a:pt x="538" y="3"/>
                  </a:lnTo>
                  <a:lnTo>
                    <a:pt x="496" y="0"/>
                  </a:lnTo>
                  <a:lnTo>
                    <a:pt x="487" y="0"/>
                  </a:lnTo>
                  <a:lnTo>
                    <a:pt x="486" y="10"/>
                  </a:lnTo>
                  <a:lnTo>
                    <a:pt x="528" y="12"/>
                  </a:lnTo>
                  <a:lnTo>
                    <a:pt x="570" y="18"/>
                  </a:lnTo>
                  <a:lnTo>
                    <a:pt x="611" y="28"/>
                  </a:lnTo>
                  <a:lnTo>
                    <a:pt x="651" y="41"/>
                  </a:lnTo>
                  <a:lnTo>
                    <a:pt x="689" y="58"/>
                  </a:lnTo>
                  <a:lnTo>
                    <a:pt x="726" y="79"/>
                  </a:lnTo>
                  <a:lnTo>
                    <a:pt x="761" y="102"/>
                  </a:lnTo>
                  <a:lnTo>
                    <a:pt x="794" y="128"/>
                  </a:lnTo>
                  <a:lnTo>
                    <a:pt x="825" y="158"/>
                  </a:lnTo>
                  <a:lnTo>
                    <a:pt x="852" y="189"/>
                  </a:lnTo>
                  <a:lnTo>
                    <a:pt x="876" y="224"/>
                  </a:lnTo>
                  <a:lnTo>
                    <a:pt x="897" y="260"/>
                  </a:lnTo>
                  <a:lnTo>
                    <a:pt x="915" y="298"/>
                  </a:lnTo>
                  <a:lnTo>
                    <a:pt x="930" y="337"/>
                  </a:lnTo>
                  <a:lnTo>
                    <a:pt x="942" y="378"/>
                  </a:lnTo>
                  <a:lnTo>
                    <a:pt x="948" y="419"/>
                  </a:lnTo>
                  <a:lnTo>
                    <a:pt x="952" y="461"/>
                  </a:lnTo>
                  <a:lnTo>
                    <a:pt x="952" y="503"/>
                  </a:lnTo>
                  <a:lnTo>
                    <a:pt x="948" y="545"/>
                  </a:lnTo>
                  <a:lnTo>
                    <a:pt x="941" y="586"/>
                  </a:lnTo>
                  <a:lnTo>
                    <a:pt x="929" y="626"/>
                  </a:lnTo>
                  <a:lnTo>
                    <a:pt x="914" y="666"/>
                  </a:lnTo>
                  <a:lnTo>
                    <a:pt x="895" y="704"/>
                  </a:lnTo>
                  <a:lnTo>
                    <a:pt x="874" y="740"/>
                  </a:lnTo>
                  <a:lnTo>
                    <a:pt x="849" y="774"/>
                  </a:lnTo>
                  <a:lnTo>
                    <a:pt x="821" y="805"/>
                  </a:lnTo>
                  <a:lnTo>
                    <a:pt x="791" y="835"/>
                  </a:lnTo>
                  <a:lnTo>
                    <a:pt x="758" y="860"/>
                  </a:lnTo>
                  <a:lnTo>
                    <a:pt x="722" y="883"/>
                  </a:lnTo>
                  <a:lnTo>
                    <a:pt x="685" y="903"/>
                  </a:lnTo>
                  <a:lnTo>
                    <a:pt x="646" y="920"/>
                  </a:lnTo>
                  <a:lnTo>
                    <a:pt x="606" y="933"/>
                  </a:lnTo>
                  <a:lnTo>
                    <a:pt x="566" y="942"/>
                  </a:lnTo>
                  <a:lnTo>
                    <a:pt x="524" y="948"/>
                  </a:lnTo>
                  <a:lnTo>
                    <a:pt x="481" y="950"/>
                  </a:lnTo>
                  <a:lnTo>
                    <a:pt x="439" y="948"/>
                  </a:lnTo>
                  <a:lnTo>
                    <a:pt x="398" y="942"/>
                  </a:lnTo>
                  <a:lnTo>
                    <a:pt x="357" y="933"/>
                  </a:lnTo>
                  <a:lnTo>
                    <a:pt x="317" y="920"/>
                  </a:lnTo>
                  <a:lnTo>
                    <a:pt x="278" y="903"/>
                  </a:lnTo>
                  <a:lnTo>
                    <a:pt x="241" y="884"/>
                  </a:lnTo>
                  <a:lnTo>
                    <a:pt x="205" y="861"/>
                  </a:lnTo>
                  <a:lnTo>
                    <a:pt x="172" y="835"/>
                  </a:lnTo>
                  <a:lnTo>
                    <a:pt x="142" y="805"/>
                  </a:lnTo>
                  <a:lnTo>
                    <a:pt x="114" y="774"/>
                  </a:lnTo>
                  <a:lnTo>
                    <a:pt x="89" y="740"/>
                  </a:lnTo>
                  <a:lnTo>
                    <a:pt x="68" y="704"/>
                  </a:lnTo>
                  <a:lnTo>
                    <a:pt x="49" y="666"/>
                  </a:lnTo>
                  <a:lnTo>
                    <a:pt x="34" y="628"/>
                  </a:lnTo>
                  <a:lnTo>
                    <a:pt x="22" y="586"/>
                  </a:lnTo>
                  <a:lnTo>
                    <a:pt x="15" y="545"/>
                  </a:lnTo>
                  <a:lnTo>
                    <a:pt x="11" y="504"/>
                  </a:lnTo>
                  <a:lnTo>
                    <a:pt x="11" y="462"/>
                  </a:lnTo>
                  <a:lnTo>
                    <a:pt x="14" y="420"/>
                  </a:lnTo>
                  <a:lnTo>
                    <a:pt x="21" y="379"/>
                  </a:lnTo>
                  <a:lnTo>
                    <a:pt x="32" y="338"/>
                  </a:lnTo>
                  <a:lnTo>
                    <a:pt x="47" y="299"/>
                  </a:lnTo>
                  <a:lnTo>
                    <a:pt x="65" y="260"/>
                  </a:lnTo>
                  <a:lnTo>
                    <a:pt x="86" y="224"/>
                  </a:lnTo>
                  <a:lnTo>
                    <a:pt x="110" y="189"/>
                  </a:lnTo>
                  <a:lnTo>
                    <a:pt x="137" y="158"/>
                  </a:lnTo>
                  <a:lnTo>
                    <a:pt x="168" y="128"/>
                  </a:lnTo>
                  <a:lnTo>
                    <a:pt x="201" y="102"/>
                  </a:lnTo>
                  <a:lnTo>
                    <a:pt x="236" y="79"/>
                  </a:lnTo>
                  <a:lnTo>
                    <a:pt x="272" y="59"/>
                  </a:lnTo>
                  <a:lnTo>
                    <a:pt x="312" y="42"/>
                  </a:lnTo>
                  <a:lnTo>
                    <a:pt x="351" y="28"/>
                  </a:lnTo>
                  <a:lnTo>
                    <a:pt x="392" y="19"/>
                  </a:lnTo>
                  <a:lnTo>
                    <a:pt x="434" y="12"/>
                  </a:lnTo>
                  <a:lnTo>
                    <a:pt x="476" y="9"/>
                  </a:lnTo>
                  <a:lnTo>
                    <a:pt x="486" y="10"/>
                  </a:lnTo>
                  <a:lnTo>
                    <a:pt x="486" y="0"/>
                  </a:lnTo>
                  <a:close/>
                </a:path>
              </a:pathLst>
            </a:cu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Oval 418"/>
            <p:cNvSpPr/>
            <p:nvPr/>
          </p:nvSpPr>
          <p:spPr>
            <a:xfrm>
              <a:off x="4084560" y="4076640"/>
              <a:ext cx="1522440" cy="1517760"/>
            </a:xfrm>
            <a:prstGeom prst="ellipse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Oval 419"/>
            <p:cNvSpPr/>
            <p:nvPr/>
          </p:nvSpPr>
          <p:spPr>
            <a:xfrm>
              <a:off x="4102200" y="4092480"/>
              <a:ext cx="1487520" cy="1486080"/>
            </a:xfrm>
            <a:prstGeom prst="ellipse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Line 420"/>
            <p:cNvSpPr/>
            <p:nvPr/>
          </p:nvSpPr>
          <p:spPr>
            <a:xfrm flipV="1">
              <a:off x="4856040" y="4076640"/>
              <a:ext cx="180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Rectangle 421"/>
            <p:cNvSpPr/>
            <p:nvPr/>
          </p:nvSpPr>
          <p:spPr>
            <a:xfrm>
              <a:off x="4613400" y="4718160"/>
              <a:ext cx="486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800" spc="-1" strike="noStrike">
                  <a:solidFill>
                    <a:srgbClr val="000000"/>
                  </a:solidFill>
                  <a:latin typeface="Arial"/>
                </a:rPr>
                <a:t>pH7FWG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Rectangle 422"/>
            <p:cNvSpPr/>
            <p:nvPr/>
          </p:nvSpPr>
          <p:spPr>
            <a:xfrm>
              <a:off x="4680000" y="4844880"/>
              <a:ext cx="366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</a:rPr>
                <a:t>12267 b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Freeform 423"/>
            <p:cNvSpPr/>
            <p:nvPr/>
          </p:nvSpPr>
          <p:spPr>
            <a:xfrm>
              <a:off x="4513320" y="4059360"/>
              <a:ext cx="249120" cy="134640"/>
            </a:xfrm>
            <a:custGeom>
              <a:avLst/>
              <a:gdLst>
                <a:gd name="textAreaLeft" fmla="*/ 0 w 249120"/>
                <a:gd name="textAreaRight" fmla="*/ 249480 w 249120"/>
                <a:gd name="textAreaTop" fmla="*/ 0 h 134640"/>
                <a:gd name="textAreaBottom" fmla="*/ 135000 h 134640"/>
              </a:gdLst>
              <a:ahLst/>
              <a:rect l="textAreaLeft" t="textAreaTop" r="textAreaRight" b="textAreaBottom"/>
              <a:pathLst>
                <a:path w="157" h="85">
                  <a:moveTo>
                    <a:pt x="151" y="0"/>
                  </a:moveTo>
                  <a:lnTo>
                    <a:pt x="108" y="7"/>
                  </a:lnTo>
                  <a:lnTo>
                    <a:pt x="65" y="18"/>
                  </a:lnTo>
                  <a:lnTo>
                    <a:pt x="24" y="33"/>
                  </a:lnTo>
                  <a:lnTo>
                    <a:pt x="21" y="34"/>
                  </a:lnTo>
                  <a:lnTo>
                    <a:pt x="16" y="19"/>
                  </a:lnTo>
                  <a:lnTo>
                    <a:pt x="0" y="65"/>
                  </a:lnTo>
                  <a:lnTo>
                    <a:pt x="43" y="85"/>
                  </a:lnTo>
                  <a:lnTo>
                    <a:pt x="36" y="70"/>
                  </a:lnTo>
                  <a:lnTo>
                    <a:pt x="75" y="56"/>
                  </a:lnTo>
                  <a:lnTo>
                    <a:pt x="114" y="46"/>
                  </a:lnTo>
                  <a:lnTo>
                    <a:pt x="154" y="38"/>
                  </a:lnTo>
                  <a:lnTo>
                    <a:pt x="157" y="39"/>
                  </a:lnTo>
                  <a:lnTo>
                    <a:pt x="151" y="0"/>
                  </a:lnTo>
                  <a:close/>
                </a:path>
              </a:pathLst>
            </a:custGeom>
            <a:solidFill>
              <a:srgbClr val="33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Arc 424"/>
            <p:cNvSpPr/>
            <p:nvPr/>
          </p:nvSpPr>
          <p:spPr>
            <a:xfrm>
              <a:off x="4546440" y="4059360"/>
              <a:ext cx="298440" cy="776160"/>
            </a:xfrm>
            <a:custGeom>
              <a:avLst/>
              <a:gdLst>
                <a:gd name="textAreaLeft" fmla="*/ 0 w 298440"/>
                <a:gd name="textAreaRight" fmla="*/ 298800 w 298440"/>
                <a:gd name="textAreaTop" fmla="*/ 0 h 776160"/>
                <a:gd name="textAreaBottom" fmla="*/ 776520 h 776160"/>
              </a:gdLst>
              <a:ahLst/>
              <a:rect l="textAreaLeft" t="textAreaTop" r="textAreaRight" b="textAreaBottom"/>
              <a:pathLst>
                <a:path fill="none" w="8234" h="21450">
                  <a:moveTo>
                    <a:pt x="-1" y="1480"/>
                  </a:moveTo>
                  <a:cubicBezTo>
                    <a:pt x="1821" y="729"/>
                    <a:pt x="3737" y="231"/>
                    <a:pt x="5694" y="-1"/>
                  </a:cubicBezTo>
                </a:path>
                <a:path stroke="0" w="8234" h="21450">
                  <a:moveTo>
                    <a:pt x="-1" y="1480"/>
                  </a:moveTo>
                  <a:cubicBezTo>
                    <a:pt x="1821" y="729"/>
                    <a:pt x="3737" y="231"/>
                    <a:pt x="5694" y="-1"/>
                  </a:cubicBezTo>
                  <a:lnTo>
                    <a:pt x="8234" y="21450"/>
                  </a:lnTo>
                  <a:lnTo>
                    <a:pt x="-1" y="148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Arc 425"/>
            <p:cNvSpPr/>
            <p:nvPr/>
          </p:nvSpPr>
          <p:spPr>
            <a:xfrm>
              <a:off x="4570560" y="4119480"/>
              <a:ext cx="274320" cy="716040"/>
            </a:xfrm>
            <a:custGeom>
              <a:avLst/>
              <a:gdLst>
                <a:gd name="textAreaLeft" fmla="*/ 0 w 274320"/>
                <a:gd name="textAreaRight" fmla="*/ 274680 w 274320"/>
                <a:gd name="textAreaTop" fmla="*/ 0 h 716040"/>
                <a:gd name="textAreaBottom" fmla="*/ 716400 h 716040"/>
              </a:gdLst>
              <a:ahLst/>
              <a:rect l="textAreaLeft" t="textAreaTop" r="textAreaRight" b="textAreaBottom"/>
              <a:pathLst>
                <a:path fill="none" w="8228" h="21458">
                  <a:moveTo>
                    <a:pt x="0" y="1486"/>
                  </a:moveTo>
                  <a:cubicBezTo>
                    <a:pt x="1840" y="728"/>
                    <a:pt x="3776" y="228"/>
                    <a:pt x="5754" y="0"/>
                  </a:cubicBezTo>
                </a:path>
                <a:path stroke="0" w="8228" h="21458">
                  <a:moveTo>
                    <a:pt x="0" y="1486"/>
                  </a:moveTo>
                  <a:cubicBezTo>
                    <a:pt x="1840" y="728"/>
                    <a:pt x="3776" y="228"/>
                    <a:pt x="5754" y="0"/>
                  </a:cubicBezTo>
                  <a:lnTo>
                    <a:pt x="8228" y="21458"/>
                  </a:lnTo>
                  <a:lnTo>
                    <a:pt x="0" y="1486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Line 426"/>
            <p:cNvSpPr/>
            <p:nvPr/>
          </p:nvSpPr>
          <p:spPr>
            <a:xfrm flipH="1" flipV="1">
              <a:off x="4753080" y="4059360"/>
              <a:ext cx="9360" cy="61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Freeform 427"/>
            <p:cNvSpPr/>
            <p:nvPr/>
          </p:nvSpPr>
          <p:spPr>
            <a:xfrm>
              <a:off x="4513320" y="4089240"/>
              <a:ext cx="68040" cy="10476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104760"/>
                <a:gd name="textAreaBottom" fmla="*/ 105120 h 104760"/>
              </a:gdLst>
              <a:ahLst/>
              <a:rect l="textAreaLeft" t="textAreaTop" r="textAreaRight" b="textAreaBottom"/>
              <a:pathLst>
                <a:path w="40" h="62">
                  <a:moveTo>
                    <a:pt x="34" y="48"/>
                  </a:moveTo>
                  <a:lnTo>
                    <a:pt x="40" y="62"/>
                  </a:lnTo>
                  <a:lnTo>
                    <a:pt x="0" y="43"/>
                  </a:lnTo>
                  <a:lnTo>
                    <a:pt x="15" y="0"/>
                  </a:lnTo>
                  <a:lnTo>
                    <a:pt x="20" y="1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Line 428"/>
            <p:cNvSpPr/>
            <p:nvPr/>
          </p:nvSpPr>
          <p:spPr>
            <a:xfrm flipV="1">
              <a:off x="4341960" y="4086000"/>
              <a:ext cx="282600" cy="468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Rectangle 429"/>
            <p:cNvSpPr/>
            <p:nvPr/>
          </p:nvSpPr>
          <p:spPr>
            <a:xfrm>
              <a:off x="4142880" y="4003560"/>
              <a:ext cx="266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Cm(R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Freeform 430"/>
            <p:cNvSpPr/>
            <p:nvPr/>
          </p:nvSpPr>
          <p:spPr>
            <a:xfrm>
              <a:off x="4311720" y="4205160"/>
              <a:ext cx="108000" cy="1098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09800"/>
                <a:gd name="textAreaBottom" fmla="*/ 110160 h 109800"/>
              </a:gdLst>
              <a:ahLst/>
              <a:rect l="textAreaLeft" t="textAreaTop" r="textAreaRight" b="textAreaBottom"/>
              <a:pathLst>
                <a:path w="68" h="69">
                  <a:moveTo>
                    <a:pt x="45" y="0"/>
                  </a:moveTo>
                  <a:lnTo>
                    <a:pt x="10" y="27"/>
                  </a:lnTo>
                  <a:lnTo>
                    <a:pt x="10" y="28"/>
                  </a:lnTo>
                  <a:lnTo>
                    <a:pt x="0" y="17"/>
                  </a:lnTo>
                  <a:lnTo>
                    <a:pt x="1" y="64"/>
                  </a:lnTo>
                  <a:lnTo>
                    <a:pt x="46" y="69"/>
                  </a:lnTo>
                  <a:lnTo>
                    <a:pt x="37" y="58"/>
                  </a:lnTo>
                  <a:lnTo>
                    <a:pt x="68" y="32"/>
                  </a:lnTo>
                  <a:lnTo>
                    <a:pt x="45" y="0"/>
                  </a:lnTo>
                  <a:close/>
                </a:path>
              </a:pathLst>
            </a:custGeom>
            <a:solidFill>
              <a:srgbClr val="33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Arc 431"/>
            <p:cNvSpPr/>
            <p:nvPr/>
          </p:nvSpPr>
          <p:spPr>
            <a:xfrm>
              <a:off x="4327560" y="4205160"/>
              <a:ext cx="517320" cy="630360"/>
            </a:xfrm>
            <a:custGeom>
              <a:avLst/>
              <a:gdLst>
                <a:gd name="textAreaLeft" fmla="*/ 0 w 517320"/>
                <a:gd name="textAreaRight" fmla="*/ 517680 w 517320"/>
                <a:gd name="textAreaTop" fmla="*/ 0 h 630360"/>
                <a:gd name="textAreaBottom" fmla="*/ 630720 h 630360"/>
              </a:gdLst>
              <a:ahLst/>
              <a:rect l="textAreaLeft" t="textAreaTop" r="textAreaRight" b="textAreaBottom"/>
              <a:pathLst>
                <a:path fill="none" w="14285" h="17433">
                  <a:moveTo>
                    <a:pt x="0" y="1231"/>
                  </a:moveTo>
                  <a:cubicBezTo>
                    <a:pt x="491" y="797"/>
                    <a:pt x="1002" y="386"/>
                    <a:pt x="1531" y="-1"/>
                  </a:cubicBezTo>
                </a:path>
                <a:path stroke="0" w="14285" h="17433">
                  <a:moveTo>
                    <a:pt x="0" y="1231"/>
                  </a:moveTo>
                  <a:cubicBezTo>
                    <a:pt x="491" y="797"/>
                    <a:pt x="1002" y="386"/>
                    <a:pt x="1531" y="-1"/>
                  </a:cubicBezTo>
                  <a:lnTo>
                    <a:pt x="14285" y="17433"/>
                  </a:lnTo>
                  <a:lnTo>
                    <a:pt x="0" y="123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Arc 432"/>
            <p:cNvSpPr/>
            <p:nvPr/>
          </p:nvSpPr>
          <p:spPr>
            <a:xfrm>
              <a:off x="4368960" y="4254480"/>
              <a:ext cx="475920" cy="581040"/>
            </a:xfrm>
            <a:custGeom>
              <a:avLst/>
              <a:gdLst>
                <a:gd name="textAreaLeft" fmla="*/ 0 w 475920"/>
                <a:gd name="textAreaRight" fmla="*/ 476280 w 475920"/>
                <a:gd name="textAreaTop" fmla="*/ 0 h 581040"/>
                <a:gd name="textAreaBottom" fmla="*/ 581400 h 581040"/>
              </a:gdLst>
              <a:ahLst/>
              <a:rect l="textAreaLeft" t="textAreaTop" r="textAreaRight" b="textAreaBottom"/>
              <a:pathLst>
                <a:path fill="none" w="14270" h="17424">
                  <a:moveTo>
                    <a:pt x="-1" y="1208"/>
                  </a:moveTo>
                  <a:cubicBezTo>
                    <a:pt x="483" y="783"/>
                    <a:pt x="985" y="380"/>
                    <a:pt x="1504" y="-1"/>
                  </a:cubicBezTo>
                </a:path>
                <a:path stroke="0" w="14270" h="17424">
                  <a:moveTo>
                    <a:pt x="-1" y="1208"/>
                  </a:moveTo>
                  <a:cubicBezTo>
                    <a:pt x="483" y="783"/>
                    <a:pt x="985" y="380"/>
                    <a:pt x="1504" y="-1"/>
                  </a:cubicBezTo>
                  <a:lnTo>
                    <a:pt x="14270" y="17424"/>
                  </a:lnTo>
                  <a:lnTo>
                    <a:pt x="-1" y="1208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Line 433"/>
            <p:cNvSpPr/>
            <p:nvPr/>
          </p:nvSpPr>
          <p:spPr>
            <a:xfrm flipH="1" flipV="1">
              <a:off x="4383000" y="4204800"/>
              <a:ext cx="36720" cy="50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Freeform 434"/>
            <p:cNvSpPr/>
            <p:nvPr/>
          </p:nvSpPr>
          <p:spPr>
            <a:xfrm>
              <a:off x="4311720" y="4232160"/>
              <a:ext cx="73080" cy="82800"/>
            </a:xfrm>
            <a:custGeom>
              <a:avLst/>
              <a:gdLst>
                <a:gd name="textAreaLeft" fmla="*/ 0 w 73080"/>
                <a:gd name="textAreaRight" fmla="*/ 73440 w 73080"/>
                <a:gd name="textAreaTop" fmla="*/ 0 h 82800"/>
                <a:gd name="textAreaBottom" fmla="*/ 83160 h 82800"/>
              </a:gdLst>
              <a:ahLst/>
              <a:rect l="textAreaLeft" t="textAreaTop" r="textAreaRight" b="textAreaBottom"/>
              <a:pathLst>
                <a:path w="44" h="50">
                  <a:moveTo>
                    <a:pt x="35" y="39"/>
                  </a:moveTo>
                  <a:lnTo>
                    <a:pt x="44" y="50"/>
                  </a:lnTo>
                  <a:lnTo>
                    <a:pt x="1" y="45"/>
                  </a:lnTo>
                  <a:lnTo>
                    <a:pt x="0" y="0"/>
                  </a:lnTo>
                  <a:lnTo>
                    <a:pt x="10" y="11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360" bIns="36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Line 435"/>
            <p:cNvSpPr/>
            <p:nvPr/>
          </p:nvSpPr>
          <p:spPr>
            <a:xfrm>
              <a:off x="4173480" y="4224240"/>
              <a:ext cx="160560" cy="1908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Rectangle 436"/>
            <p:cNvSpPr/>
            <p:nvPr/>
          </p:nvSpPr>
          <p:spPr>
            <a:xfrm>
              <a:off x="4011840" y="4137120"/>
              <a:ext cx="21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ccd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Freeform 437"/>
            <p:cNvSpPr/>
            <p:nvPr/>
          </p:nvSpPr>
          <p:spPr>
            <a:xfrm>
              <a:off x="4098960" y="4336920"/>
              <a:ext cx="191880" cy="260640"/>
            </a:xfrm>
            <a:custGeom>
              <a:avLst/>
              <a:gdLst>
                <a:gd name="textAreaLeft" fmla="*/ 0 w 191880"/>
                <a:gd name="textAreaRight" fmla="*/ 192240 w 191880"/>
                <a:gd name="textAreaTop" fmla="*/ 0 h 260640"/>
                <a:gd name="textAreaBottom" fmla="*/ 261000 h 260640"/>
              </a:gdLst>
              <a:ahLst/>
              <a:rect l="textAreaLeft" t="textAreaTop" r="textAreaRight" b="textAreaBottom"/>
              <a:pathLst>
                <a:path w="121" h="164">
                  <a:moveTo>
                    <a:pt x="91" y="0"/>
                  </a:moveTo>
                  <a:lnTo>
                    <a:pt x="64" y="35"/>
                  </a:lnTo>
                  <a:lnTo>
                    <a:pt x="41" y="73"/>
                  </a:lnTo>
                  <a:lnTo>
                    <a:pt x="21" y="112"/>
                  </a:lnTo>
                  <a:lnTo>
                    <a:pt x="14" y="128"/>
                  </a:lnTo>
                  <a:lnTo>
                    <a:pt x="0" y="121"/>
                  </a:lnTo>
                  <a:lnTo>
                    <a:pt x="22" y="164"/>
                  </a:lnTo>
                  <a:lnTo>
                    <a:pt x="65" y="149"/>
                  </a:lnTo>
                  <a:lnTo>
                    <a:pt x="50" y="142"/>
                  </a:lnTo>
                  <a:lnTo>
                    <a:pt x="67" y="105"/>
                  </a:lnTo>
                  <a:lnTo>
                    <a:pt x="88" y="70"/>
                  </a:lnTo>
                  <a:lnTo>
                    <a:pt x="111" y="37"/>
                  </a:lnTo>
                  <a:lnTo>
                    <a:pt x="121" y="24"/>
                  </a:lnTo>
                  <a:lnTo>
                    <a:pt x="91" y="0"/>
                  </a:lnTo>
                  <a:close/>
                </a:path>
              </a:pathLst>
            </a:custGeom>
            <a:solidFill>
              <a:srgbClr val="33ff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Arc 438"/>
            <p:cNvSpPr/>
            <p:nvPr/>
          </p:nvSpPr>
          <p:spPr>
            <a:xfrm>
              <a:off x="4119480" y="4335480"/>
              <a:ext cx="725400" cy="500040"/>
            </a:xfrm>
            <a:custGeom>
              <a:avLst/>
              <a:gdLst>
                <a:gd name="textAreaLeft" fmla="*/ 0 w 725400"/>
                <a:gd name="textAreaRight" fmla="*/ 725760 w 725400"/>
                <a:gd name="textAreaTop" fmla="*/ 0 h 500040"/>
                <a:gd name="textAreaBottom" fmla="*/ 500400 h 500040"/>
              </a:gdLst>
              <a:ahLst/>
              <a:rect l="textAreaLeft" t="textAreaTop" r="textAreaRight" b="textAreaBottom"/>
              <a:pathLst>
                <a:path fill="none" w="19994" h="13797">
                  <a:moveTo>
                    <a:pt x="-1" y="5624"/>
                  </a:moveTo>
                  <a:cubicBezTo>
                    <a:pt x="831" y="3588"/>
                    <a:pt x="1969" y="1692"/>
                    <a:pt x="3374" y="-1"/>
                  </a:cubicBezTo>
                </a:path>
                <a:path stroke="0" w="19994" h="13797">
                  <a:moveTo>
                    <a:pt x="-1" y="5624"/>
                  </a:moveTo>
                  <a:cubicBezTo>
                    <a:pt x="831" y="3588"/>
                    <a:pt x="1969" y="1692"/>
                    <a:pt x="3374" y="-1"/>
                  </a:cubicBezTo>
                  <a:lnTo>
                    <a:pt x="19994" y="13797"/>
                  </a:lnTo>
                  <a:lnTo>
                    <a:pt x="-1" y="5624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Arc 439"/>
            <p:cNvSpPr/>
            <p:nvPr/>
          </p:nvSpPr>
          <p:spPr>
            <a:xfrm>
              <a:off x="4178160" y="4375080"/>
              <a:ext cx="666720" cy="460440"/>
            </a:xfrm>
            <a:custGeom>
              <a:avLst/>
              <a:gdLst>
                <a:gd name="textAreaLeft" fmla="*/ 0 w 666720"/>
                <a:gd name="textAreaRight" fmla="*/ 667080 w 666720"/>
                <a:gd name="textAreaTop" fmla="*/ 0 h 460440"/>
                <a:gd name="textAreaBottom" fmla="*/ 460800 h 460440"/>
              </a:gdLst>
              <a:ahLst/>
              <a:rect l="textAreaLeft" t="textAreaTop" r="textAreaRight" b="textAreaBottom"/>
              <a:pathLst>
                <a:path fill="none" w="19982" h="13823">
                  <a:moveTo>
                    <a:pt x="-1" y="5621"/>
                  </a:moveTo>
                  <a:cubicBezTo>
                    <a:pt x="834" y="3586"/>
                    <a:pt x="1976" y="1690"/>
                    <a:pt x="3384" y="0"/>
                  </a:cubicBezTo>
                </a:path>
                <a:path stroke="0" w="19982" h="13823">
                  <a:moveTo>
                    <a:pt x="-1" y="5621"/>
                  </a:moveTo>
                  <a:cubicBezTo>
                    <a:pt x="834" y="3586"/>
                    <a:pt x="1976" y="1690"/>
                    <a:pt x="3384" y="0"/>
                  </a:cubicBezTo>
                  <a:lnTo>
                    <a:pt x="19982" y="13823"/>
                  </a:lnTo>
                  <a:lnTo>
                    <a:pt x="-1" y="562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Line 440"/>
            <p:cNvSpPr/>
            <p:nvPr/>
          </p:nvSpPr>
          <p:spPr>
            <a:xfrm flipH="1" flipV="1">
              <a:off x="4243320" y="4336920"/>
              <a:ext cx="4752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Freeform 441"/>
            <p:cNvSpPr/>
            <p:nvPr/>
          </p:nvSpPr>
          <p:spPr>
            <a:xfrm>
              <a:off x="4098960" y="4529160"/>
              <a:ext cx="103320" cy="68400"/>
            </a:xfrm>
            <a:custGeom>
              <a:avLst/>
              <a:gdLst>
                <a:gd name="textAreaLeft" fmla="*/ 0 w 103320"/>
                <a:gd name="textAreaRight" fmla="*/ 103680 w 103320"/>
                <a:gd name="textAreaTop" fmla="*/ 0 h 68400"/>
                <a:gd name="textAreaBottom" fmla="*/ 68760 h 68400"/>
              </a:gdLst>
              <a:ahLst/>
              <a:rect l="textAreaLeft" t="textAreaTop" r="textAreaRight" b="textAreaBottom"/>
              <a:pathLst>
                <a:path w="62" h="41">
                  <a:moveTo>
                    <a:pt x="48" y="20"/>
                  </a:moveTo>
                  <a:lnTo>
                    <a:pt x="62" y="26"/>
                  </a:lnTo>
                  <a:lnTo>
                    <a:pt x="21" y="41"/>
                  </a:lnTo>
                  <a:lnTo>
                    <a:pt x="0" y="0"/>
                  </a:lnTo>
                  <a:lnTo>
                    <a:pt x="14" y="6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960" bIns="21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Line 442"/>
            <p:cNvSpPr/>
            <p:nvPr/>
          </p:nvSpPr>
          <p:spPr>
            <a:xfrm flipV="1">
              <a:off x="4006800" y="4456080"/>
              <a:ext cx="155520" cy="3024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Rectangle 443"/>
            <p:cNvSpPr/>
            <p:nvPr/>
          </p:nvSpPr>
          <p:spPr>
            <a:xfrm>
              <a:off x="3858120" y="4398840"/>
              <a:ext cx="195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Egf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Freeform 444"/>
            <p:cNvSpPr/>
            <p:nvPr/>
          </p:nvSpPr>
          <p:spPr>
            <a:xfrm>
              <a:off x="4060800" y="4697280"/>
              <a:ext cx="236520" cy="644760"/>
            </a:xfrm>
            <a:custGeom>
              <a:avLst/>
              <a:gdLst>
                <a:gd name="textAreaLeft" fmla="*/ 0 w 236520"/>
                <a:gd name="textAreaRight" fmla="*/ 236880 w 236520"/>
                <a:gd name="textAreaTop" fmla="*/ 0 h 644760"/>
                <a:gd name="textAreaBottom" fmla="*/ 645120 h 644760"/>
              </a:gdLst>
              <a:ahLst/>
              <a:rect l="textAreaLeft" t="textAreaTop" r="textAreaRight" b="textAreaBottom"/>
              <a:pathLst>
                <a:path w="149" h="406">
                  <a:moveTo>
                    <a:pt x="9" y="0"/>
                  </a:moveTo>
                  <a:lnTo>
                    <a:pt x="2" y="43"/>
                  </a:lnTo>
                  <a:lnTo>
                    <a:pt x="0" y="87"/>
                  </a:lnTo>
                  <a:lnTo>
                    <a:pt x="2" y="131"/>
                  </a:lnTo>
                  <a:lnTo>
                    <a:pt x="8" y="175"/>
                  </a:lnTo>
                  <a:lnTo>
                    <a:pt x="17" y="219"/>
                  </a:lnTo>
                  <a:lnTo>
                    <a:pt x="31" y="261"/>
                  </a:lnTo>
                  <a:lnTo>
                    <a:pt x="49" y="301"/>
                  </a:lnTo>
                  <a:lnTo>
                    <a:pt x="69" y="341"/>
                  </a:lnTo>
                  <a:lnTo>
                    <a:pt x="93" y="378"/>
                  </a:lnTo>
                  <a:lnTo>
                    <a:pt x="107" y="394"/>
                  </a:lnTo>
                  <a:lnTo>
                    <a:pt x="94" y="404"/>
                  </a:lnTo>
                  <a:lnTo>
                    <a:pt x="142" y="406"/>
                  </a:lnTo>
                  <a:lnTo>
                    <a:pt x="149" y="361"/>
                  </a:lnTo>
                  <a:lnTo>
                    <a:pt x="138" y="370"/>
                  </a:lnTo>
                  <a:lnTo>
                    <a:pt x="113" y="338"/>
                  </a:lnTo>
                  <a:lnTo>
                    <a:pt x="92" y="302"/>
                  </a:lnTo>
                  <a:lnTo>
                    <a:pt x="75" y="265"/>
                  </a:lnTo>
                  <a:lnTo>
                    <a:pt x="62" y="227"/>
                  </a:lnTo>
                  <a:lnTo>
                    <a:pt x="50" y="188"/>
                  </a:lnTo>
                  <a:lnTo>
                    <a:pt x="44" y="147"/>
                  </a:lnTo>
                  <a:lnTo>
                    <a:pt x="40" y="107"/>
                  </a:lnTo>
                  <a:lnTo>
                    <a:pt x="40" y="66"/>
                  </a:lnTo>
                  <a:lnTo>
                    <a:pt x="44" y="26"/>
                  </a:lnTo>
                  <a:lnTo>
                    <a:pt x="48" y="6"/>
                  </a:lnTo>
                  <a:lnTo>
                    <a:pt x="9" y="0"/>
                  </a:lnTo>
                  <a:close/>
                </a:path>
              </a:pathLst>
            </a:custGeom>
            <a:solidFill>
              <a:srgbClr val="ffcc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Arc 445"/>
            <p:cNvSpPr/>
            <p:nvPr/>
          </p:nvSpPr>
          <p:spPr>
            <a:xfrm>
              <a:off x="4060800" y="4697280"/>
              <a:ext cx="784080" cy="625680"/>
            </a:xfrm>
            <a:custGeom>
              <a:avLst/>
              <a:gdLst>
                <a:gd name="textAreaLeft" fmla="*/ 0 w 784080"/>
                <a:gd name="textAreaRight" fmla="*/ 784440 w 784080"/>
                <a:gd name="textAreaTop" fmla="*/ 0 h 625680"/>
                <a:gd name="textAreaBottom" fmla="*/ 626040 h 625680"/>
              </a:gdLst>
              <a:ahLst/>
              <a:rect l="textAreaLeft" t="textAreaTop" r="textAreaRight" b="textAreaBottom"/>
              <a:pathLst>
                <a:path fill="none" w="21600" h="17262">
                  <a:moveTo>
                    <a:pt x="4691" y="17261"/>
                  </a:moveTo>
                  <a:cubicBezTo>
                    <a:pt x="1653" y="13440"/>
                    <a:pt x="0" y="8702"/>
                    <a:pt x="0" y="3821"/>
                  </a:cubicBezTo>
                  <a:cubicBezTo>
                    <a:pt x="-1" y="2539"/>
                    <a:pt x="114" y="1261"/>
                    <a:pt x="340" y="-1"/>
                  </a:cubicBezTo>
                </a:path>
                <a:path stroke="0" w="21600" h="17262">
                  <a:moveTo>
                    <a:pt x="4691" y="17261"/>
                  </a:moveTo>
                  <a:cubicBezTo>
                    <a:pt x="1653" y="13440"/>
                    <a:pt x="0" y="8702"/>
                    <a:pt x="0" y="3821"/>
                  </a:cubicBezTo>
                  <a:cubicBezTo>
                    <a:pt x="-1" y="2539"/>
                    <a:pt x="114" y="1261"/>
                    <a:pt x="340" y="-1"/>
                  </a:cubicBezTo>
                  <a:lnTo>
                    <a:pt x="21600" y="3821"/>
                  </a:lnTo>
                  <a:lnTo>
                    <a:pt x="4691" y="1726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Arc 446"/>
            <p:cNvSpPr/>
            <p:nvPr/>
          </p:nvSpPr>
          <p:spPr>
            <a:xfrm>
              <a:off x="4122720" y="4707000"/>
              <a:ext cx="722160" cy="577800"/>
            </a:xfrm>
            <a:custGeom>
              <a:avLst/>
              <a:gdLst/>
              <a:ahLst/>
              <a:rect l="l" t="t" r="r" b="b"/>
              <a:pathLst>
                <a:path fill="none" w="21600" h="17327">
                  <a:moveTo>
                    <a:pt x="4705" y="17327"/>
                  </a:moveTo>
                  <a:cubicBezTo>
                    <a:pt x="1659" y="13502"/>
                    <a:pt x="0" y="8757"/>
                    <a:pt x="0" y="3868"/>
                  </a:cubicBezTo>
                  <a:cubicBezTo>
                    <a:pt x="-1" y="2570"/>
                    <a:pt x="116" y="1276"/>
                    <a:pt x="349" y="0"/>
                  </a:cubicBezTo>
                </a:path>
                <a:path stroke="0" w="21600" h="17327">
                  <a:moveTo>
                    <a:pt x="4705" y="17327"/>
                  </a:moveTo>
                  <a:cubicBezTo>
                    <a:pt x="1659" y="13502"/>
                    <a:pt x="0" y="8757"/>
                    <a:pt x="0" y="3868"/>
                  </a:cubicBezTo>
                  <a:cubicBezTo>
                    <a:pt x="-1" y="2570"/>
                    <a:pt x="116" y="1276"/>
                    <a:pt x="349" y="0"/>
                  </a:cubicBezTo>
                  <a:lnTo>
                    <a:pt x="21600" y="3868"/>
                  </a:lnTo>
                  <a:lnTo>
                    <a:pt x="4705" y="17327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Line 447"/>
            <p:cNvSpPr/>
            <p:nvPr/>
          </p:nvSpPr>
          <p:spPr>
            <a:xfrm flipH="1" flipV="1">
              <a:off x="4075200" y="4696920"/>
              <a:ext cx="61920" cy="9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Freeform 448"/>
            <p:cNvSpPr/>
            <p:nvPr/>
          </p:nvSpPr>
          <p:spPr>
            <a:xfrm>
              <a:off x="4210200" y="5270400"/>
              <a:ext cx="87120" cy="7164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52" h="43">
                  <a:moveTo>
                    <a:pt x="41" y="9"/>
                  </a:moveTo>
                  <a:lnTo>
                    <a:pt x="52" y="0"/>
                  </a:lnTo>
                  <a:lnTo>
                    <a:pt x="45" y="43"/>
                  </a:lnTo>
                  <a:lnTo>
                    <a:pt x="0" y="41"/>
                  </a:lnTo>
                  <a:lnTo>
                    <a:pt x="12" y="32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0" bIns="25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Line 449"/>
            <p:cNvSpPr/>
            <p:nvPr/>
          </p:nvSpPr>
          <p:spPr>
            <a:xfrm flipV="1">
              <a:off x="3959280" y="5051520"/>
              <a:ext cx="131760" cy="792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Rectangle 450"/>
            <p:cNvSpPr/>
            <p:nvPr/>
          </p:nvSpPr>
          <p:spPr>
            <a:xfrm>
              <a:off x="3837240" y="5056200"/>
              <a:ext cx="16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Hyg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Freeform 451"/>
            <p:cNvSpPr/>
            <p:nvPr/>
          </p:nvSpPr>
          <p:spPr>
            <a:xfrm>
              <a:off x="4865760" y="4030560"/>
              <a:ext cx="392040" cy="190440"/>
            </a:xfrm>
            <a:custGeom>
              <a:avLst/>
              <a:gdLst>
                <a:gd name="textAreaLeft" fmla="*/ 0 w 392040"/>
                <a:gd name="textAreaRight" fmla="*/ 392400 w 392040"/>
                <a:gd name="textAreaTop" fmla="*/ 0 h 190440"/>
                <a:gd name="textAreaBottom" fmla="*/ 190800 h 190440"/>
              </a:gdLst>
              <a:ahLst/>
              <a:rect l="textAreaLeft" t="textAreaTop" r="textAreaRight" b="textAreaBottom"/>
              <a:pathLst>
                <a:path w="247" h="120">
                  <a:moveTo>
                    <a:pt x="247" y="87"/>
                  </a:moveTo>
                  <a:lnTo>
                    <a:pt x="209" y="66"/>
                  </a:lnTo>
                  <a:lnTo>
                    <a:pt x="168" y="48"/>
                  </a:lnTo>
                  <a:lnTo>
                    <a:pt x="126" y="33"/>
                  </a:lnTo>
                  <a:lnTo>
                    <a:pt x="83" y="24"/>
                  </a:lnTo>
                  <a:lnTo>
                    <a:pt x="39" y="16"/>
                  </a:lnTo>
                  <a:lnTo>
                    <a:pt x="33" y="16"/>
                  </a:lnTo>
                  <a:lnTo>
                    <a:pt x="34" y="0"/>
                  </a:lnTo>
                  <a:lnTo>
                    <a:pt x="0" y="34"/>
                  </a:lnTo>
                  <a:lnTo>
                    <a:pt x="29" y="71"/>
                  </a:lnTo>
                  <a:lnTo>
                    <a:pt x="30" y="55"/>
                  </a:lnTo>
                  <a:lnTo>
                    <a:pt x="70" y="60"/>
                  </a:lnTo>
                  <a:lnTo>
                    <a:pt x="110" y="69"/>
                  </a:lnTo>
                  <a:lnTo>
                    <a:pt x="149" y="82"/>
                  </a:lnTo>
                  <a:lnTo>
                    <a:pt x="186" y="97"/>
                  </a:lnTo>
                  <a:lnTo>
                    <a:pt x="223" y="117"/>
                  </a:lnTo>
                  <a:lnTo>
                    <a:pt x="227" y="120"/>
                  </a:lnTo>
                  <a:lnTo>
                    <a:pt x="247" y="87"/>
                  </a:lnTo>
                  <a:close/>
                </a:path>
              </a:pathLst>
            </a:custGeom>
            <a:solidFill>
              <a:srgbClr val="ff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Arc 452"/>
            <p:cNvSpPr/>
            <p:nvPr/>
          </p:nvSpPr>
          <p:spPr>
            <a:xfrm>
              <a:off x="4844880" y="4057560"/>
              <a:ext cx="411480" cy="777960"/>
            </a:xfrm>
            <a:custGeom>
              <a:avLst/>
              <a:gdLst>
                <a:gd name="textAreaLeft" fmla="*/ 0 w 411480"/>
                <a:gd name="textAreaRight" fmla="*/ 411840 w 411480"/>
                <a:gd name="textAreaTop" fmla="*/ 0 h 777960"/>
                <a:gd name="textAreaBottom" fmla="*/ 778320 h 777960"/>
              </a:gdLst>
              <a:ahLst/>
              <a:rect l="textAreaLeft" t="textAreaTop" r="textAreaRight" b="textAreaBottom"/>
              <a:pathLst>
                <a:path fill="none" w="11353" h="21506">
                  <a:moveTo>
                    <a:pt x="2011" y="-1"/>
                  </a:moveTo>
                  <a:cubicBezTo>
                    <a:pt x="5324" y="309"/>
                    <a:pt x="8521" y="1380"/>
                    <a:pt x="11352" y="3130"/>
                  </a:cubicBezTo>
                </a:path>
                <a:path stroke="0" w="11353" h="21506">
                  <a:moveTo>
                    <a:pt x="2011" y="-1"/>
                  </a:moveTo>
                  <a:cubicBezTo>
                    <a:pt x="5324" y="309"/>
                    <a:pt x="8521" y="1380"/>
                    <a:pt x="11352" y="3130"/>
                  </a:cubicBezTo>
                  <a:lnTo>
                    <a:pt x="0" y="21506"/>
                  </a:lnTo>
                  <a:lnTo>
                    <a:pt x="2011" y="-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Arc 453"/>
            <p:cNvSpPr/>
            <p:nvPr/>
          </p:nvSpPr>
          <p:spPr>
            <a:xfrm>
              <a:off x="4844880" y="4119480"/>
              <a:ext cx="379440" cy="716040"/>
            </a:xfrm>
            <a:custGeom>
              <a:avLst/>
              <a:gdLst>
                <a:gd name="textAreaLeft" fmla="*/ 0 w 379440"/>
                <a:gd name="textAreaRight" fmla="*/ 379800 w 379440"/>
                <a:gd name="textAreaTop" fmla="*/ 0 h 716040"/>
                <a:gd name="textAreaBottom" fmla="*/ 716400 h 716040"/>
              </a:gdLst>
              <a:ahLst/>
              <a:rect l="textAreaLeft" t="textAreaTop" r="textAreaRight" b="textAreaBottom"/>
              <a:pathLst>
                <a:path fill="none" w="11366" h="21503">
                  <a:moveTo>
                    <a:pt x="2041" y="-1"/>
                  </a:moveTo>
                  <a:cubicBezTo>
                    <a:pt x="5349" y="313"/>
                    <a:pt x="8540" y="1386"/>
                    <a:pt x="11365" y="3135"/>
                  </a:cubicBezTo>
                </a:path>
                <a:path stroke="0" w="11366" h="21503">
                  <a:moveTo>
                    <a:pt x="2041" y="-1"/>
                  </a:moveTo>
                  <a:cubicBezTo>
                    <a:pt x="5349" y="313"/>
                    <a:pt x="8540" y="1386"/>
                    <a:pt x="11365" y="3135"/>
                  </a:cubicBezTo>
                  <a:lnTo>
                    <a:pt x="0" y="21503"/>
                  </a:lnTo>
                  <a:lnTo>
                    <a:pt x="2041" y="-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Line 454"/>
            <p:cNvSpPr/>
            <p:nvPr/>
          </p:nvSpPr>
          <p:spPr>
            <a:xfrm flipV="1">
              <a:off x="5226120" y="4168440"/>
              <a:ext cx="31680" cy="52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Freeform 455"/>
            <p:cNvSpPr/>
            <p:nvPr/>
          </p:nvSpPr>
          <p:spPr>
            <a:xfrm>
              <a:off x="4865760" y="4030560"/>
              <a:ext cx="54000" cy="112680"/>
            </a:xfrm>
            <a:custGeom>
              <a:avLst/>
              <a:gdLst>
                <a:gd name="textAreaLeft" fmla="*/ 0 w 54000"/>
                <a:gd name="textAreaRight" fmla="*/ 54360 w 5400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32" h="67">
                  <a:moveTo>
                    <a:pt x="28" y="52"/>
                  </a:moveTo>
                  <a:lnTo>
                    <a:pt x="27" y="67"/>
                  </a:lnTo>
                  <a:lnTo>
                    <a:pt x="0" y="32"/>
                  </a:lnTo>
                  <a:lnTo>
                    <a:pt x="32" y="0"/>
                  </a:lnTo>
                  <a:lnTo>
                    <a:pt x="31" y="15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Line 456"/>
            <p:cNvSpPr/>
            <p:nvPr/>
          </p:nvSpPr>
          <p:spPr>
            <a:xfrm flipH="1">
              <a:off x="5070240" y="3960720"/>
              <a:ext cx="106200" cy="12384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Rectangle 457"/>
            <p:cNvSpPr/>
            <p:nvPr/>
          </p:nvSpPr>
          <p:spPr>
            <a:xfrm>
              <a:off x="5169960" y="3873600"/>
              <a:ext cx="21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p35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Freeform 458"/>
            <p:cNvSpPr/>
            <p:nvPr/>
          </p:nvSpPr>
          <p:spPr>
            <a:xfrm>
              <a:off x="4078440" y="4587840"/>
              <a:ext cx="83880" cy="100080"/>
            </a:xfrm>
            <a:custGeom>
              <a:avLst/>
              <a:gdLst>
                <a:gd name="textAreaLeft" fmla="*/ 0 w 83880"/>
                <a:gd name="textAreaRight" fmla="*/ 84240 w 83880"/>
                <a:gd name="textAreaTop" fmla="*/ 0 h 100080"/>
                <a:gd name="textAreaBottom" fmla="*/ 100440 h 100080"/>
              </a:gdLst>
              <a:ahLst/>
              <a:rect l="textAreaLeft" t="textAreaTop" r="textAreaRight" b="textAreaBottom"/>
              <a:pathLst>
                <a:path w="53" h="63">
                  <a:moveTo>
                    <a:pt x="16" y="0"/>
                  </a:moveTo>
                  <a:lnTo>
                    <a:pt x="3" y="43"/>
                  </a:lnTo>
                  <a:lnTo>
                    <a:pt x="0" y="56"/>
                  </a:lnTo>
                  <a:lnTo>
                    <a:pt x="39" y="63"/>
                  </a:lnTo>
                  <a:lnTo>
                    <a:pt x="48" y="24"/>
                  </a:lnTo>
                  <a:lnTo>
                    <a:pt x="53" y="13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ff66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Arc 459"/>
            <p:cNvSpPr/>
            <p:nvPr/>
          </p:nvSpPr>
          <p:spPr>
            <a:xfrm>
              <a:off x="4078440" y="4587840"/>
              <a:ext cx="766440" cy="247680"/>
            </a:xfrm>
            <a:custGeom>
              <a:avLst/>
              <a:gdLst>
                <a:gd name="textAreaLeft" fmla="*/ 0 w 766440"/>
                <a:gd name="textAreaRight" fmla="*/ 766800 w 766440"/>
                <a:gd name="textAreaTop" fmla="*/ 0 h 247680"/>
                <a:gd name="textAreaBottom" fmla="*/ 248040 h 247680"/>
              </a:gdLst>
              <a:ahLst/>
              <a:rect l="textAreaLeft" t="textAreaTop" r="textAreaRight" b="textAreaBottom"/>
              <a:pathLst>
                <a:path fill="none" w="21150" h="6856">
                  <a:moveTo>
                    <a:pt x="0" y="2468"/>
                  </a:moveTo>
                  <a:cubicBezTo>
                    <a:pt x="173" y="1632"/>
                    <a:pt x="396" y="808"/>
                    <a:pt x="666" y="-1"/>
                  </a:cubicBezTo>
                </a:path>
                <a:path stroke="0" w="21150" h="6856">
                  <a:moveTo>
                    <a:pt x="0" y="2468"/>
                  </a:moveTo>
                  <a:cubicBezTo>
                    <a:pt x="173" y="1632"/>
                    <a:pt x="396" y="808"/>
                    <a:pt x="666" y="-1"/>
                  </a:cubicBezTo>
                  <a:lnTo>
                    <a:pt x="21150" y="6856"/>
                  </a:lnTo>
                  <a:lnTo>
                    <a:pt x="0" y="2468"/>
                  </a:lnTo>
                  <a:close/>
                </a:path>
              </a:pathLst>
            </a:cu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Arc 460"/>
            <p:cNvSpPr/>
            <p:nvPr/>
          </p:nvSpPr>
          <p:spPr>
            <a:xfrm>
              <a:off x="4138560" y="4608360"/>
              <a:ext cx="706320" cy="227160"/>
            </a:xfrm>
            <a:custGeom>
              <a:avLst/>
              <a:gdLst>
                <a:gd name="textAreaLeft" fmla="*/ 0 w 706320"/>
                <a:gd name="textAreaRight" fmla="*/ 706680 w 706320"/>
                <a:gd name="textAreaTop" fmla="*/ 0 h 227160"/>
                <a:gd name="textAreaBottom" fmla="*/ 227520 h 227160"/>
              </a:gdLst>
              <a:ahLst/>
              <a:rect l="textAreaLeft" t="textAreaTop" r="textAreaRight" b="textAreaBottom"/>
              <a:pathLst>
                <a:path fill="none" w="21139" h="6830">
                  <a:moveTo>
                    <a:pt x="-1" y="2391"/>
                  </a:moveTo>
                  <a:cubicBezTo>
                    <a:pt x="169" y="1582"/>
                    <a:pt x="385" y="784"/>
                    <a:pt x="647" y="0"/>
                  </a:cubicBezTo>
                </a:path>
                <a:path stroke="0" w="21139" h="6830">
                  <a:moveTo>
                    <a:pt x="-1" y="2391"/>
                  </a:moveTo>
                  <a:cubicBezTo>
                    <a:pt x="169" y="1582"/>
                    <a:pt x="385" y="784"/>
                    <a:pt x="647" y="0"/>
                  </a:cubicBezTo>
                  <a:lnTo>
                    <a:pt x="21139" y="6830"/>
                  </a:lnTo>
                  <a:lnTo>
                    <a:pt x="-1" y="2391"/>
                  </a:lnTo>
                  <a:close/>
                </a:path>
              </a:pathLst>
            </a:cu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Line 461"/>
            <p:cNvSpPr/>
            <p:nvPr/>
          </p:nvSpPr>
          <p:spPr>
            <a:xfrm flipH="1" flipV="1">
              <a:off x="4103280" y="4587480"/>
              <a:ext cx="58680" cy="20520"/>
            </a:xfrm>
            <a:prstGeom prst="line">
              <a:avLst/>
            </a:prstGeom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Line 462"/>
            <p:cNvSpPr/>
            <p:nvPr/>
          </p:nvSpPr>
          <p:spPr>
            <a:xfrm flipH="1" flipV="1">
              <a:off x="4078440" y="4676400"/>
              <a:ext cx="61920" cy="11160"/>
            </a:xfrm>
            <a:prstGeom prst="line">
              <a:avLst/>
            </a:prstGeom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Line 463"/>
            <p:cNvSpPr/>
            <p:nvPr/>
          </p:nvSpPr>
          <p:spPr>
            <a:xfrm>
              <a:off x="3951360" y="4618080"/>
              <a:ext cx="137880" cy="1260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Rectangle 464"/>
            <p:cNvSpPr/>
            <p:nvPr/>
          </p:nvSpPr>
          <p:spPr>
            <a:xfrm>
              <a:off x="3790440" y="4530600"/>
              <a:ext cx="21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T35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Freeform 465"/>
            <p:cNvSpPr/>
            <p:nvPr/>
          </p:nvSpPr>
          <p:spPr>
            <a:xfrm>
              <a:off x="4797360" y="4052880"/>
              <a:ext cx="49320" cy="63360"/>
            </a:xfrm>
            <a:custGeom>
              <a:avLst/>
              <a:gdLst>
                <a:gd name="textAreaLeft" fmla="*/ 0 w 49320"/>
                <a:gd name="textAreaRight" fmla="*/ 49680 w 49320"/>
                <a:gd name="textAreaTop" fmla="*/ 0 h 63360"/>
                <a:gd name="textAreaBottom" fmla="*/ 63720 h 63360"/>
              </a:gdLst>
              <a:ahLst/>
              <a:rect l="textAreaLeft" t="textAreaTop" r="textAreaRight" b="textAreaBottom"/>
              <a:pathLst>
                <a:path w="31" h="40">
                  <a:moveTo>
                    <a:pt x="31" y="0"/>
                  </a:moveTo>
                  <a:lnTo>
                    <a:pt x="0" y="1"/>
                  </a:lnTo>
                  <a:lnTo>
                    <a:pt x="3" y="40"/>
                  </a:lnTo>
                  <a:lnTo>
                    <a:pt x="31" y="39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Arc 466"/>
            <p:cNvSpPr/>
            <p:nvPr/>
          </p:nvSpPr>
          <p:spPr>
            <a:xfrm>
              <a:off x="4797360" y="4052880"/>
              <a:ext cx="49320" cy="782640"/>
            </a:xfrm>
            <a:custGeom>
              <a:avLst/>
              <a:gdLst>
                <a:gd name="textAreaLeft" fmla="*/ 0 w 49320"/>
                <a:gd name="textAreaRight" fmla="*/ 49680 w 49320"/>
                <a:gd name="textAreaTop" fmla="*/ 0 h 782640"/>
                <a:gd name="textAreaBottom" fmla="*/ 783000 h 782640"/>
              </a:gdLst>
              <a:ahLst/>
              <a:rect l="textAreaLeft" t="textAreaTop" r="textAreaRight" b="textAreaBottom"/>
              <a:pathLst>
                <a:path fill="none" w="1356" h="21600">
                  <a:moveTo>
                    <a:pt x="-1" y="39"/>
                  </a:moveTo>
                  <a:cubicBezTo>
                    <a:pt x="436" y="13"/>
                    <a:pt x="874" y="-1"/>
                    <a:pt x="1312" y="0"/>
                  </a:cubicBezTo>
                  <a:cubicBezTo>
                    <a:pt x="1326" y="0"/>
                    <a:pt x="1341" y="0"/>
                    <a:pt x="1355" y="0"/>
                  </a:cubicBezTo>
                </a:path>
                <a:path stroke="0" w="1356" h="21600">
                  <a:moveTo>
                    <a:pt x="-1" y="39"/>
                  </a:moveTo>
                  <a:cubicBezTo>
                    <a:pt x="436" y="13"/>
                    <a:pt x="874" y="-1"/>
                    <a:pt x="1312" y="0"/>
                  </a:cubicBezTo>
                  <a:cubicBezTo>
                    <a:pt x="1326" y="0"/>
                    <a:pt x="1341" y="0"/>
                    <a:pt x="1355" y="0"/>
                  </a:cubicBezTo>
                  <a:lnTo>
                    <a:pt x="1312" y="21600"/>
                  </a:lnTo>
                  <a:lnTo>
                    <a:pt x="-1" y="39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Arc 467"/>
            <p:cNvSpPr/>
            <p:nvPr/>
          </p:nvSpPr>
          <p:spPr>
            <a:xfrm>
              <a:off x="4802040" y="4114800"/>
              <a:ext cx="44640" cy="720720"/>
            </a:xfrm>
            <a:custGeom>
              <a:avLst/>
              <a:gdLst>
                <a:gd name="textAreaLeft" fmla="*/ 0 w 44640"/>
                <a:gd name="textAreaRight" fmla="*/ 45000 w 44640"/>
                <a:gd name="textAreaTop" fmla="*/ 0 h 720720"/>
                <a:gd name="textAreaBottom" fmla="*/ 721080 h 720720"/>
              </a:gdLst>
              <a:ahLst/>
              <a:rect l="textAreaLeft" t="textAreaTop" r="textAreaRight" b="textAreaBottom"/>
              <a:pathLst>
                <a:path fill="none" w="1329" h="21600">
                  <a:moveTo>
                    <a:pt x="0" y="38"/>
                  </a:moveTo>
                  <a:cubicBezTo>
                    <a:pt x="426" y="12"/>
                    <a:pt x="854" y="-1"/>
                    <a:pt x="1282" y="0"/>
                  </a:cubicBezTo>
                  <a:cubicBezTo>
                    <a:pt x="1297" y="0"/>
                    <a:pt x="1313" y="0"/>
                    <a:pt x="1328" y="0"/>
                  </a:cubicBezTo>
                </a:path>
                <a:path stroke="0" w="1329" h="21600">
                  <a:moveTo>
                    <a:pt x="0" y="38"/>
                  </a:moveTo>
                  <a:cubicBezTo>
                    <a:pt x="426" y="12"/>
                    <a:pt x="854" y="-1"/>
                    <a:pt x="1282" y="0"/>
                  </a:cubicBezTo>
                  <a:cubicBezTo>
                    <a:pt x="1297" y="0"/>
                    <a:pt x="1313" y="0"/>
                    <a:pt x="1328" y="0"/>
                  </a:cubicBezTo>
                  <a:lnTo>
                    <a:pt x="1282" y="21600"/>
                  </a:lnTo>
                  <a:lnTo>
                    <a:pt x="0" y="38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Line 468"/>
            <p:cNvSpPr/>
            <p:nvPr/>
          </p:nvSpPr>
          <p:spPr>
            <a:xfrm flipV="1">
              <a:off x="4846680" y="4052880"/>
              <a:ext cx="1440" cy="61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Line 469"/>
            <p:cNvSpPr/>
            <p:nvPr/>
          </p:nvSpPr>
          <p:spPr>
            <a:xfrm flipH="1" flipV="1">
              <a:off x="4797000" y="4054320"/>
              <a:ext cx="4680" cy="61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Line 470"/>
            <p:cNvSpPr/>
            <p:nvPr/>
          </p:nvSpPr>
          <p:spPr>
            <a:xfrm>
              <a:off x="4745160" y="3960720"/>
              <a:ext cx="77760" cy="9360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Rectangle 471"/>
            <p:cNvSpPr/>
            <p:nvPr/>
          </p:nvSpPr>
          <p:spPr>
            <a:xfrm>
              <a:off x="4583520" y="3873600"/>
              <a:ext cx="22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attR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Freeform 472"/>
            <p:cNvSpPr/>
            <p:nvPr/>
          </p:nvSpPr>
          <p:spPr>
            <a:xfrm>
              <a:off x="4245120" y="4297320"/>
              <a:ext cx="79200" cy="76320"/>
            </a:xfrm>
            <a:custGeom>
              <a:avLst/>
              <a:gdLst>
                <a:gd name="textAreaLeft" fmla="*/ 0 w 79200"/>
                <a:gd name="textAreaRight" fmla="*/ 79560 w 79200"/>
                <a:gd name="textAreaTop" fmla="*/ 0 h 76320"/>
                <a:gd name="textAreaBottom" fmla="*/ 76680 h 76320"/>
              </a:gdLst>
              <a:ahLst/>
              <a:rect l="textAreaLeft" t="textAreaTop" r="textAreaRight" b="textAreaBottom"/>
              <a:pathLst>
                <a:path w="50" h="48">
                  <a:moveTo>
                    <a:pt x="22" y="0"/>
                  </a:moveTo>
                  <a:lnTo>
                    <a:pt x="0" y="23"/>
                  </a:lnTo>
                  <a:lnTo>
                    <a:pt x="30" y="48"/>
                  </a:lnTo>
                  <a:lnTo>
                    <a:pt x="50" y="27"/>
                  </a:lnTo>
                  <a:lnTo>
                    <a:pt x="22" y="0"/>
                  </a:lnTo>
                  <a:close/>
                </a:path>
              </a:pathLst>
            </a:cu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Arc 473"/>
            <p:cNvSpPr/>
            <p:nvPr/>
          </p:nvSpPr>
          <p:spPr>
            <a:xfrm>
              <a:off x="4245120" y="4295880"/>
              <a:ext cx="599760" cy="539640"/>
            </a:xfrm>
            <a:custGeom>
              <a:avLst/>
              <a:gdLst>
                <a:gd name="textAreaLeft" fmla="*/ 0 w 599760"/>
                <a:gd name="textAreaRight" fmla="*/ 600120 w 599760"/>
                <a:gd name="textAreaTop" fmla="*/ 0 h 539640"/>
                <a:gd name="textAreaBottom" fmla="*/ 540000 h 539640"/>
              </a:gdLst>
              <a:ahLst/>
              <a:rect l="textAreaLeft" t="textAreaTop" r="textAreaRight" b="textAreaBottom"/>
              <a:pathLst>
                <a:path fill="none" w="16558" h="14911">
                  <a:moveTo>
                    <a:pt x="-1" y="1040"/>
                  </a:moveTo>
                  <a:cubicBezTo>
                    <a:pt x="298" y="683"/>
                    <a:pt x="609" y="336"/>
                    <a:pt x="930" y="-1"/>
                  </a:cubicBezTo>
                </a:path>
                <a:path stroke="0" w="16558" h="14911">
                  <a:moveTo>
                    <a:pt x="-1" y="1040"/>
                  </a:moveTo>
                  <a:cubicBezTo>
                    <a:pt x="298" y="683"/>
                    <a:pt x="609" y="336"/>
                    <a:pt x="930" y="-1"/>
                  </a:cubicBezTo>
                  <a:lnTo>
                    <a:pt x="16558" y="14911"/>
                  </a:lnTo>
                  <a:lnTo>
                    <a:pt x="-1" y="104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Arc 474"/>
            <p:cNvSpPr/>
            <p:nvPr/>
          </p:nvSpPr>
          <p:spPr>
            <a:xfrm>
              <a:off x="4292640" y="4338720"/>
              <a:ext cx="552240" cy="496800"/>
            </a:xfrm>
            <a:custGeom>
              <a:avLst/>
              <a:gdLst>
                <a:gd name="textAreaLeft" fmla="*/ 0 w 552240"/>
                <a:gd name="textAreaRight" fmla="*/ 552600 w 552240"/>
                <a:gd name="textAreaTop" fmla="*/ 0 h 496800"/>
                <a:gd name="textAreaBottom" fmla="*/ 497160 h 496800"/>
              </a:gdLst>
              <a:ahLst/>
              <a:rect l="textAreaLeft" t="textAreaTop" r="textAreaRight" b="textAreaBottom"/>
              <a:pathLst>
                <a:path fill="none" w="16555" h="14904">
                  <a:moveTo>
                    <a:pt x="-1" y="1029"/>
                  </a:moveTo>
                  <a:cubicBezTo>
                    <a:pt x="295" y="676"/>
                    <a:pt x="602" y="333"/>
                    <a:pt x="920" y="-1"/>
                  </a:cubicBezTo>
                </a:path>
                <a:path stroke="0" w="16555" h="14904">
                  <a:moveTo>
                    <a:pt x="-1" y="1029"/>
                  </a:moveTo>
                  <a:cubicBezTo>
                    <a:pt x="295" y="676"/>
                    <a:pt x="602" y="333"/>
                    <a:pt x="920" y="-1"/>
                  </a:cubicBezTo>
                  <a:lnTo>
                    <a:pt x="16555" y="14904"/>
                  </a:lnTo>
                  <a:lnTo>
                    <a:pt x="-1" y="1029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Line 475"/>
            <p:cNvSpPr/>
            <p:nvPr/>
          </p:nvSpPr>
          <p:spPr>
            <a:xfrm flipH="1" flipV="1">
              <a:off x="4279680" y="4296960"/>
              <a:ext cx="44280" cy="4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Line 476"/>
            <p:cNvSpPr/>
            <p:nvPr/>
          </p:nvSpPr>
          <p:spPr>
            <a:xfrm flipH="1" flipV="1">
              <a:off x="4245120" y="4334040"/>
              <a:ext cx="47520" cy="39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Line 477"/>
            <p:cNvSpPr/>
            <p:nvPr/>
          </p:nvSpPr>
          <p:spPr>
            <a:xfrm flipV="1">
              <a:off x="4071960" y="4314960"/>
              <a:ext cx="190440" cy="4104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Rectangle 478"/>
            <p:cNvSpPr/>
            <p:nvPr/>
          </p:nvSpPr>
          <p:spPr>
            <a:xfrm>
              <a:off x="3910320" y="4268880"/>
              <a:ext cx="22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attR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Freeform 479"/>
            <p:cNvSpPr/>
            <p:nvPr/>
          </p:nvSpPr>
          <p:spPr>
            <a:xfrm>
              <a:off x="4264200" y="5321160"/>
              <a:ext cx="136440" cy="135000"/>
            </a:xfrm>
            <a:custGeom>
              <a:avLst/>
              <a:gdLst>
                <a:gd name="textAreaLeft" fmla="*/ 0 w 136440"/>
                <a:gd name="textAreaRight" fmla="*/ 136800 w 136440"/>
                <a:gd name="textAreaTop" fmla="*/ 0 h 135000"/>
                <a:gd name="textAreaBottom" fmla="*/ 135360 h 135000"/>
              </a:gdLst>
              <a:ahLst/>
              <a:rect l="textAreaLeft" t="textAreaTop" r="textAreaRight" b="textAreaBottom"/>
              <a:pathLst>
                <a:path w="86" h="85">
                  <a:moveTo>
                    <a:pt x="0" y="27"/>
                  </a:moveTo>
                  <a:lnTo>
                    <a:pt x="31" y="58"/>
                  </a:lnTo>
                  <a:lnTo>
                    <a:pt x="61" y="85"/>
                  </a:lnTo>
                  <a:lnTo>
                    <a:pt x="86" y="53"/>
                  </a:lnTo>
                  <a:lnTo>
                    <a:pt x="55" y="27"/>
                  </a:lnTo>
                  <a:lnTo>
                    <a:pt x="29" y="0"/>
                  </a:lnTo>
                  <a:lnTo>
                    <a:pt x="0" y="27"/>
                  </a:lnTo>
                  <a:close/>
                </a:path>
              </a:pathLst>
            </a:custGeom>
            <a:solidFill>
              <a:srgbClr val="cccc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Arc 480"/>
            <p:cNvSpPr/>
            <p:nvPr/>
          </p:nvSpPr>
          <p:spPr>
            <a:xfrm>
              <a:off x="4265640" y="4835520"/>
              <a:ext cx="579240" cy="617400"/>
            </a:xfrm>
            <a:custGeom>
              <a:avLst/>
              <a:gdLst>
                <a:gd name="textAreaLeft" fmla="*/ 0 w 579240"/>
                <a:gd name="textAreaRight" fmla="*/ 579600 w 579240"/>
                <a:gd name="textAreaTop" fmla="*/ 0 h 617400"/>
                <a:gd name="textAreaBottom" fmla="*/ 617760 h 617400"/>
              </a:gdLst>
              <a:ahLst/>
              <a:rect l="textAreaLeft" t="textAreaTop" r="textAreaRight" b="textAreaBottom"/>
              <a:pathLst>
                <a:path fill="none" w="15962" h="17044">
                  <a:moveTo>
                    <a:pt x="2693" y="17044"/>
                  </a:moveTo>
                  <a:cubicBezTo>
                    <a:pt x="1726" y="16291"/>
                    <a:pt x="825" y="15457"/>
                    <a:pt x="-1" y="14552"/>
                  </a:cubicBezTo>
                </a:path>
                <a:path stroke="0" w="15962" h="17044">
                  <a:moveTo>
                    <a:pt x="2693" y="17044"/>
                  </a:moveTo>
                  <a:cubicBezTo>
                    <a:pt x="1726" y="16291"/>
                    <a:pt x="825" y="15457"/>
                    <a:pt x="-1" y="14552"/>
                  </a:cubicBezTo>
                  <a:lnTo>
                    <a:pt x="15962" y="0"/>
                  </a:lnTo>
                  <a:lnTo>
                    <a:pt x="2693" y="17044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Arc 481"/>
            <p:cNvSpPr/>
            <p:nvPr/>
          </p:nvSpPr>
          <p:spPr>
            <a:xfrm>
              <a:off x="4311720" y="4835520"/>
              <a:ext cx="533160" cy="568440"/>
            </a:xfrm>
            <a:custGeom>
              <a:avLst/>
              <a:gdLst>
                <a:gd name="textAreaLeft" fmla="*/ 0 w 533160"/>
                <a:gd name="textAreaRight" fmla="*/ 533520 w 533160"/>
                <a:gd name="textAreaTop" fmla="*/ 0 h 568440"/>
                <a:gd name="textAreaBottom" fmla="*/ 568800 h 568440"/>
              </a:gdLst>
              <a:ahLst/>
              <a:rect l="textAreaLeft" t="textAreaTop" r="textAreaRight" b="textAreaBottom"/>
              <a:pathLst>
                <a:path fill="none" w="15975" h="17046">
                  <a:moveTo>
                    <a:pt x="2708" y="17046"/>
                  </a:moveTo>
                  <a:cubicBezTo>
                    <a:pt x="1735" y="16288"/>
                    <a:pt x="829" y="15449"/>
                    <a:pt x="-1" y="14538"/>
                  </a:cubicBezTo>
                </a:path>
                <a:path stroke="0" w="15975" h="17046">
                  <a:moveTo>
                    <a:pt x="2708" y="17046"/>
                  </a:moveTo>
                  <a:cubicBezTo>
                    <a:pt x="1735" y="16288"/>
                    <a:pt x="829" y="15449"/>
                    <a:pt x="-1" y="14538"/>
                  </a:cubicBezTo>
                  <a:lnTo>
                    <a:pt x="15975" y="0"/>
                  </a:lnTo>
                  <a:lnTo>
                    <a:pt x="2708" y="17046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Line 482"/>
            <p:cNvSpPr/>
            <p:nvPr/>
          </p:nvSpPr>
          <p:spPr>
            <a:xfrm flipH="1">
              <a:off x="4263840" y="5321160"/>
              <a:ext cx="45720" cy="42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Line 483"/>
            <p:cNvSpPr/>
            <p:nvPr/>
          </p:nvSpPr>
          <p:spPr>
            <a:xfrm flipH="1">
              <a:off x="4361040" y="5405400"/>
              <a:ext cx="39600" cy="50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Line 484"/>
            <p:cNvSpPr/>
            <p:nvPr/>
          </p:nvSpPr>
          <p:spPr>
            <a:xfrm flipV="1">
              <a:off x="4181400" y="5411520"/>
              <a:ext cx="130320" cy="4284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Rectangle 485"/>
            <p:cNvSpPr/>
            <p:nvPr/>
          </p:nvSpPr>
          <p:spPr>
            <a:xfrm>
              <a:off x="4100040" y="5450040"/>
              <a:ext cx="118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L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Freeform 486"/>
            <p:cNvSpPr/>
            <p:nvPr/>
          </p:nvSpPr>
          <p:spPr>
            <a:xfrm>
              <a:off x="5232240" y="4172040"/>
              <a:ext cx="98640" cy="95040"/>
            </a:xfrm>
            <a:custGeom>
              <a:avLst/>
              <a:gdLst>
                <a:gd name="textAreaLeft" fmla="*/ 0 w 98640"/>
                <a:gd name="textAreaRight" fmla="*/ 99000 w 98640"/>
                <a:gd name="textAreaTop" fmla="*/ 0 h 95040"/>
                <a:gd name="textAreaBottom" fmla="*/ 95400 h 95040"/>
              </a:gdLst>
              <a:ahLst/>
              <a:rect l="textAreaLeft" t="textAreaTop" r="textAreaRight" b="textAreaBottom"/>
              <a:pathLst>
                <a:path w="62" h="60">
                  <a:moveTo>
                    <a:pt x="62" y="29"/>
                  </a:moveTo>
                  <a:lnTo>
                    <a:pt x="27" y="3"/>
                  </a:lnTo>
                  <a:lnTo>
                    <a:pt x="20" y="0"/>
                  </a:lnTo>
                  <a:lnTo>
                    <a:pt x="0" y="34"/>
                  </a:lnTo>
                  <a:lnTo>
                    <a:pt x="34" y="57"/>
                  </a:lnTo>
                  <a:lnTo>
                    <a:pt x="38" y="60"/>
                  </a:lnTo>
                  <a:lnTo>
                    <a:pt x="62" y="29"/>
                  </a:lnTo>
                  <a:close/>
                </a:path>
              </a:pathLst>
            </a:custGeom>
            <a:solidFill>
              <a:srgbClr val="ccccc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Arc 487"/>
            <p:cNvSpPr/>
            <p:nvPr/>
          </p:nvSpPr>
          <p:spPr>
            <a:xfrm>
              <a:off x="4844880" y="4173480"/>
              <a:ext cx="484200" cy="662040"/>
            </a:xfrm>
            <a:custGeom>
              <a:avLst/>
              <a:gdLst>
                <a:gd name="textAreaLeft" fmla="*/ 0 w 484200"/>
                <a:gd name="textAreaRight" fmla="*/ 484560 w 484200"/>
                <a:gd name="textAreaTop" fmla="*/ 0 h 662040"/>
                <a:gd name="textAreaBottom" fmla="*/ 662400 h 662040"/>
              </a:gdLst>
              <a:ahLst/>
              <a:rect l="textAreaLeft" t="textAreaTop" r="textAreaRight" b="textAreaBottom"/>
              <a:pathLst>
                <a:path fill="none" w="13338" h="18273">
                  <a:moveTo>
                    <a:pt x="11517" y="0"/>
                  </a:moveTo>
                  <a:cubicBezTo>
                    <a:pt x="12146" y="396"/>
                    <a:pt x="12753" y="824"/>
                    <a:pt x="13337" y="1283"/>
                  </a:cubicBezTo>
                </a:path>
                <a:path stroke="0" w="13338" h="18273">
                  <a:moveTo>
                    <a:pt x="11517" y="0"/>
                  </a:moveTo>
                  <a:cubicBezTo>
                    <a:pt x="12146" y="396"/>
                    <a:pt x="12753" y="824"/>
                    <a:pt x="13337" y="1283"/>
                  </a:cubicBezTo>
                  <a:lnTo>
                    <a:pt x="0" y="18273"/>
                  </a:lnTo>
                  <a:lnTo>
                    <a:pt x="11517" y="0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Arc 488"/>
            <p:cNvSpPr/>
            <p:nvPr/>
          </p:nvSpPr>
          <p:spPr>
            <a:xfrm>
              <a:off x="4844880" y="4227480"/>
              <a:ext cx="446400" cy="608040"/>
            </a:xfrm>
            <a:custGeom>
              <a:avLst/>
              <a:gdLst>
                <a:gd name="textAreaLeft" fmla="*/ 0 w 446400"/>
                <a:gd name="textAreaRight" fmla="*/ 446760 w 446400"/>
                <a:gd name="textAreaTop" fmla="*/ 0 h 608040"/>
                <a:gd name="textAreaBottom" fmla="*/ 608400 h 608040"/>
              </a:gdLst>
              <a:ahLst/>
              <a:rect l="textAreaLeft" t="textAreaTop" r="textAreaRight" b="textAreaBottom"/>
              <a:pathLst>
                <a:path fill="none" w="13348" h="18242">
                  <a:moveTo>
                    <a:pt x="11566" y="-1"/>
                  </a:moveTo>
                  <a:cubicBezTo>
                    <a:pt x="12181" y="389"/>
                    <a:pt x="12775" y="810"/>
                    <a:pt x="13348" y="1259"/>
                  </a:cubicBezTo>
                </a:path>
                <a:path stroke="0" w="13348" h="18242">
                  <a:moveTo>
                    <a:pt x="11566" y="-1"/>
                  </a:moveTo>
                  <a:cubicBezTo>
                    <a:pt x="12181" y="389"/>
                    <a:pt x="12775" y="810"/>
                    <a:pt x="13348" y="1259"/>
                  </a:cubicBezTo>
                  <a:lnTo>
                    <a:pt x="0" y="18242"/>
                  </a:lnTo>
                  <a:lnTo>
                    <a:pt x="11566" y="-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Line 489"/>
            <p:cNvSpPr/>
            <p:nvPr/>
          </p:nvSpPr>
          <p:spPr>
            <a:xfrm flipV="1">
              <a:off x="5292720" y="4218120"/>
              <a:ext cx="3816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Line 490"/>
            <p:cNvSpPr/>
            <p:nvPr/>
          </p:nvSpPr>
          <p:spPr>
            <a:xfrm flipV="1">
              <a:off x="5232240" y="4172040"/>
              <a:ext cx="32040" cy="54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Line 491"/>
            <p:cNvSpPr/>
            <p:nvPr/>
          </p:nvSpPr>
          <p:spPr>
            <a:xfrm flipH="1">
              <a:off x="5297040" y="4091040"/>
              <a:ext cx="127080" cy="10476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Rectangle 492"/>
            <p:cNvSpPr/>
            <p:nvPr/>
          </p:nvSpPr>
          <p:spPr>
            <a:xfrm>
              <a:off x="5427000" y="4003560"/>
              <a:ext cx="128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R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Freeform 493"/>
            <p:cNvSpPr/>
            <p:nvPr/>
          </p:nvSpPr>
          <p:spPr>
            <a:xfrm>
              <a:off x="4362480" y="5407200"/>
              <a:ext cx="466560" cy="237960"/>
            </a:xfrm>
            <a:custGeom>
              <a:avLst/>
              <a:gdLst>
                <a:gd name="textAreaLeft" fmla="*/ 0 w 466560"/>
                <a:gd name="textAreaRight" fmla="*/ 466920 w 466560"/>
                <a:gd name="textAreaTop" fmla="*/ 0 h 237960"/>
                <a:gd name="textAreaBottom" fmla="*/ 238320 h 237960"/>
              </a:gdLst>
              <a:ahLst/>
              <a:rect l="textAreaLeft" t="textAreaTop" r="textAreaRight" b="textAreaBottom"/>
              <a:pathLst>
                <a:path w="294" h="150">
                  <a:moveTo>
                    <a:pt x="0" y="31"/>
                  </a:moveTo>
                  <a:lnTo>
                    <a:pt x="36" y="57"/>
                  </a:lnTo>
                  <a:lnTo>
                    <a:pt x="74" y="79"/>
                  </a:lnTo>
                  <a:lnTo>
                    <a:pt x="114" y="98"/>
                  </a:lnTo>
                  <a:lnTo>
                    <a:pt x="157" y="114"/>
                  </a:lnTo>
                  <a:lnTo>
                    <a:pt x="199" y="124"/>
                  </a:lnTo>
                  <a:lnTo>
                    <a:pt x="243" y="133"/>
                  </a:lnTo>
                  <a:lnTo>
                    <a:pt x="261" y="134"/>
                  </a:lnTo>
                  <a:lnTo>
                    <a:pt x="260" y="150"/>
                  </a:lnTo>
                  <a:lnTo>
                    <a:pt x="294" y="117"/>
                  </a:lnTo>
                  <a:lnTo>
                    <a:pt x="266" y="80"/>
                  </a:lnTo>
                  <a:lnTo>
                    <a:pt x="264" y="95"/>
                  </a:lnTo>
                  <a:lnTo>
                    <a:pt x="224" y="90"/>
                  </a:lnTo>
                  <a:lnTo>
                    <a:pt x="184" y="81"/>
                  </a:lnTo>
                  <a:lnTo>
                    <a:pt x="145" y="69"/>
                  </a:lnTo>
                  <a:lnTo>
                    <a:pt x="108" y="53"/>
                  </a:lnTo>
                  <a:lnTo>
                    <a:pt x="72" y="33"/>
                  </a:lnTo>
                  <a:lnTo>
                    <a:pt x="38" y="11"/>
                  </a:lnTo>
                  <a:lnTo>
                    <a:pt x="25" y="0"/>
                  </a:lnTo>
                  <a:lnTo>
                    <a:pt x="0" y="31"/>
                  </a:lnTo>
                  <a:close/>
                </a:path>
              </a:pathLst>
            </a:cu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Arc 494"/>
            <p:cNvSpPr/>
            <p:nvPr/>
          </p:nvSpPr>
          <p:spPr>
            <a:xfrm>
              <a:off x="4363920" y="4835520"/>
              <a:ext cx="480960" cy="779400"/>
            </a:xfrm>
            <a:custGeom>
              <a:avLst/>
              <a:gdLst>
                <a:gd name="textAreaLeft" fmla="*/ 0 w 480960"/>
                <a:gd name="textAreaRight" fmla="*/ 481320 w 480960"/>
                <a:gd name="textAreaTop" fmla="*/ 0 h 779400"/>
                <a:gd name="textAreaBottom" fmla="*/ 779760 h 779400"/>
              </a:gdLst>
              <a:ahLst/>
              <a:rect l="textAreaLeft" t="textAreaTop" r="textAreaRight" b="textAreaBottom"/>
              <a:pathLst>
                <a:path fill="none" w="13241" h="21519">
                  <a:moveTo>
                    <a:pt x="11372" y="21518"/>
                  </a:moveTo>
                  <a:cubicBezTo>
                    <a:pt x="7231" y="21159"/>
                    <a:pt x="3283" y="19613"/>
                    <a:pt x="-1" y="17065"/>
                  </a:cubicBezTo>
                </a:path>
                <a:path stroke="0" w="13241" h="21519">
                  <a:moveTo>
                    <a:pt x="11372" y="21518"/>
                  </a:moveTo>
                  <a:cubicBezTo>
                    <a:pt x="7231" y="21159"/>
                    <a:pt x="3283" y="19613"/>
                    <a:pt x="-1" y="17065"/>
                  </a:cubicBezTo>
                  <a:lnTo>
                    <a:pt x="13241" y="0"/>
                  </a:lnTo>
                  <a:lnTo>
                    <a:pt x="11372" y="21518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Arc 495"/>
            <p:cNvSpPr/>
            <p:nvPr/>
          </p:nvSpPr>
          <p:spPr>
            <a:xfrm>
              <a:off x="4403880" y="4835520"/>
              <a:ext cx="441000" cy="717480"/>
            </a:xfrm>
            <a:custGeom>
              <a:avLst/>
              <a:gdLst>
                <a:gd name="textAreaLeft" fmla="*/ 0 w 441000"/>
                <a:gd name="textAreaRight" fmla="*/ 441360 w 441000"/>
                <a:gd name="textAreaTop" fmla="*/ 0 h 717480"/>
                <a:gd name="textAreaBottom" fmla="*/ 717840 h 717480"/>
              </a:gdLst>
              <a:ahLst/>
              <a:rect l="textAreaLeft" t="textAreaTop" r="textAreaRight" b="textAreaBottom"/>
              <a:pathLst>
                <a:path fill="none" w="13213" h="21517">
                  <a:moveTo>
                    <a:pt x="11325" y="21517"/>
                  </a:moveTo>
                  <a:cubicBezTo>
                    <a:pt x="7204" y="21155"/>
                    <a:pt x="3272" y="19618"/>
                    <a:pt x="-1" y="17087"/>
                  </a:cubicBezTo>
                </a:path>
                <a:path stroke="0" w="13213" h="21517">
                  <a:moveTo>
                    <a:pt x="11325" y="21517"/>
                  </a:moveTo>
                  <a:cubicBezTo>
                    <a:pt x="7204" y="21155"/>
                    <a:pt x="3272" y="19618"/>
                    <a:pt x="-1" y="17087"/>
                  </a:cubicBezTo>
                  <a:lnTo>
                    <a:pt x="13213" y="0"/>
                  </a:lnTo>
                  <a:lnTo>
                    <a:pt x="11325" y="21517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Line 496"/>
            <p:cNvSpPr/>
            <p:nvPr/>
          </p:nvSpPr>
          <p:spPr>
            <a:xfrm flipH="1">
              <a:off x="4362480" y="5407200"/>
              <a:ext cx="3960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Freeform 497"/>
            <p:cNvSpPr/>
            <p:nvPr/>
          </p:nvSpPr>
          <p:spPr>
            <a:xfrm>
              <a:off x="4775040" y="5533920"/>
              <a:ext cx="54000" cy="111240"/>
            </a:xfrm>
            <a:custGeom>
              <a:avLst/>
              <a:gdLst>
                <a:gd name="textAreaLeft" fmla="*/ 0 w 54000"/>
                <a:gd name="textAreaRight" fmla="*/ 54360 w 54000"/>
                <a:gd name="textAreaTop" fmla="*/ 0 h 111240"/>
                <a:gd name="textAreaBottom" fmla="*/ 111600 h 111240"/>
              </a:gdLst>
              <a:ahLst/>
              <a:rect l="textAreaLeft" t="textAreaTop" r="textAreaRight" b="textAreaBottom"/>
              <a:pathLst>
                <a:path w="32" h="66">
                  <a:moveTo>
                    <a:pt x="4" y="14"/>
                  </a:moveTo>
                  <a:lnTo>
                    <a:pt x="6" y="0"/>
                  </a:lnTo>
                  <a:lnTo>
                    <a:pt x="32" y="35"/>
                  </a:lnTo>
                  <a:lnTo>
                    <a:pt x="0" y="66"/>
                  </a:lnTo>
                  <a:lnTo>
                    <a:pt x="1" y="51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Line 498"/>
            <p:cNvSpPr/>
            <p:nvPr/>
          </p:nvSpPr>
          <p:spPr>
            <a:xfrm flipV="1">
              <a:off x="4340160" y="5578200"/>
              <a:ext cx="243000" cy="6120"/>
            </a:xfrm>
            <a:prstGeom prst="line">
              <a:avLst/>
            </a:prstGeom>
            <a:ln w="0">
              <a:solidFill>
                <a:srgbClr val="ff0033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Rectangle 499"/>
            <p:cNvSpPr/>
            <p:nvPr/>
          </p:nvSpPr>
          <p:spPr>
            <a:xfrm>
              <a:off x="4073040" y="5580000"/>
              <a:ext cx="340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700" spc="-1" strike="noStrike">
                  <a:solidFill>
                    <a:srgbClr val="800000"/>
                  </a:solidFill>
                  <a:latin typeface="Arial"/>
                </a:rPr>
                <a:t>Sm/Sp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8-31T17:49:44Z</dcterms:created>
  <dc:creator>Paco</dc:creator>
  <dc:description/>
  <dc:language>en-US</dc:language>
  <cp:lastModifiedBy>Javier Pozueta</cp:lastModifiedBy>
  <dcterms:modified xsi:type="dcterms:W3CDTF">2015-01-27T09:11:43Z</dcterms:modified>
  <cp:revision>36</cp:revision>
  <dc:subject/>
  <dc:title>Diapositiva 1</dc:title>
</cp:coreProperties>
</file>